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7" r:id="rId2"/>
    <p:sldId id="1051" r:id="rId3"/>
    <p:sldId id="258" r:id="rId4"/>
    <p:sldId id="259" r:id="rId5"/>
    <p:sldId id="260" r:id="rId6"/>
    <p:sldId id="1052" r:id="rId7"/>
    <p:sldId id="261" r:id="rId8"/>
    <p:sldId id="105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33" autoAdjust="0"/>
    <p:restoredTop sz="96015" autoAdjust="0"/>
  </p:normalViewPr>
  <p:slideViewPr>
    <p:cSldViewPr snapToGrid="0">
      <p:cViewPr varScale="1">
        <p:scale>
          <a:sx n="111" d="100"/>
          <a:sy n="111" d="100"/>
        </p:scale>
        <p:origin x="750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Masoud\Dormancy\Paper\Dormanc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manjili\Dropbox\Dormancy\Oncogene\Original\Figur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manjili\Dropbox\Dormancy\Oncogene\Original\Figures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manjili\Dropbox\Dormancy\Oncogene\Original\Figures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manjili\Dropbox\Dormancy\Oncogene\Original\Figures.xlsx" TargetMode="Externa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manjili\Dropbox\Dormancy\Oncogene\Original\Figures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manjili\Dropbox\Dormancy\Oncogene\Original\Figur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manjili\Dropbox\Dormancy\Oncogene\Original\Figures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manjili\Dropbox\Dormancy\Oncogene\Original\Figur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\Dropbox\Dormancy\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636135170603674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Y$1685:$AA$1685</c:f>
                <c:numCache>
                  <c:formatCode>General</c:formatCode>
                  <c:ptCount val="3"/>
                  <c:pt idx="0">
                    <c:v>3.3700000000000041</c:v>
                  </c:pt>
                  <c:pt idx="1">
                    <c:v>8.5760966256994227</c:v>
                  </c:pt>
                  <c:pt idx="2">
                    <c:v>6.6878230970755377</c:v>
                  </c:pt>
                </c:numCache>
              </c:numRef>
            </c:plus>
            <c:minus>
              <c:numRef>
                <c:f>Dormancy!$Y$1685:$AA$1685</c:f>
                <c:numCache>
                  <c:formatCode>General</c:formatCode>
                  <c:ptCount val="3"/>
                  <c:pt idx="0">
                    <c:v>3.3700000000000041</c:v>
                  </c:pt>
                  <c:pt idx="1">
                    <c:v>8.5760966256994227</c:v>
                  </c:pt>
                  <c:pt idx="2">
                    <c:v>6.6878230970755377</c:v>
                  </c:pt>
                </c:numCache>
              </c:numRef>
            </c:minus>
          </c:errBars>
          <c:cat>
            <c:strRef>
              <c:f>Dormancy!$Y$1680:$AA$1680</c:f>
              <c:strCache>
                <c:ptCount val="3"/>
                <c:pt idx="0">
                  <c:v>Ctrl</c:v>
                </c:pt>
                <c:pt idx="1">
                  <c:v>FAC</c:v>
                </c:pt>
                <c:pt idx="2">
                  <c:v>FAC/AIT</c:v>
                </c:pt>
              </c:strCache>
            </c:strRef>
          </c:cat>
          <c:val>
            <c:numRef>
              <c:f>Dormancy!$Y$1684:$AA$1684</c:f>
              <c:numCache>
                <c:formatCode>General</c:formatCode>
                <c:ptCount val="3"/>
                <c:pt idx="0">
                  <c:v>61.59</c:v>
                </c:pt>
                <c:pt idx="1">
                  <c:v>43.970000000000013</c:v>
                </c:pt>
                <c:pt idx="2">
                  <c:v>63.1366666666665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E2-45FC-A955-54A9128DE6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10065672"/>
        <c:axId val="-2009901544"/>
      </c:barChart>
      <c:catAx>
        <c:axId val="-2010065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901544"/>
        <c:crosses val="autoZero"/>
        <c:auto val="1"/>
        <c:lblAlgn val="ctr"/>
        <c:lblOffset val="100"/>
        <c:noMultiLvlLbl val="0"/>
      </c:catAx>
      <c:valAx>
        <c:axId val="-2009901544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10065672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latin typeface="+mj-lt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ysClr val="windowText" lastClr="000000"/>
                </a:solidFill>
                <a:latin typeface="+mj-lt"/>
                <a:ea typeface="+mn-ea"/>
                <a:cs typeface="+mn-cs"/>
              </a:defRPr>
            </a:pPr>
            <a:r>
              <a:rPr lang="en-US"/>
              <a:t>FVBN202</a:t>
            </a:r>
          </a:p>
        </c:rich>
      </c:tx>
      <c:layout>
        <c:manualLayout>
          <c:xMode val="edge"/>
          <c:yMode val="edge"/>
          <c:x val="0.30278288130650299"/>
          <c:y val="2.700678040244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ysClr val="windowText" lastClr="000000"/>
              </a:solidFill>
              <a:latin typeface="+mj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32787255759697"/>
          <c:y val="7.3354111986001794E-2"/>
          <c:w val="0.87753018372703395"/>
          <c:h val="0.57053149606299203"/>
        </c:manualLayout>
      </c:layout>
      <c:lineChart>
        <c:grouping val="standard"/>
        <c:varyColors val="0"/>
        <c:ser>
          <c:idx val="3"/>
          <c:order val="3"/>
          <c:tx>
            <c:strRef>
              <c:f>Dormancy!$AH$394</c:f>
              <c:strCache>
                <c:ptCount val="1"/>
                <c:pt idx="0">
                  <c:v>R-FAC/AIT</c:v>
                </c:pt>
              </c:strCache>
              <c:extLst xmlns:c15="http://schemas.microsoft.com/office/drawing/2012/chart"/>
            </c:strRef>
          </c:tx>
          <c:spPr>
            <a:ln w="9525" cap="rnd">
              <a:solidFill>
                <a:schemeClr val="tx1"/>
              </a:solidFill>
              <a:prstDash val="lgDashDotDot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Dormancy!$AI$400:$AM$40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3.042665031009239</c:v>
                  </c:pt>
                  <c:pt idx="2">
                    <c:v>63.940944976160957</c:v>
                  </c:pt>
                </c:numCache>
              </c:numRef>
            </c:plus>
            <c:minus>
              <c:numRef>
                <c:f>Dormancy!$AI$400:$AM$40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3.042665031009239</c:v>
                  </c:pt>
                  <c:pt idx="2">
                    <c:v>63.9409449761609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ormancy!$AI$390:$AM$390</c:f>
              <c:numCache>
                <c:formatCode>General</c:formatCode>
                <c:ptCount val="3"/>
                <c:pt idx="0">
                  <c:v>0</c:v>
                </c:pt>
                <c:pt idx="1">
                  <c:v>7</c:v>
                </c:pt>
                <c:pt idx="2">
                  <c:v>14</c:v>
                </c:pt>
              </c:numCache>
            </c:numRef>
          </c:cat>
          <c:val>
            <c:numRef>
              <c:f>Dormancy!$AI$394:$AM$394</c:f>
              <c:numCache>
                <c:formatCode>General</c:formatCode>
                <c:ptCount val="3"/>
                <c:pt idx="0">
                  <c:v>0</c:v>
                </c:pt>
                <c:pt idx="1">
                  <c:v>29.333333333333279</c:v>
                </c:pt>
                <c:pt idx="2">
                  <c:v>250.6666666666666</c:v>
                </c:pt>
              </c:numCache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0-5077-426B-A093-7697207D43FD}"/>
            </c:ext>
          </c:extLst>
        </c:ser>
        <c:ser>
          <c:idx val="4"/>
          <c:order val="4"/>
          <c:tx>
            <c:strRef>
              <c:f>Dormancy!$AH$395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ln w="9525" cap="sq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Dormancy!$AI$401:$AM$40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0.626304672539959</c:v>
                  </c:pt>
                  <c:pt idx="2">
                    <c:v>145.420463178712</c:v>
                  </c:pt>
                </c:numCache>
              </c:numRef>
            </c:plus>
            <c:minus>
              <c:numRef>
                <c:f>Dormancy!$AI$401:$AM$40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0.626304672539959</c:v>
                  </c:pt>
                  <c:pt idx="2">
                    <c:v>145.4204631787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ormancy!$AI$390:$AM$390</c:f>
              <c:numCache>
                <c:formatCode>General</c:formatCode>
                <c:ptCount val="3"/>
                <c:pt idx="0">
                  <c:v>0</c:v>
                </c:pt>
                <c:pt idx="1">
                  <c:v>7</c:v>
                </c:pt>
                <c:pt idx="2">
                  <c:v>14</c:v>
                </c:pt>
              </c:numCache>
            </c:numRef>
          </c:cat>
          <c:val>
            <c:numRef>
              <c:f>Dormancy!$AI$395:$AM$395</c:f>
              <c:numCache>
                <c:formatCode>General</c:formatCode>
                <c:ptCount val="3"/>
                <c:pt idx="0">
                  <c:v>0</c:v>
                </c:pt>
                <c:pt idx="1">
                  <c:v>109.3333333333333</c:v>
                </c:pt>
                <c:pt idx="2">
                  <c:v>1107.333333333333</c:v>
                </c:pt>
              </c:numCache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1-5077-426B-A093-7697207D43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009953016"/>
        <c:axId val="-2009906808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AH$391</c15:sqref>
                        </c15:formulaRef>
                      </c:ext>
                    </c:extLst>
                    <c:strCache>
                      <c:ptCount val="1"/>
                      <c:pt idx="0">
                        <c:v>MMC</c:v>
                      </c:pt>
                    </c:strCache>
                  </c:strRef>
                </c:tx>
                <c:spPr>
                  <a:ln w="22225" cap="rnd" cmpd="sng">
                    <a:solidFill>
                      <a:schemeClr val="bg2">
                        <a:lumMod val="50000"/>
                      </a:schemeClr>
                    </a:solidFill>
                    <a:prstDash val="sysDot"/>
                    <a:round/>
                  </a:ln>
                  <a:effectLst/>
                </c:spPr>
                <c:marker>
                  <c:symbol val="none"/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AI$397:$AM$397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0</c:v>
                        </c:pt>
                        <c:pt idx="1">
                          <c:v>25.886504420471898</c:v>
                        </c:pt>
                        <c:pt idx="2">
                          <c:v>13.012814197295423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AI$397:$AM$397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0</c:v>
                        </c:pt>
                        <c:pt idx="1">
                          <c:v>25.886504420471898</c:v>
                        </c:pt>
                        <c:pt idx="2">
                          <c:v>13.012814197295423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>
                      <c:ext uri="{02D57815-91ED-43cb-92C2-25804820EDAC}">
                        <c15:formulaRef>
                          <c15:sqref>Dormancy!$AI$390:$AM$390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0</c:v>
                      </c:pt>
                      <c:pt idx="1">
                        <c:v>7</c:v>
                      </c:pt>
                      <c:pt idx="2">
                        <c:v>14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Dormancy!$AI$391:$AM$391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0</c:v>
                      </c:pt>
                      <c:pt idx="1">
                        <c:v>51.333333333333336</c:v>
                      </c:pt>
                      <c:pt idx="2">
                        <c:v>6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2-5077-426B-A093-7697207D43FD}"/>
                  </c:ext>
                </c:extLst>
              </c15:ser>
            </c15:filteredLineSeries>
            <c15:filteredLine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H$392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spPr>
                  <a:ln w="15875" cap="rnd">
                    <a:solidFill>
                      <a:schemeClr val="tx1"/>
                    </a:solidFill>
                    <a:round/>
                  </a:ln>
                  <a:effectLst/>
                </c:spPr>
                <c:marker>
                  <c:symbol val="none"/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I$398:$AM$398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0</c:v>
                        </c:pt>
                        <c:pt idx="1">
                          <c:v>3.2393414968683589</c:v>
                        </c:pt>
                        <c:pt idx="2">
                          <c:v>12.364105754607227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I$398:$AM$398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0</c:v>
                        </c:pt>
                        <c:pt idx="1">
                          <c:v>3.2393414968683589</c:v>
                        </c:pt>
                        <c:pt idx="2">
                          <c:v>12.364105754607227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I$390:$AM$390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0</c:v>
                      </c:pt>
                      <c:pt idx="1">
                        <c:v>7</c:v>
                      </c:pt>
                      <c:pt idx="2">
                        <c:v>14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I$392:$AM$392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0</c:v>
                      </c:pt>
                      <c:pt idx="1">
                        <c:v>27.599999999999998</c:v>
                      </c:pt>
                      <c:pt idx="2">
                        <c:v>100.06666666666666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5077-426B-A093-7697207D43FD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H$393</c15:sqref>
                        </c15:formulaRef>
                      </c:ext>
                    </c:extLst>
                    <c:strCache>
                      <c:ptCount val="1"/>
                      <c:pt idx="0">
                        <c:v>R-FAC</c:v>
                      </c:pt>
                    </c:strCache>
                  </c:strRef>
                </c:tx>
                <c:spPr>
                  <a:ln w="15875" cap="rnd">
                    <a:solidFill>
                      <a:schemeClr val="tx1"/>
                    </a:solidFill>
                    <a:prstDash val="sysDash"/>
                    <a:round/>
                  </a:ln>
                  <a:effectLst/>
                </c:spPr>
                <c:marker>
                  <c:symbol val="none"/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I$399:$AM$399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0</c:v>
                        </c:pt>
                        <c:pt idx="1">
                          <c:v>8.306256176320753</c:v>
                        </c:pt>
                        <c:pt idx="2">
                          <c:v>25.233905761891084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I$399:$AM$399</c15:sqref>
                          </c15:formulaRef>
                        </c:ext>
                      </c:extLst>
                      <c:numCache>
                        <c:formatCode>General</c:formatCode>
                        <c:ptCount val="3"/>
                        <c:pt idx="0">
                          <c:v>0</c:v>
                        </c:pt>
                        <c:pt idx="1">
                          <c:v>8.306256176320753</c:v>
                        </c:pt>
                        <c:pt idx="2">
                          <c:v>25.233905761891084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I$390:$AM$390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0</c:v>
                      </c:pt>
                      <c:pt idx="1">
                        <c:v>7</c:v>
                      </c:pt>
                      <c:pt idx="2">
                        <c:v>14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I$393:$AM$393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0</c:v>
                      </c:pt>
                      <c:pt idx="1">
                        <c:v>50.835000000000001</c:v>
                      </c:pt>
                      <c:pt idx="2">
                        <c:v>134.5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5077-426B-A093-7697207D43FD}"/>
                  </c:ext>
                </c:extLst>
              </c15:ser>
            </c15:filteredLineSeries>
          </c:ext>
        </c:extLst>
      </c:lineChart>
      <c:catAx>
        <c:axId val="-2009953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-2009906808"/>
        <c:crosses val="autoZero"/>
        <c:auto val="1"/>
        <c:lblAlgn val="ctr"/>
        <c:lblOffset val="100"/>
        <c:noMultiLvlLbl val="0"/>
      </c:catAx>
      <c:valAx>
        <c:axId val="-2009906808"/>
        <c:scaling>
          <c:orientation val="minMax"/>
          <c:max val="12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-2009953016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50335374744824E-3"/>
          <c:y val="0.805288167104112"/>
          <c:w val="0.76551108194809003"/>
          <c:h val="0.176193253621074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+mj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  <a:latin typeface="+mj-lt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471323272090989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M$1232:$P$1232</c:f>
                <c:numCache>
                  <c:formatCode>General</c:formatCode>
                  <c:ptCount val="2"/>
                  <c:pt idx="0">
                    <c:v>4.3588989435406698E-2</c:v>
                  </c:pt>
                  <c:pt idx="1">
                    <c:v>0.26457513110645797</c:v>
                  </c:pt>
                </c:numCache>
              </c:numRef>
            </c:plus>
            <c:minus>
              <c:numRef>
                <c:f>Dormancy!$M$1232:$P$1232</c:f>
                <c:numCache>
                  <c:formatCode>General</c:formatCode>
                  <c:ptCount val="2"/>
                  <c:pt idx="0">
                    <c:v>4.3588989435406698E-2</c:v>
                  </c:pt>
                  <c:pt idx="1">
                    <c:v>0.26457513110645797</c:v>
                  </c:pt>
                </c:numCache>
              </c:numRef>
            </c:minus>
          </c:errBars>
          <c:cat>
            <c:strRef>
              <c:f>Dormancy!$M$1227:$P$1227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M$1231:$P$1231</c:f>
              <c:numCache>
                <c:formatCode>General</c:formatCode>
                <c:ptCount val="2"/>
                <c:pt idx="0">
                  <c:v>0.26</c:v>
                </c:pt>
                <c:pt idx="1">
                  <c:v>2.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8F-4618-92E2-F4F89D581A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9694104"/>
        <c:axId val="-2009690696"/>
      </c:barChart>
      <c:catAx>
        <c:axId val="-2009694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690696"/>
        <c:crosses val="autoZero"/>
        <c:auto val="1"/>
        <c:lblAlgn val="ctr"/>
        <c:lblOffset val="100"/>
        <c:noMultiLvlLbl val="0"/>
      </c:catAx>
      <c:valAx>
        <c:axId val="-2009690696"/>
        <c:scaling>
          <c:orientation val="minMax"/>
          <c:max val="3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694104"/>
        <c:crosses val="autoZero"/>
        <c:crossBetween val="between"/>
        <c:majorUnit val="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652769808565019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Dormancy!$W$1235</c:f>
              <c:strCache>
                <c:ptCount val="1"/>
                <c:pt idx="0">
                  <c:v>Ki67-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Dormancy!$W$1232,Dormancy!$Y$1232,Dormancy!$AA$1232,Dormancy!$AC$1232)</c:f>
                <c:numCache>
                  <c:formatCode>General</c:formatCode>
                  <c:ptCount val="2"/>
                  <c:pt idx="0">
                    <c:v>7.4103733599146899</c:v>
                  </c:pt>
                  <c:pt idx="1">
                    <c:v>5.75849903283064</c:v>
                  </c:pt>
                </c:numCache>
              </c:numRef>
            </c:plus>
            <c:minus>
              <c:numRef>
                <c:f>(Dormancy!$W$1232,Dormancy!$Y$1232,Dormancy!$AA$1232,Dormancy!$AC$1232)</c:f>
                <c:numCache>
                  <c:formatCode>General</c:formatCode>
                  <c:ptCount val="2"/>
                  <c:pt idx="0">
                    <c:v>7.4103733599146899</c:v>
                  </c:pt>
                  <c:pt idx="1">
                    <c:v>5.75849903283064</c:v>
                  </c:pt>
                </c:numCache>
              </c:numRef>
            </c:minus>
          </c:errBars>
          <c:cat>
            <c:strRef>
              <c:f>Dormancy!$X$1234:$AA$1234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X$1235:$AA$1235</c:f>
              <c:numCache>
                <c:formatCode>General</c:formatCode>
                <c:ptCount val="2"/>
                <c:pt idx="0">
                  <c:v>53.26</c:v>
                </c:pt>
                <c:pt idx="1">
                  <c:v>60.52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63-4693-ABA0-D6F1BCAF050A}"/>
            </c:ext>
          </c:extLst>
        </c:ser>
        <c:ser>
          <c:idx val="1"/>
          <c:order val="1"/>
          <c:tx>
            <c:strRef>
              <c:f>Dormancy!$W$1236</c:f>
              <c:strCache>
                <c:ptCount val="1"/>
                <c:pt idx="0">
                  <c:v>Ki67+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Dormancy!$X$1232,Dormancy!$Z$1232,Dormancy!$AB$1232,Dormancy!$AD$1232)</c:f>
                <c:numCache>
                  <c:formatCode>General</c:formatCode>
                  <c:ptCount val="2"/>
                  <c:pt idx="0">
                    <c:v>7.4103733599147059</c:v>
                  </c:pt>
                  <c:pt idx="1">
                    <c:v>5.7584990328306302</c:v>
                  </c:pt>
                </c:numCache>
              </c:numRef>
            </c:plus>
            <c:minus>
              <c:numRef>
                <c:f>(Dormancy!$X$1232,Dormancy!$Z$1232,Dormancy!$AB$1232,Dormancy!$AD$1232)</c:f>
                <c:numCache>
                  <c:formatCode>General</c:formatCode>
                  <c:ptCount val="2"/>
                  <c:pt idx="0">
                    <c:v>7.4103733599147059</c:v>
                  </c:pt>
                  <c:pt idx="1">
                    <c:v>5.7584990328306302</c:v>
                  </c:pt>
                </c:numCache>
              </c:numRef>
            </c:minus>
          </c:errBars>
          <c:cat>
            <c:strRef>
              <c:f>Dormancy!$X$1234:$AA$1234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X$1236:$AA$1236</c:f>
              <c:numCache>
                <c:formatCode>General</c:formatCode>
                <c:ptCount val="2"/>
                <c:pt idx="0">
                  <c:v>46.74</c:v>
                </c:pt>
                <c:pt idx="1">
                  <c:v>39.476666666666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63-4693-ABA0-D6F1BCAF05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9386312"/>
        <c:axId val="-2009351208"/>
      </c:barChart>
      <c:catAx>
        <c:axId val="-20093863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351208"/>
        <c:crosses val="autoZero"/>
        <c:auto val="1"/>
        <c:lblAlgn val="ctr"/>
        <c:lblOffset val="100"/>
        <c:noMultiLvlLbl val="0"/>
      </c:catAx>
      <c:valAx>
        <c:axId val="-2009351208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386312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0060012029746302"/>
          <c:y val="3.5919540229885097E-2"/>
          <c:w val="0.69844433508311499"/>
          <c:h val="0.194242907136608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471323272090989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I$1172:$L$1172</c:f>
                <c:numCache>
                  <c:formatCode>General</c:formatCode>
                  <c:ptCount val="2"/>
                  <c:pt idx="0">
                    <c:v>5.6862407030773297E-2</c:v>
                  </c:pt>
                  <c:pt idx="1">
                    <c:v>0.40308532319817503</c:v>
                  </c:pt>
                </c:numCache>
              </c:numRef>
            </c:plus>
            <c:minus>
              <c:numRef>
                <c:f>Dormancy!$I$1172:$L$1172</c:f>
                <c:numCache>
                  <c:formatCode>General</c:formatCode>
                  <c:ptCount val="2"/>
                  <c:pt idx="0">
                    <c:v>5.6862407030773297E-2</c:v>
                  </c:pt>
                  <c:pt idx="1">
                    <c:v>0.40308532319817503</c:v>
                  </c:pt>
                </c:numCache>
              </c:numRef>
            </c:minus>
          </c:errBars>
          <c:cat>
            <c:strRef>
              <c:f>Dormancy!$I$1167:$L$1167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I$1171:$L$1171</c:f>
              <c:numCache>
                <c:formatCode>General</c:formatCode>
                <c:ptCount val="2"/>
                <c:pt idx="0">
                  <c:v>0.21</c:v>
                </c:pt>
                <c:pt idx="1">
                  <c:v>3.50333333333333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EE-493F-B8D1-51EB8D4FB1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9666712"/>
        <c:axId val="-2009663368"/>
      </c:barChart>
      <c:catAx>
        <c:axId val="-2009666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663368"/>
        <c:crosses val="autoZero"/>
        <c:auto val="1"/>
        <c:lblAlgn val="ctr"/>
        <c:lblOffset val="100"/>
        <c:noMultiLvlLbl val="0"/>
      </c:catAx>
      <c:valAx>
        <c:axId val="-2009663368"/>
        <c:scaling>
          <c:orientation val="minMax"/>
          <c:max val="6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666712"/>
        <c:crosses val="autoZero"/>
        <c:crossBetween val="between"/>
        <c:majorUnit val="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3636363636363599"/>
          <c:w val="0.85756826449325396"/>
          <c:h val="0.475713831225641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Dormancy!$S$1175</c:f>
              <c:strCache>
                <c:ptCount val="1"/>
                <c:pt idx="0">
                  <c:v>Ki67-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Dormancy!$T$1172,Dormancy!$V$1172,Dormancy!$X$1172,Dormancy!$Z$1172)</c:f>
                <c:numCache>
                  <c:formatCode>General</c:formatCode>
                  <c:ptCount val="2"/>
                  <c:pt idx="0">
                    <c:v>9.9725127781874292</c:v>
                  </c:pt>
                  <c:pt idx="1">
                    <c:v>6.8685830659120146</c:v>
                  </c:pt>
                </c:numCache>
              </c:numRef>
            </c:plus>
            <c:minus>
              <c:numRef>
                <c:f>(Dormancy!$T$1172,Dormancy!$V$1172,Dormancy!$X$1172,Dormancy!$Z$1172)</c:f>
                <c:numCache>
                  <c:formatCode>General</c:formatCode>
                  <c:ptCount val="2"/>
                  <c:pt idx="0">
                    <c:v>9.9725127781874292</c:v>
                  </c:pt>
                  <c:pt idx="1">
                    <c:v>6.8685830659120146</c:v>
                  </c:pt>
                </c:numCache>
              </c:numRef>
            </c:minus>
          </c:errBars>
          <c:cat>
            <c:strRef>
              <c:f>Dormancy!$T$1174:$W$1174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T$1175:$W$1175</c:f>
              <c:numCache>
                <c:formatCode>General</c:formatCode>
                <c:ptCount val="2"/>
                <c:pt idx="0">
                  <c:v>48.533333333333331</c:v>
                </c:pt>
                <c:pt idx="1">
                  <c:v>62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D6-4CD5-9752-8D9EEDE24492}"/>
            </c:ext>
          </c:extLst>
        </c:ser>
        <c:ser>
          <c:idx val="1"/>
          <c:order val="1"/>
          <c:tx>
            <c:strRef>
              <c:f>Dormancy!$S$1176</c:f>
              <c:strCache>
                <c:ptCount val="1"/>
                <c:pt idx="0">
                  <c:v>Ki67+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Dormancy!$X$1232,Dormancy!$Z$1232,Dormancy!$AB$1232,Dormancy!$AD$1232,Dormancy!$U$1172,Dormancy!$W$1172,Dormancy!$Y$1172,Dormancy!$AA$1172)</c:f>
                <c:numCache>
                  <c:formatCode>General</c:formatCode>
                  <c:ptCount val="6"/>
                  <c:pt idx="0">
                    <c:v>7.4103733599147059</c:v>
                  </c:pt>
                  <c:pt idx="1">
                    <c:v>5.7584990328306302</c:v>
                  </c:pt>
                  <c:pt idx="2">
                    <c:v>11.105752263279321</c:v>
                  </c:pt>
                  <c:pt idx="3">
                    <c:v>20.545000000000009</c:v>
                  </c:pt>
                  <c:pt idx="4">
                    <c:v>9.9725127781874097</c:v>
                  </c:pt>
                  <c:pt idx="5">
                    <c:v>6.8685830659120146</c:v>
                  </c:pt>
                </c:numCache>
              </c:numRef>
            </c:plus>
            <c:minus>
              <c:numRef>
                <c:f>(Dormancy!$U$1172,Dormancy!$W$1172,Dormancy!$Y$1172,Dormancy!$AA$1172)</c:f>
                <c:numCache>
                  <c:formatCode>General</c:formatCode>
                  <c:ptCount val="2"/>
                  <c:pt idx="0">
                    <c:v>9.9725127781874097</c:v>
                  </c:pt>
                  <c:pt idx="1">
                    <c:v>6.8685830659120146</c:v>
                  </c:pt>
                </c:numCache>
              </c:numRef>
            </c:minus>
          </c:errBars>
          <c:cat>
            <c:strRef>
              <c:f>Dormancy!$T$1174:$W$1174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T$1176:$W$1176</c:f>
              <c:numCache>
                <c:formatCode>General</c:formatCode>
                <c:ptCount val="2"/>
                <c:pt idx="0">
                  <c:v>51.466666666666526</c:v>
                </c:pt>
                <c:pt idx="1">
                  <c:v>37.77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6D6-4CD5-9752-8D9EEDE244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9229160"/>
        <c:axId val="-2078190136"/>
      </c:barChart>
      <c:catAx>
        <c:axId val="-2009229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78190136"/>
        <c:crosses val="autoZero"/>
        <c:auto val="1"/>
        <c:lblAlgn val="ctr"/>
        <c:lblOffset val="100"/>
        <c:noMultiLvlLbl val="0"/>
      </c:catAx>
      <c:valAx>
        <c:axId val="-2078190136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229160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19771298118985101"/>
          <c:y val="1.0666706434423001E-2"/>
          <c:w val="0.79554489282589702"/>
          <c:h val="0.17287043664996399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471323272090989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L$1255:$O$1255</c:f>
                <c:numCache>
                  <c:formatCode>General</c:formatCode>
                  <c:ptCount val="2"/>
                  <c:pt idx="0">
                    <c:v>4.6357643502567747</c:v>
                  </c:pt>
                  <c:pt idx="1">
                    <c:v>2.1920082116634481</c:v>
                  </c:pt>
                </c:numCache>
              </c:numRef>
            </c:plus>
            <c:minus>
              <c:numRef>
                <c:f>Dormancy!$L$1255:$O$1255</c:f>
                <c:numCache>
                  <c:formatCode>General</c:formatCode>
                  <c:ptCount val="2"/>
                  <c:pt idx="0">
                    <c:v>4.6357643502567747</c:v>
                  </c:pt>
                  <c:pt idx="1">
                    <c:v>2.1920082116634481</c:v>
                  </c:pt>
                </c:numCache>
              </c:numRef>
            </c:minus>
          </c:errBars>
          <c:cat>
            <c:strRef>
              <c:f>Dormancy!$L$1250:$O$1250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L$1254:$O$1254</c:f>
              <c:numCache>
                <c:formatCode>General</c:formatCode>
                <c:ptCount val="2"/>
                <c:pt idx="0">
                  <c:v>60.50333333333333</c:v>
                </c:pt>
                <c:pt idx="1">
                  <c:v>64.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B2-4F35-B31C-FF9FFE27F7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9553128"/>
        <c:axId val="-2009549720"/>
      </c:barChart>
      <c:catAx>
        <c:axId val="-2009553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549720"/>
        <c:crosses val="autoZero"/>
        <c:auto val="1"/>
        <c:lblAlgn val="ctr"/>
        <c:lblOffset val="100"/>
        <c:noMultiLvlLbl val="0"/>
      </c:catAx>
      <c:valAx>
        <c:axId val="-2009549720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553128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471323272090989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S$1255:$V$1255</c:f>
                <c:numCache>
                  <c:formatCode>General</c:formatCode>
                  <c:ptCount val="2"/>
                  <c:pt idx="0">
                    <c:v>4.4686401113140111</c:v>
                  </c:pt>
                  <c:pt idx="1">
                    <c:v>4.9766164319857999</c:v>
                  </c:pt>
                </c:numCache>
              </c:numRef>
            </c:plus>
            <c:minus>
              <c:numRef>
                <c:f>Dormancy!$S$1255:$V$1255</c:f>
                <c:numCache>
                  <c:formatCode>General</c:formatCode>
                  <c:ptCount val="2"/>
                  <c:pt idx="0">
                    <c:v>4.4686401113140111</c:v>
                  </c:pt>
                  <c:pt idx="1">
                    <c:v>4.9766164319857999</c:v>
                  </c:pt>
                </c:numCache>
              </c:numRef>
            </c:minus>
          </c:errBars>
          <c:cat>
            <c:strRef>
              <c:f>Dormancy!$S$1250:$V$1250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S$1254:$V$1254</c:f>
              <c:numCache>
                <c:formatCode>General</c:formatCode>
                <c:ptCount val="2"/>
                <c:pt idx="0">
                  <c:v>24.813333333333279</c:v>
                </c:pt>
                <c:pt idx="1">
                  <c:v>24.9833333333332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E2-47F3-82A5-5B36DD1AE3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10008408"/>
        <c:axId val="-2075162152"/>
      </c:barChart>
      <c:catAx>
        <c:axId val="-20100084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75162152"/>
        <c:crosses val="autoZero"/>
        <c:auto val="1"/>
        <c:lblAlgn val="ctr"/>
        <c:lblOffset val="100"/>
        <c:noMultiLvlLbl val="0"/>
      </c:catAx>
      <c:valAx>
        <c:axId val="-2075162152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10008408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471323272090989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L$1255:$O$1255</c:f>
                <c:numCache>
                  <c:formatCode>General</c:formatCode>
                  <c:ptCount val="2"/>
                  <c:pt idx="0">
                    <c:v>4.6357643502567747</c:v>
                  </c:pt>
                  <c:pt idx="1">
                    <c:v>2.1920082116634481</c:v>
                  </c:pt>
                </c:numCache>
              </c:numRef>
            </c:plus>
            <c:minus>
              <c:numRef>
                <c:f>Dormancy!$L$1255:$O$1255</c:f>
                <c:numCache>
                  <c:formatCode>General</c:formatCode>
                  <c:ptCount val="2"/>
                  <c:pt idx="0">
                    <c:v>4.6357643502567747</c:v>
                  </c:pt>
                  <c:pt idx="1">
                    <c:v>2.1920082116634481</c:v>
                  </c:pt>
                </c:numCache>
              </c:numRef>
            </c:minus>
          </c:errBars>
          <c:cat>
            <c:strRef>
              <c:f>Dormancy!$L$1250:$O$1250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L$1254:$O$1254</c:f>
              <c:numCache>
                <c:formatCode>General</c:formatCode>
                <c:ptCount val="2"/>
                <c:pt idx="0">
                  <c:v>60.50333333333333</c:v>
                </c:pt>
                <c:pt idx="1">
                  <c:v>64.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02-4F17-ABC7-C2DA1ED5A5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10043576"/>
        <c:axId val="-2010040168"/>
      </c:barChart>
      <c:catAx>
        <c:axId val="-2010043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10040168"/>
        <c:crosses val="autoZero"/>
        <c:auto val="1"/>
        <c:lblAlgn val="ctr"/>
        <c:lblOffset val="100"/>
        <c:noMultiLvlLbl val="0"/>
      </c:catAx>
      <c:valAx>
        <c:axId val="-2010040168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10043576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471323272090989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S$1255:$V$1255</c:f>
                <c:numCache>
                  <c:formatCode>General</c:formatCode>
                  <c:ptCount val="2"/>
                  <c:pt idx="0">
                    <c:v>4.4686401113140111</c:v>
                  </c:pt>
                  <c:pt idx="1">
                    <c:v>4.9766164319857999</c:v>
                  </c:pt>
                </c:numCache>
              </c:numRef>
            </c:plus>
            <c:minus>
              <c:numRef>
                <c:f>Dormancy!$S$1255:$V$1255</c:f>
                <c:numCache>
                  <c:formatCode>General</c:formatCode>
                  <c:ptCount val="2"/>
                  <c:pt idx="0">
                    <c:v>4.4686401113140111</c:v>
                  </c:pt>
                  <c:pt idx="1">
                    <c:v>4.9766164319857999</c:v>
                  </c:pt>
                </c:numCache>
              </c:numRef>
            </c:minus>
          </c:errBars>
          <c:cat>
            <c:strRef>
              <c:f>Dormancy!$S$1250:$V$1250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S$1254:$V$1254</c:f>
              <c:numCache>
                <c:formatCode>General</c:formatCode>
                <c:ptCount val="2"/>
                <c:pt idx="0">
                  <c:v>24.813333333333279</c:v>
                </c:pt>
                <c:pt idx="1">
                  <c:v>24.9833333333332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C6-4A99-BFBF-BEC4577B78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9881720"/>
        <c:axId val="-2010058728"/>
      </c:barChart>
      <c:catAx>
        <c:axId val="-20098817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10058728"/>
        <c:crosses val="autoZero"/>
        <c:auto val="1"/>
        <c:lblAlgn val="ctr"/>
        <c:lblOffset val="100"/>
        <c:noMultiLvlLbl val="0"/>
      </c:catAx>
      <c:valAx>
        <c:axId val="-2010058728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881720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9.1020304752253103E-2"/>
          <c:w val="0.85756826449325396"/>
          <c:h val="0.77196583066005597"/>
        </c:manualLayout>
      </c:layout>
      <c:barChart>
        <c:barDir val="col"/>
        <c:grouping val="clustered"/>
        <c:varyColors val="0"/>
        <c:ser>
          <c:idx val="2"/>
          <c:order val="2"/>
          <c:tx>
            <c:strRef>
              <c:f>Dormancy!$X$1220</c:f>
              <c:strCache>
                <c:ptCount val="1"/>
                <c:pt idx="0">
                  <c:v>R-FAC/AIT</c:v>
                </c:pt>
              </c:strCache>
              <c:extLst xmlns:c15="http://schemas.microsoft.com/office/drawing/2012/chart"/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07E-4DD6-AE91-54A83259B699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307E-4DD6-AE91-54A83259B699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307E-4DD6-AE91-54A83259B699}"/>
              </c:ext>
            </c:extLst>
          </c:dPt>
          <c:errBars>
            <c:errBarType val="both"/>
            <c:errValType val="cust"/>
            <c:noEndCap val="0"/>
            <c:plus>
              <c:numRef>
                <c:f>Dormancy!$Y$1208:$AB$1208</c:f>
                <c:numCache>
                  <c:formatCode>General</c:formatCode>
                  <c:ptCount val="4"/>
                  <c:pt idx="0">
                    <c:v>1.602570851267842</c:v>
                  </c:pt>
                  <c:pt idx="1">
                    <c:v>2.806731986571652</c:v>
                  </c:pt>
                  <c:pt idx="2">
                    <c:v>0.45182346601791701</c:v>
                  </c:pt>
                  <c:pt idx="3">
                    <c:v>1.487383982403707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Y$1208:$AB$1208</c:f>
                <c:numCache>
                  <c:formatCode>General</c:formatCode>
                  <c:ptCount val="4"/>
                  <c:pt idx="0">
                    <c:v>1.602570851267842</c:v>
                  </c:pt>
                  <c:pt idx="1">
                    <c:v>2.806731986571652</c:v>
                  </c:pt>
                  <c:pt idx="2">
                    <c:v>0.45182346601791701</c:v>
                  </c:pt>
                  <c:pt idx="3">
                    <c:v>1.487383982403707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Y$1217:$AB$1217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Y$1220:$AB$1220</c:f>
              <c:numCache>
                <c:formatCode>General</c:formatCode>
                <c:ptCount val="4"/>
                <c:pt idx="0">
                  <c:v>47.31</c:v>
                </c:pt>
                <c:pt idx="1">
                  <c:v>44.376666666666601</c:v>
                </c:pt>
                <c:pt idx="2">
                  <c:v>2.3066666666666662</c:v>
                </c:pt>
                <c:pt idx="3">
                  <c:v>4.6933333333333334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3-307E-4DD6-AE91-54A83259B699}"/>
            </c:ext>
          </c:extLst>
        </c:ser>
        <c:ser>
          <c:idx val="3"/>
          <c:order val="3"/>
          <c:tx>
            <c:strRef>
              <c:f>Dormancy!$X$1221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rgbClr val="FF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Y$1215:$AB$1215</c:f>
                <c:numCache>
                  <c:formatCode>General</c:formatCode>
                  <c:ptCount val="4"/>
                  <c:pt idx="0">
                    <c:v>1.7596432719288451</c:v>
                  </c:pt>
                  <c:pt idx="1">
                    <c:v>2.8821924525148108</c:v>
                  </c:pt>
                  <c:pt idx="2">
                    <c:v>1.3102841082927199</c:v>
                  </c:pt>
                  <c:pt idx="3">
                    <c:v>0.18205615739228501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Y$1215:$AB$1215</c:f>
                <c:numCache>
                  <c:formatCode>General</c:formatCode>
                  <c:ptCount val="4"/>
                  <c:pt idx="0">
                    <c:v>1.7596432719288451</c:v>
                  </c:pt>
                  <c:pt idx="1">
                    <c:v>2.8821924525148108</c:v>
                  </c:pt>
                  <c:pt idx="2">
                    <c:v>1.3102841082927199</c:v>
                  </c:pt>
                  <c:pt idx="3">
                    <c:v>0.18205615739228501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Y$1217:$AB$1217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Y$1221:$AB$1221</c:f>
              <c:numCache>
                <c:formatCode>General</c:formatCode>
                <c:ptCount val="4"/>
                <c:pt idx="0">
                  <c:v>78.31333333333329</c:v>
                </c:pt>
                <c:pt idx="1">
                  <c:v>30.02</c:v>
                </c:pt>
                <c:pt idx="2">
                  <c:v>8.5633333333333344</c:v>
                </c:pt>
                <c:pt idx="3">
                  <c:v>1.256666666666667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4-307E-4DD6-AE91-54A83259B6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25865368"/>
        <c:axId val="-2009407240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X$1218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spPr>
                  <a:solidFill>
                    <a:schemeClr val="tx1"/>
                  </a:solidFill>
                </c:spPr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6-307E-4DD6-AE91-54A83259B699}"/>
                    </c:ext>
                  </c:extLst>
                </c:dPt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8-307E-4DD6-AE91-54A83259B699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Y$1194:$AB$1194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5.2266847363633309</c:v>
                        </c:pt>
                        <c:pt idx="1">
                          <c:v>6.1384389980949825</c:v>
                        </c:pt>
                        <c:pt idx="2">
                          <c:v>0.61344201935562837</c:v>
                        </c:pt>
                        <c:pt idx="3">
                          <c:v>1.2985504739259597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Y$1194:$AB$1194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5.2266847363633309</c:v>
                        </c:pt>
                        <c:pt idx="1">
                          <c:v>6.1384389980949825</c:v>
                        </c:pt>
                        <c:pt idx="2">
                          <c:v>0.61344201935562837</c:v>
                        </c:pt>
                        <c:pt idx="3">
                          <c:v>1.2985504739259597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Dormancy!$Y$1217:$AB$1217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Dormancy!$Y$1218:$AB$1218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65.39</c:v>
                      </c:pt>
                      <c:pt idx="1">
                        <c:v>20.07</c:v>
                      </c:pt>
                      <c:pt idx="2">
                        <c:v>1.0633333333333332</c:v>
                      </c:pt>
                      <c:pt idx="3">
                        <c:v>2.65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9-307E-4DD6-AE91-54A83259B699}"/>
                  </c:ext>
                </c:extLst>
              </c15:ser>
            </c15:filteredBarSeries>
            <c15:filteredBa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X$1219</c15:sqref>
                        </c15:formulaRef>
                      </c:ext>
                    </c:extLst>
                    <c:strCache>
                      <c:ptCount val="1"/>
                      <c:pt idx="0">
                        <c:v>R-FAC</c:v>
                      </c:pt>
                    </c:strCache>
                  </c:strRef>
                </c:tx>
                <c:spPr>
                  <a:solidFill>
                    <a:srgbClr val="FF0000"/>
                  </a:solidFill>
                </c:spPr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B-307E-4DD6-AE91-54A83259B699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Y$1201:$AB$1201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22999999999999685</c:v>
                        </c:pt>
                        <c:pt idx="1">
                          <c:v>6.0000000000000046E-2</c:v>
                        </c:pt>
                        <c:pt idx="2">
                          <c:v>6.5000000000000016E-2</c:v>
                        </c:pt>
                        <c:pt idx="3">
                          <c:v>2.4999999999999994E-2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Y$1201:$AB$1201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22999999999999685</c:v>
                        </c:pt>
                        <c:pt idx="1">
                          <c:v>6.0000000000000046E-2</c:v>
                        </c:pt>
                        <c:pt idx="2">
                          <c:v>6.5000000000000016E-2</c:v>
                        </c:pt>
                        <c:pt idx="3">
                          <c:v>2.4999999999999994E-2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Y$1217:$AB$1217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Y$1219:$AB$1219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84.22999999999999</c:v>
                      </c:pt>
                      <c:pt idx="1">
                        <c:v>2.75</c:v>
                      </c:pt>
                      <c:pt idx="2">
                        <c:v>0.16500000000000001</c:v>
                      </c:pt>
                      <c:pt idx="3">
                        <c:v>0.48499999999999999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C-307E-4DD6-AE91-54A83259B699}"/>
                  </c:ext>
                </c:extLst>
              </c15:ser>
            </c15:filteredBarSeries>
          </c:ext>
        </c:extLst>
      </c:barChart>
      <c:catAx>
        <c:axId val="-2125865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407240"/>
        <c:crosses val="autoZero"/>
        <c:auto val="1"/>
        <c:lblAlgn val="ctr"/>
        <c:lblOffset val="100"/>
        <c:noMultiLvlLbl val="0"/>
      </c:catAx>
      <c:valAx>
        <c:axId val="-2009407240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25865368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5534622186451198"/>
          <c:y val="4.0201475868985002E-2"/>
          <c:w val="0.63697942616652903"/>
          <c:h val="0.14339581550118299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636135170603674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AM$1664:$AP$1664</c:f>
                <c:numCache>
                  <c:formatCode>General</c:formatCode>
                  <c:ptCount val="4"/>
                  <c:pt idx="0">
                    <c:v>2.327015255644012</c:v>
                  </c:pt>
                  <c:pt idx="1">
                    <c:v>2.4449999999999972</c:v>
                  </c:pt>
                  <c:pt idx="2">
                    <c:v>1.6518709930795981</c:v>
                  </c:pt>
                  <c:pt idx="3">
                    <c:v>2.9915937781278599</c:v>
                  </c:pt>
                </c:numCache>
              </c:numRef>
            </c:plus>
            <c:minus>
              <c:numRef>
                <c:f>Dormancy!$AM$1664:$AP$1664</c:f>
                <c:numCache>
                  <c:formatCode>General</c:formatCode>
                  <c:ptCount val="4"/>
                  <c:pt idx="0">
                    <c:v>2.327015255644012</c:v>
                  </c:pt>
                  <c:pt idx="1">
                    <c:v>2.4449999999999972</c:v>
                  </c:pt>
                  <c:pt idx="2">
                    <c:v>1.6518709930795981</c:v>
                  </c:pt>
                  <c:pt idx="3">
                    <c:v>2.9915937781278599</c:v>
                  </c:pt>
                </c:numCache>
              </c:numRef>
            </c:minus>
          </c:errBars>
          <c:cat>
            <c:strRef>
              <c:f>Dormancy!$AM$1659:$AP$1659</c:f>
              <c:strCache>
                <c:ptCount val="4"/>
                <c:pt idx="0">
                  <c:v>MMC</c:v>
                </c:pt>
                <c:pt idx="1">
                  <c:v>Ctrl</c:v>
                </c:pt>
                <c:pt idx="2">
                  <c:v>FAC</c:v>
                </c:pt>
                <c:pt idx="3">
                  <c:v>FAC/AIT</c:v>
                </c:pt>
              </c:strCache>
            </c:strRef>
          </c:cat>
          <c:val>
            <c:numRef>
              <c:f>Dormancy!$AM$1663:$AP$1663</c:f>
              <c:numCache>
                <c:formatCode>General</c:formatCode>
                <c:ptCount val="4"/>
                <c:pt idx="0">
                  <c:v>24.123333333333282</c:v>
                </c:pt>
                <c:pt idx="1">
                  <c:v>55.484999999999999</c:v>
                </c:pt>
                <c:pt idx="2">
                  <c:v>55.396666666666583</c:v>
                </c:pt>
                <c:pt idx="3">
                  <c:v>76.20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68-45CA-9509-876603B099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0324328"/>
        <c:axId val="-2009236152"/>
      </c:barChart>
      <c:catAx>
        <c:axId val="2130324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236152"/>
        <c:crosses val="autoZero"/>
        <c:auto val="1"/>
        <c:lblAlgn val="ctr"/>
        <c:lblOffset val="100"/>
        <c:noMultiLvlLbl val="0"/>
      </c:catAx>
      <c:valAx>
        <c:axId val="-2009236152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2130324328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latin typeface="+mj-lt"/>
        </a:defRPr>
      </a:pPr>
      <a:endParaRPr lang="en-US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5.5555555555555601E-2"/>
          <c:w val="0.85756826449325396"/>
          <c:h val="0.791999003596773"/>
        </c:manualLayout>
      </c:layout>
      <c:barChart>
        <c:barDir val="col"/>
        <c:grouping val="clustered"/>
        <c:varyColors val="0"/>
        <c:ser>
          <c:idx val="2"/>
          <c:order val="2"/>
          <c:tx>
            <c:strRef>
              <c:f>Dormancy!$AH$1220</c:f>
              <c:strCache>
                <c:ptCount val="1"/>
                <c:pt idx="0">
                  <c:v>R-FAC/AIT</c:v>
                </c:pt>
              </c:strCache>
              <c:extLst xmlns:c15="http://schemas.microsoft.com/office/drawing/2012/chart"/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AAE2-47CD-8EEB-954567DF2D8A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AAE2-47CD-8EEB-954567DF2D8A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AAE2-47CD-8EEB-954567DF2D8A}"/>
              </c:ext>
            </c:extLst>
          </c:dPt>
          <c:errBars>
            <c:errBarType val="both"/>
            <c:errValType val="cust"/>
            <c:noEndCap val="0"/>
            <c:plus>
              <c:numRef>
                <c:f>Dormancy!$AI$1208:$AL$1208</c:f>
                <c:numCache>
                  <c:formatCode>General</c:formatCode>
                  <c:ptCount val="4"/>
                  <c:pt idx="0">
                    <c:v>0.996683388934409</c:v>
                  </c:pt>
                  <c:pt idx="1">
                    <c:v>2.8733855370354489</c:v>
                  </c:pt>
                  <c:pt idx="2">
                    <c:v>0.90781789657029899</c:v>
                  </c:pt>
                  <c:pt idx="3">
                    <c:v>1.7795723581180329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I$1208:$AL$1208</c:f>
                <c:numCache>
                  <c:formatCode>General</c:formatCode>
                  <c:ptCount val="4"/>
                  <c:pt idx="0">
                    <c:v>0.996683388934409</c:v>
                  </c:pt>
                  <c:pt idx="1">
                    <c:v>2.8733855370354489</c:v>
                  </c:pt>
                  <c:pt idx="2">
                    <c:v>0.90781789657029899</c:v>
                  </c:pt>
                  <c:pt idx="3">
                    <c:v>1.7795723581180329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I$1217:$AL$1217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I$1220:$AL$1220</c:f>
              <c:numCache>
                <c:formatCode>General</c:formatCode>
                <c:ptCount val="4"/>
                <c:pt idx="0">
                  <c:v>26.096666666666671</c:v>
                </c:pt>
                <c:pt idx="1">
                  <c:v>29.553333333333299</c:v>
                </c:pt>
                <c:pt idx="2">
                  <c:v>9.26</c:v>
                </c:pt>
                <c:pt idx="3">
                  <c:v>28.106666666666669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3-AAE2-47CD-8EEB-954567DF2D8A}"/>
            </c:ext>
          </c:extLst>
        </c:ser>
        <c:ser>
          <c:idx val="3"/>
          <c:order val="3"/>
          <c:tx>
            <c:strRef>
              <c:f>Dormancy!$AH$1221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rgbClr val="FF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AI$1215:$AL$1215</c:f>
                <c:numCache>
                  <c:formatCode>General</c:formatCode>
                  <c:ptCount val="4"/>
                  <c:pt idx="0">
                    <c:v>2.7514380078626348</c:v>
                  </c:pt>
                  <c:pt idx="1">
                    <c:v>2.7829899987842812</c:v>
                  </c:pt>
                  <c:pt idx="2">
                    <c:v>0.77860987235799495</c:v>
                  </c:pt>
                  <c:pt idx="3">
                    <c:v>2.1830126991028842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I$1215:$AL$1215</c:f>
                <c:numCache>
                  <c:formatCode>General</c:formatCode>
                  <c:ptCount val="4"/>
                  <c:pt idx="0">
                    <c:v>2.7514380078626348</c:v>
                  </c:pt>
                  <c:pt idx="1">
                    <c:v>2.7829899987842812</c:v>
                  </c:pt>
                  <c:pt idx="2">
                    <c:v>0.77860987235799495</c:v>
                  </c:pt>
                  <c:pt idx="3">
                    <c:v>2.1830126991028842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I$1217:$AL$1217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I$1221:$AL$1221</c:f>
              <c:numCache>
                <c:formatCode>General</c:formatCode>
                <c:ptCount val="4"/>
                <c:pt idx="0">
                  <c:v>39.9166666666666</c:v>
                </c:pt>
                <c:pt idx="1">
                  <c:v>22.97</c:v>
                </c:pt>
                <c:pt idx="2">
                  <c:v>3.27</c:v>
                </c:pt>
                <c:pt idx="3">
                  <c:v>12.573333333333331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4-AAE2-47CD-8EEB-954567DF2D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10282344"/>
        <c:axId val="-2058320376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AH$1218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spPr>
                  <a:solidFill>
                    <a:srgbClr val="00B050"/>
                  </a:solidFill>
                </c:spPr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6-AAE2-47CD-8EEB-954567DF2D8A}"/>
                    </c:ext>
                  </c:extLst>
                </c:dPt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8-AAE2-47CD-8EEB-954567DF2D8A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A-AAE2-47CD-8EEB-954567DF2D8A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AI$1194:$AL$1194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77272245987805899</c:v>
                        </c:pt>
                        <c:pt idx="1">
                          <c:v>2.1725126262259296</c:v>
                        </c:pt>
                        <c:pt idx="2">
                          <c:v>2.1735250426694233</c:v>
                        </c:pt>
                        <c:pt idx="3">
                          <c:v>3.4163154291006337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AI$1194:$AL$1194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77272245987805899</c:v>
                        </c:pt>
                        <c:pt idx="1">
                          <c:v>2.1725126262259296</c:v>
                        </c:pt>
                        <c:pt idx="2">
                          <c:v>2.1735250426694233</c:v>
                        </c:pt>
                        <c:pt idx="3">
                          <c:v>3.4163154291006337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Dormancy!$AI$1217:$AL$1217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Dormancy!$AI$1218:$AL$1218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9.36</c:v>
                      </c:pt>
                      <c:pt idx="1">
                        <c:v>28.413333333333338</c:v>
                      </c:pt>
                      <c:pt idx="2">
                        <c:v>8.6366666666666649</c:v>
                      </c:pt>
                      <c:pt idx="3">
                        <c:v>24.003333333333334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B-AAE2-47CD-8EEB-954567DF2D8A}"/>
                  </c:ext>
                </c:extLst>
              </c15:ser>
            </c15:filteredBarSeries>
            <c15:filteredBa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H$1219</c15:sqref>
                        </c15:formulaRef>
                      </c:ext>
                    </c:extLst>
                    <c:strCache>
                      <c:ptCount val="1"/>
                      <c:pt idx="0">
                        <c:v>R-FAC</c:v>
                      </c:pt>
                    </c:strCache>
                  </c:strRef>
                </c:tx>
                <c:spPr>
                  <a:solidFill>
                    <a:schemeClr val="tx1"/>
                  </a:solidFill>
                </c:spPr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D-AAE2-47CD-8EEB-954567DF2D8A}"/>
                    </c:ext>
                  </c:extLst>
                </c:dPt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F-AAE2-47CD-8EEB-954567DF2D8A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I$1201:$AL$1201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5250000000000021</c:v>
                        </c:pt>
                        <c:pt idx="1">
                          <c:v>0.1800000000000006</c:v>
                        </c:pt>
                        <c:pt idx="2">
                          <c:v>0.21000000000000008</c:v>
                        </c:pt>
                        <c:pt idx="3">
                          <c:v>0.13500000000000001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I$1201:$AL$1201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5250000000000021</c:v>
                        </c:pt>
                        <c:pt idx="1">
                          <c:v>0.1800000000000006</c:v>
                        </c:pt>
                        <c:pt idx="2">
                          <c:v>0.21000000000000008</c:v>
                        </c:pt>
                        <c:pt idx="3">
                          <c:v>0.13500000000000001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I$1217:$AL$1217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I$1219:$AL$1219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44.034999999999997</c:v>
                      </c:pt>
                      <c:pt idx="1">
                        <c:v>8.2100000000000009</c:v>
                      </c:pt>
                      <c:pt idx="2">
                        <c:v>0.83000000000000007</c:v>
                      </c:pt>
                      <c:pt idx="3">
                        <c:v>3.5350000000000001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0-AAE2-47CD-8EEB-954567DF2D8A}"/>
                  </c:ext>
                </c:extLst>
              </c15:ser>
            </c15:filteredBarSeries>
          </c:ext>
        </c:extLst>
      </c:barChart>
      <c:catAx>
        <c:axId val="-2110282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58320376"/>
        <c:crosses val="autoZero"/>
        <c:auto val="1"/>
        <c:lblAlgn val="ctr"/>
        <c:lblOffset val="100"/>
        <c:noMultiLvlLbl val="0"/>
      </c:catAx>
      <c:valAx>
        <c:axId val="-2058320376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10282344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5556474803100802"/>
          <c:y val="4.82418015843823E-2"/>
          <c:w val="0.57815922501357597"/>
          <c:h val="0.15947650681241299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6.1025444736074699E-2"/>
          <c:w val="0.85756826449325396"/>
          <c:h val="0.77873468941382296"/>
        </c:manualLayout>
      </c:layout>
      <c:barChart>
        <c:barDir val="col"/>
        <c:grouping val="clustered"/>
        <c:varyColors val="0"/>
        <c:ser>
          <c:idx val="2"/>
          <c:order val="2"/>
          <c:tx>
            <c:strRef>
              <c:f>Dormancy!$X$1280</c:f>
              <c:strCache>
                <c:ptCount val="1"/>
                <c:pt idx="0">
                  <c:v>R-FAC/AIT</c:v>
                </c:pt>
              </c:strCache>
              <c:extLst xmlns:c15="http://schemas.microsoft.com/office/drawing/2012/chart"/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86D6-4D25-AFE4-2433A6411632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86D6-4D25-AFE4-2433A6411632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86D6-4D25-AFE4-2433A6411632}"/>
              </c:ext>
            </c:extLst>
          </c:dPt>
          <c:errBars>
            <c:errBarType val="both"/>
            <c:errValType val="cust"/>
            <c:noEndCap val="0"/>
            <c:plus>
              <c:numRef>
                <c:f>Dormancy!$Y$1269:$AB$1269</c:f>
                <c:numCache>
                  <c:formatCode>General</c:formatCode>
                  <c:ptCount val="4"/>
                  <c:pt idx="0">
                    <c:v>1.733676248130928</c:v>
                  </c:pt>
                  <c:pt idx="1">
                    <c:v>0.75291286200846597</c:v>
                  </c:pt>
                  <c:pt idx="2">
                    <c:v>1.482119353418536</c:v>
                  </c:pt>
                  <c:pt idx="3">
                    <c:v>0.46095311885025497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Y$1269:$AB$1269</c:f>
                <c:numCache>
                  <c:formatCode>General</c:formatCode>
                  <c:ptCount val="4"/>
                  <c:pt idx="0">
                    <c:v>1.733676248130928</c:v>
                  </c:pt>
                  <c:pt idx="1">
                    <c:v>0.75291286200846597</c:v>
                  </c:pt>
                  <c:pt idx="2">
                    <c:v>1.482119353418536</c:v>
                  </c:pt>
                  <c:pt idx="3">
                    <c:v>0.46095311885025497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Y$1277:$AB$1277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Y$1280:$AB$1280</c:f>
              <c:numCache>
                <c:formatCode>General</c:formatCode>
                <c:ptCount val="4"/>
                <c:pt idx="0">
                  <c:v>26.01</c:v>
                </c:pt>
                <c:pt idx="1">
                  <c:v>56.233333333333327</c:v>
                </c:pt>
                <c:pt idx="2">
                  <c:v>6.6566666666666663</c:v>
                </c:pt>
                <c:pt idx="3">
                  <c:v>8.8966666666666701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3-86D6-4D25-AFE4-2433A6411632}"/>
            </c:ext>
          </c:extLst>
        </c:ser>
        <c:ser>
          <c:idx val="3"/>
          <c:order val="3"/>
          <c:tx>
            <c:strRef>
              <c:f>Dormancy!$X$1281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rgbClr val="FF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Y$1276:$AB$1276</c:f>
                <c:numCache>
                  <c:formatCode>General</c:formatCode>
                  <c:ptCount val="4"/>
                  <c:pt idx="0">
                    <c:v>10.871485639046799</c:v>
                  </c:pt>
                  <c:pt idx="1">
                    <c:v>2.7401480089789199</c:v>
                  </c:pt>
                  <c:pt idx="2">
                    <c:v>8.3905230932152133</c:v>
                  </c:pt>
                  <c:pt idx="3">
                    <c:v>1.515149424240982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Y$1276:$AB$1276</c:f>
                <c:numCache>
                  <c:formatCode>General</c:formatCode>
                  <c:ptCount val="4"/>
                  <c:pt idx="0">
                    <c:v>10.871485639046799</c:v>
                  </c:pt>
                  <c:pt idx="1">
                    <c:v>2.7401480089789199</c:v>
                  </c:pt>
                  <c:pt idx="2">
                    <c:v>8.3905230932152133</c:v>
                  </c:pt>
                  <c:pt idx="3">
                    <c:v>1.515149424240982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Y$1277:$AB$1277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Y$1281:$AB$1281</c:f>
              <c:numCache>
                <c:formatCode>General</c:formatCode>
                <c:ptCount val="4"/>
                <c:pt idx="0">
                  <c:v>60.15</c:v>
                </c:pt>
                <c:pt idx="1">
                  <c:v>23.38666666666667</c:v>
                </c:pt>
                <c:pt idx="2">
                  <c:v>23.936666666666671</c:v>
                </c:pt>
                <c:pt idx="3">
                  <c:v>3.936666666666667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4-86D6-4D25-AFE4-2433A64116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24366392"/>
        <c:axId val="-2014486472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X$1278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spPr>
                  <a:solidFill>
                    <a:srgbClr val="00B050"/>
                  </a:solidFill>
                </c:spPr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6-86D6-4D25-AFE4-2433A6411632}"/>
                    </c:ext>
                  </c:extLst>
                </c:dPt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8-86D6-4D25-AFE4-2433A6411632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A-86D6-4D25-AFE4-2433A6411632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Y$1255:$AB$125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6.1394607074055898</c:v>
                        </c:pt>
                        <c:pt idx="1">
                          <c:v>5.3166792058368308</c:v>
                        </c:pt>
                        <c:pt idx="2">
                          <c:v>0.74869516122681368</c:v>
                        </c:pt>
                        <c:pt idx="3">
                          <c:v>0.94678989808252223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Y$1255:$AB$125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6.1394607074055898</c:v>
                        </c:pt>
                        <c:pt idx="1">
                          <c:v>5.3166792058368308</c:v>
                        </c:pt>
                        <c:pt idx="2">
                          <c:v>0.74869516122681368</c:v>
                        </c:pt>
                        <c:pt idx="3">
                          <c:v>0.94678989808252223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Dormancy!$Y$1277:$AB$1277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Dormancy!$Y$1278:$AB$1278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62.346666666666671</c:v>
                      </c:pt>
                      <c:pt idx="1">
                        <c:v>23.706666666666667</c:v>
                      </c:pt>
                      <c:pt idx="2">
                        <c:v>1.4133333333333333</c:v>
                      </c:pt>
                      <c:pt idx="3">
                        <c:v>3.8933333333333331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B-86D6-4D25-AFE4-2433A6411632}"/>
                  </c:ext>
                </c:extLst>
              </c15:ser>
            </c15:filteredBarSeries>
            <c15:filteredBa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X$1279</c15:sqref>
                        </c15:formulaRef>
                      </c:ext>
                    </c:extLst>
                    <c:strCache>
                      <c:ptCount val="1"/>
                      <c:pt idx="0">
                        <c:v>R-FAC</c:v>
                      </c:pt>
                    </c:strCache>
                  </c:strRef>
                </c:tx>
                <c:spPr>
                  <a:solidFill>
                    <a:srgbClr val="FF0000"/>
                  </a:solidFill>
                </c:spPr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D-86D6-4D25-AFE4-2433A6411632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Y$1262:$AB$1262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72500000000000131</c:v>
                        </c:pt>
                        <c:pt idx="1">
                          <c:v>0.79499999999999471</c:v>
                        </c:pt>
                        <c:pt idx="2">
                          <c:v>1.4999999999999986E-2</c:v>
                        </c:pt>
                        <c:pt idx="3">
                          <c:v>0.06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Y$1262:$AB$1262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72500000000000131</c:v>
                        </c:pt>
                        <c:pt idx="1">
                          <c:v>0.79499999999999471</c:v>
                        </c:pt>
                        <c:pt idx="2">
                          <c:v>1.4999999999999986E-2</c:v>
                        </c:pt>
                        <c:pt idx="3">
                          <c:v>0.06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Y$1277:$AB$1277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Y$1279:$AB$1279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81.525000000000006</c:v>
                      </c:pt>
                      <c:pt idx="1">
                        <c:v>7.1850000000000005</c:v>
                      </c:pt>
                      <c:pt idx="2">
                        <c:v>0.45499999999999996</c:v>
                      </c:pt>
                      <c:pt idx="3">
                        <c:v>0.7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E-86D6-4D25-AFE4-2433A6411632}"/>
                  </c:ext>
                </c:extLst>
              </c15:ser>
            </c15:filteredBarSeries>
          </c:ext>
        </c:extLst>
      </c:barChart>
      <c:catAx>
        <c:axId val="-21243663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14486472"/>
        <c:crosses val="autoZero"/>
        <c:auto val="1"/>
        <c:lblAlgn val="ctr"/>
        <c:lblOffset val="100"/>
        <c:noMultiLvlLbl val="0"/>
      </c:catAx>
      <c:valAx>
        <c:axId val="-2014486472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24366392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3296642517934499"/>
          <c:y val="3.9944995426769797E-2"/>
          <c:w val="0.58781501653357204"/>
          <c:h val="0.174436964280996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6.4814814814814797E-2"/>
          <c:w val="0.85756826449325396"/>
          <c:h val="0.77502430251774101"/>
        </c:manualLayout>
      </c:layout>
      <c:barChart>
        <c:barDir val="col"/>
        <c:grouping val="clustered"/>
        <c:varyColors val="0"/>
        <c:ser>
          <c:idx val="2"/>
          <c:order val="2"/>
          <c:tx>
            <c:strRef>
              <c:f>Dormancy!$AJ$1280</c:f>
              <c:strCache>
                <c:ptCount val="1"/>
                <c:pt idx="0">
                  <c:v>R-FAC/AIT</c:v>
                </c:pt>
              </c:strCache>
              <c:extLst xmlns:c15="http://schemas.microsoft.com/office/drawing/2012/chart"/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66B-467F-BD1F-19B47C5E3ABA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366B-467F-BD1F-19B47C5E3ABA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366B-467F-BD1F-19B47C5E3ABA}"/>
              </c:ext>
            </c:extLst>
          </c:dPt>
          <c:errBars>
            <c:errBarType val="both"/>
            <c:errValType val="cust"/>
            <c:noEndCap val="0"/>
            <c:plus>
              <c:numRef>
                <c:f>Dormancy!$AK$1269:$AN$1269</c:f>
                <c:numCache>
                  <c:formatCode>General</c:formatCode>
                  <c:ptCount val="4"/>
                  <c:pt idx="0">
                    <c:v>2.868141093693497</c:v>
                  </c:pt>
                  <c:pt idx="1">
                    <c:v>2.9246158342213211</c:v>
                  </c:pt>
                  <c:pt idx="2">
                    <c:v>0.282901631902918</c:v>
                  </c:pt>
                  <c:pt idx="3">
                    <c:v>2.5299165554969849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K$1269:$AN$1269</c:f>
                <c:numCache>
                  <c:formatCode>General</c:formatCode>
                  <c:ptCount val="4"/>
                  <c:pt idx="0">
                    <c:v>2.868141093693497</c:v>
                  </c:pt>
                  <c:pt idx="1">
                    <c:v>2.9246158342213211</c:v>
                  </c:pt>
                  <c:pt idx="2">
                    <c:v>0.282901631902918</c:v>
                  </c:pt>
                  <c:pt idx="3">
                    <c:v>2.5299165554969849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K$1277:$AN$1277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K$1280:$AN$1280</c:f>
              <c:numCache>
                <c:formatCode>General</c:formatCode>
                <c:ptCount val="4"/>
                <c:pt idx="0">
                  <c:v>15.81</c:v>
                </c:pt>
                <c:pt idx="1">
                  <c:v>37.576666666666611</c:v>
                </c:pt>
                <c:pt idx="2">
                  <c:v>2.48</c:v>
                </c:pt>
                <c:pt idx="3">
                  <c:v>32.256666666666611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3-366B-467F-BD1F-19B47C5E3ABA}"/>
            </c:ext>
          </c:extLst>
        </c:ser>
        <c:ser>
          <c:idx val="3"/>
          <c:order val="3"/>
          <c:tx>
            <c:strRef>
              <c:f>Dormancy!$AJ$1281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rgbClr val="FF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AK$1276:$AN$1276</c:f>
                <c:numCache>
                  <c:formatCode>General</c:formatCode>
                  <c:ptCount val="4"/>
                  <c:pt idx="0">
                    <c:v>5.6324269487791216</c:v>
                  </c:pt>
                  <c:pt idx="1">
                    <c:v>5.5466516426078574</c:v>
                  </c:pt>
                  <c:pt idx="2">
                    <c:v>0.656895053346508</c:v>
                  </c:pt>
                  <c:pt idx="3">
                    <c:v>2.890515140555014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K$1276:$AN$1276</c:f>
                <c:numCache>
                  <c:formatCode>General</c:formatCode>
                  <c:ptCount val="4"/>
                  <c:pt idx="0">
                    <c:v>5.6324269487791216</c:v>
                  </c:pt>
                  <c:pt idx="1">
                    <c:v>5.5466516426078574</c:v>
                  </c:pt>
                  <c:pt idx="2">
                    <c:v>0.656895053346508</c:v>
                  </c:pt>
                  <c:pt idx="3">
                    <c:v>2.890515140555014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K$1277:$AN$1277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K$1281:$AN$1281</c:f>
              <c:numCache>
                <c:formatCode>General</c:formatCode>
                <c:ptCount val="4"/>
                <c:pt idx="0">
                  <c:v>32.299999999999997</c:v>
                </c:pt>
                <c:pt idx="1">
                  <c:v>31.286666666666662</c:v>
                </c:pt>
                <c:pt idx="2">
                  <c:v>1.866666666666666</c:v>
                </c:pt>
                <c:pt idx="3">
                  <c:v>13.286666666666671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4-366B-467F-BD1F-19B47C5E3A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27458344"/>
        <c:axId val="2127653848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AJ$1278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spPr>
                  <a:solidFill>
                    <a:srgbClr val="0070C0"/>
                  </a:solidFill>
                </c:spPr>
                <c:invertIfNegative val="0"/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6-366B-467F-BD1F-19B47C5E3ABA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8-366B-467F-BD1F-19B47C5E3ABA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AK$1255:$AN$125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4.5947179819150303</c:v>
                        </c:pt>
                        <c:pt idx="1">
                          <c:v>10.029999999999999</c:v>
                        </c:pt>
                        <c:pt idx="2">
                          <c:v>0.4</c:v>
                        </c:pt>
                        <c:pt idx="3">
                          <c:v>9.253390369660913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AK$1255:$AN$125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4.5947179819150303</c:v>
                        </c:pt>
                        <c:pt idx="1">
                          <c:v>10.029999999999999</c:v>
                        </c:pt>
                        <c:pt idx="2">
                          <c:v>0.4</c:v>
                        </c:pt>
                        <c:pt idx="3">
                          <c:v>9.253390369660913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Dormancy!$AK$1277:$AN$1277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Dormancy!$AK$1278:$AN$1278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6.07</c:v>
                      </c:pt>
                      <c:pt idx="1">
                        <c:v>10.029999999999999</c:v>
                      </c:pt>
                      <c:pt idx="2">
                        <c:v>0.39999999999999997</c:v>
                      </c:pt>
                      <c:pt idx="3">
                        <c:v>17.38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9-366B-467F-BD1F-19B47C5E3ABA}"/>
                  </c:ext>
                </c:extLst>
              </c15:ser>
            </c15:filteredBarSeries>
            <c15:filteredBa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J$1279</c15:sqref>
                        </c15:formulaRef>
                      </c:ext>
                    </c:extLst>
                    <c:strCache>
                      <c:ptCount val="1"/>
                      <c:pt idx="0">
                        <c:v>R-FAC</c:v>
                      </c:pt>
                    </c:strCache>
                  </c:strRef>
                </c:tx>
                <c:spPr>
                  <a:solidFill>
                    <a:schemeClr val="tx1"/>
                  </a:solidFill>
                </c:spPr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B-366B-467F-BD1F-19B47C5E3ABA}"/>
                    </c:ext>
                  </c:extLst>
                </c:dPt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D-366B-467F-BD1F-19B47C5E3ABA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K$1262:$AN$1262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51999999999999957</c:v>
                        </c:pt>
                        <c:pt idx="1">
                          <c:v>0.30499999999999966</c:v>
                        </c:pt>
                        <c:pt idx="2">
                          <c:v>0.30000000000000021</c:v>
                        </c:pt>
                        <c:pt idx="3">
                          <c:v>0.58999999999999986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K$1262:$AN$1262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51999999999999957</c:v>
                        </c:pt>
                        <c:pt idx="1">
                          <c:v>0.30499999999999966</c:v>
                        </c:pt>
                        <c:pt idx="2">
                          <c:v>0.30000000000000021</c:v>
                        </c:pt>
                        <c:pt idx="3">
                          <c:v>0.58999999999999986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K$1277:$AN$1277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K$1279:$AN$1279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41.739999999999995</c:v>
                      </c:pt>
                      <c:pt idx="1">
                        <c:v>9.7850000000000001</c:v>
                      </c:pt>
                      <c:pt idx="2">
                        <c:v>0.69</c:v>
                      </c:pt>
                      <c:pt idx="3">
                        <c:v>6.12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E-366B-467F-BD1F-19B47C5E3ABA}"/>
                  </c:ext>
                </c:extLst>
              </c15:ser>
            </c15:filteredBarSeries>
          </c:ext>
        </c:extLst>
      </c:barChart>
      <c:catAx>
        <c:axId val="-2127458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2127653848"/>
        <c:crosses val="autoZero"/>
        <c:auto val="1"/>
        <c:lblAlgn val="ctr"/>
        <c:lblOffset val="100"/>
        <c:noMultiLvlLbl val="0"/>
      </c:catAx>
      <c:valAx>
        <c:axId val="2127653848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27458344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2200342558761902"/>
          <c:y val="4.8562468095032001E-2"/>
          <c:w val="0.59743099034244995"/>
          <c:h val="0.19291153664522601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ysClr val="windowText" lastClr="000000"/>
                </a:solidFill>
                <a:latin typeface="+mj-lt"/>
                <a:ea typeface="+mn-ea"/>
                <a:cs typeface="+mn-cs"/>
              </a:defRPr>
            </a:pPr>
            <a:r>
              <a:rPr lang="en-US"/>
              <a:t>FVB</a:t>
            </a:r>
          </a:p>
        </c:rich>
      </c:tx>
      <c:layout>
        <c:manualLayout>
          <c:xMode val="edge"/>
          <c:yMode val="edge"/>
          <c:x val="0.25737344912422899"/>
          <c:y val="1.3888888888888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ysClr val="windowText" lastClr="000000"/>
              </a:solidFill>
              <a:latin typeface="+mj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1914260717410295E-2"/>
          <c:y val="0.109213084475552"/>
          <c:w val="0.87753018372703395"/>
          <c:h val="0.74454894527073001"/>
        </c:manualLayout>
      </c:layout>
      <c:lineChart>
        <c:grouping val="standard"/>
        <c:varyColors val="0"/>
        <c:ser>
          <c:idx val="3"/>
          <c:order val="3"/>
          <c:tx>
            <c:strRef>
              <c:f>Dormancy!$AI$540</c:f>
              <c:strCache>
                <c:ptCount val="1"/>
                <c:pt idx="0">
                  <c:v>R-FAC/AIT</c:v>
                </c:pt>
              </c:strCache>
            </c:strRef>
          </c:tx>
          <c:spPr>
            <a:ln w="15875" cap="rnd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Dormancy!$AJ$546:$AP$54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7.16637540205982</c:v>
                  </c:pt>
                  <c:pt idx="2">
                    <c:v>10.682280239308049</c:v>
                  </c:pt>
                  <c:pt idx="3">
                    <c:v>10.20348524334265</c:v>
                  </c:pt>
                  <c:pt idx="4">
                    <c:v>1.899999999999999</c:v>
                  </c:pt>
                  <c:pt idx="5">
                    <c:v>1.333333333333333</c:v>
                  </c:pt>
                  <c:pt idx="6">
                    <c:v>0</c:v>
                  </c:pt>
                </c:numCache>
              </c:numRef>
            </c:plus>
            <c:minus>
              <c:numRef>
                <c:f>Dormancy!$AJ$546:$AP$54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7.16637540205982</c:v>
                  </c:pt>
                  <c:pt idx="2">
                    <c:v>10.682280239308049</c:v>
                  </c:pt>
                  <c:pt idx="3">
                    <c:v>10.20348524334265</c:v>
                  </c:pt>
                  <c:pt idx="4">
                    <c:v>1.899999999999999</c:v>
                  </c:pt>
                  <c:pt idx="5">
                    <c:v>1.333333333333333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ormancy!$AJ$536:$AP$536</c:f>
              <c:numCache>
                <c:formatCode>General</c:formatCode>
                <c:ptCount val="7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  <c:pt idx="4">
                  <c:v>26</c:v>
                </c:pt>
                <c:pt idx="5">
                  <c:v>28</c:v>
                </c:pt>
                <c:pt idx="6">
                  <c:v>49</c:v>
                </c:pt>
              </c:numCache>
            </c:numRef>
          </c:cat>
          <c:val>
            <c:numRef>
              <c:f>Dormancy!$AJ$540:$AP$540</c:f>
              <c:numCache>
                <c:formatCode>General</c:formatCode>
                <c:ptCount val="7"/>
                <c:pt idx="0">
                  <c:v>0</c:v>
                </c:pt>
                <c:pt idx="1">
                  <c:v>47.533333333333331</c:v>
                </c:pt>
                <c:pt idx="2">
                  <c:v>18.666666666666671</c:v>
                </c:pt>
                <c:pt idx="3">
                  <c:v>20.333333333333279</c:v>
                </c:pt>
                <c:pt idx="4">
                  <c:v>9.7000000000000011</c:v>
                </c:pt>
                <c:pt idx="5">
                  <c:v>1.333333333333333</c:v>
                </c:pt>
                <c:pt idx="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B37-42E4-AEBD-5AF9D1913B3A}"/>
            </c:ext>
          </c:extLst>
        </c:ser>
        <c:ser>
          <c:idx val="4"/>
          <c:order val="4"/>
          <c:tx>
            <c:strRef>
              <c:f>Dormancy!$AI$541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ormancy!$AJ$536:$AP$536</c:f>
              <c:numCache>
                <c:formatCode>General</c:formatCode>
                <c:ptCount val="7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  <c:pt idx="4">
                  <c:v>26</c:v>
                </c:pt>
                <c:pt idx="5">
                  <c:v>28</c:v>
                </c:pt>
                <c:pt idx="6">
                  <c:v>49</c:v>
                </c:pt>
              </c:numCache>
              <c:extLst xmlns:c15="http://schemas.microsoft.com/office/drawing/2012/chart"/>
            </c:numRef>
          </c:cat>
          <c:val>
            <c:numRef>
              <c:f>Dormancy!$AJ$541:$AP$541</c:f>
              <c:numCache>
                <c:formatCode>General</c:formatCode>
                <c:ptCount val="7"/>
                <c:pt idx="0">
                  <c:v>0</c:v>
                </c:pt>
                <c:pt idx="1">
                  <c:v>47</c:v>
                </c:pt>
                <c:pt idx="2">
                  <c:v>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  <c:extLst xmlns:c15="http://schemas.microsoft.com/office/drawing/2012/chart"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1-EB37-42E4-AEBD-5AF9D1913B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111536200"/>
        <c:axId val="-2111740136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AI$537</c15:sqref>
                        </c15:formulaRef>
                      </c:ext>
                    </c:extLst>
                    <c:strCache>
                      <c:ptCount val="1"/>
                      <c:pt idx="0">
                        <c:v>MMC</c:v>
                      </c:pt>
                    </c:strCache>
                  </c:strRef>
                </c:tx>
                <c:spPr>
                  <a:ln w="22225" cap="rnd">
                    <a:solidFill>
                      <a:schemeClr val="tx1"/>
                    </a:solidFill>
                    <a:prstDash val="sysDot"/>
                    <a:round/>
                  </a:ln>
                  <a:effectLst/>
                </c:spPr>
                <c:marker>
                  <c:symbol val="none"/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AJ$543:$AP$543</c15:sqref>
                          </c15:formulaRef>
                        </c:ext>
                      </c:extLst>
                      <c:numCache>
                        <c:formatCode>General</c:formatCode>
                        <c:ptCount val="7"/>
                        <c:pt idx="0">
                          <c:v>0</c:v>
                        </c:pt>
                        <c:pt idx="1">
                          <c:v>2.753785273643051</c:v>
                        </c:pt>
                        <c:pt idx="2">
                          <c:v>5.3113086899558022</c:v>
                        </c:pt>
                        <c:pt idx="3">
                          <c:v>5.666666666666667</c:v>
                        </c:pt>
                        <c:pt idx="4">
                          <c:v>1.3333333333333335</c:v>
                        </c:pt>
                        <c:pt idx="5">
                          <c:v>0</c:v>
                        </c:pt>
                        <c:pt idx="6">
                          <c:v>0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AJ$543:$AP$543</c15:sqref>
                          </c15:formulaRef>
                        </c:ext>
                      </c:extLst>
                      <c:numCache>
                        <c:formatCode>General</c:formatCode>
                        <c:ptCount val="7"/>
                        <c:pt idx="0">
                          <c:v>0</c:v>
                        </c:pt>
                        <c:pt idx="1">
                          <c:v>2.753785273643051</c:v>
                        </c:pt>
                        <c:pt idx="2">
                          <c:v>5.3113086899558022</c:v>
                        </c:pt>
                        <c:pt idx="3">
                          <c:v>5.666666666666667</c:v>
                        </c:pt>
                        <c:pt idx="4">
                          <c:v>1.3333333333333335</c:v>
                        </c:pt>
                        <c:pt idx="5">
                          <c:v>0</c:v>
                        </c:pt>
                        <c:pt idx="6">
                          <c:v>0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>
                      <c:ext uri="{02D57815-91ED-43cb-92C2-25804820EDAC}">
                        <c15:formulaRef>
                          <c15:sqref>Dormancy!$AJ$536:$AP$536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7</c:v>
                      </c:pt>
                      <c:pt idx="2">
                        <c:v>14</c:v>
                      </c:pt>
                      <c:pt idx="3">
                        <c:v>21</c:v>
                      </c:pt>
                      <c:pt idx="4">
                        <c:v>26</c:v>
                      </c:pt>
                      <c:pt idx="5">
                        <c:v>28</c:v>
                      </c:pt>
                      <c:pt idx="6">
                        <c:v>49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Dormancy!$AJ$537:$AP$537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8.5</c:v>
                      </c:pt>
                      <c:pt idx="2">
                        <c:v>14.1</c:v>
                      </c:pt>
                      <c:pt idx="3">
                        <c:v>5.666666666666667</c:v>
                      </c:pt>
                      <c:pt idx="4">
                        <c:v>1.3333333333333333</c:v>
                      </c:pt>
                      <c:pt idx="5">
                        <c:v>0</c:v>
                      </c:pt>
                      <c:pt idx="6">
                        <c:v>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2-EB37-42E4-AEBD-5AF9D1913B3A}"/>
                  </c:ext>
                </c:extLst>
              </c15:ser>
            </c15:filteredLineSeries>
            <c15:filteredLine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I$538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spPr>
                  <a:ln w="15875" cap="rnd">
                    <a:solidFill>
                      <a:schemeClr val="tx1"/>
                    </a:solidFill>
                    <a:prstDash val="solid"/>
                    <a:round/>
                  </a:ln>
                  <a:effectLst/>
                </c:spPr>
                <c:marker>
                  <c:symbol val="none"/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J$544:$AP$544</c15:sqref>
                          </c15:formulaRef>
                        </c:ext>
                      </c:extLst>
                      <c:numCache>
                        <c:formatCode>General</c:formatCode>
                        <c:ptCount val="7"/>
                        <c:pt idx="0">
                          <c:v>0</c:v>
                        </c:pt>
                        <c:pt idx="1">
                          <c:v>0.43333333333333357</c:v>
                        </c:pt>
                        <c:pt idx="2">
                          <c:v>26.13186645543032</c:v>
                        </c:pt>
                        <c:pt idx="3">
                          <c:v>30.830522394392066</c:v>
                        </c:pt>
                        <c:pt idx="4">
                          <c:v>35.40872459970533</c:v>
                        </c:pt>
                        <c:pt idx="5">
                          <c:v>41.909956388004566</c:v>
                        </c:pt>
                        <c:pt idx="6">
                          <c:v>0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J$544:$AP$544</c15:sqref>
                          </c15:formulaRef>
                        </c:ext>
                      </c:extLst>
                      <c:numCache>
                        <c:formatCode>General</c:formatCode>
                        <c:ptCount val="7"/>
                        <c:pt idx="0">
                          <c:v>0</c:v>
                        </c:pt>
                        <c:pt idx="1">
                          <c:v>0.43333333333333357</c:v>
                        </c:pt>
                        <c:pt idx="2">
                          <c:v>26.13186645543032</c:v>
                        </c:pt>
                        <c:pt idx="3">
                          <c:v>30.830522394392066</c:v>
                        </c:pt>
                        <c:pt idx="4">
                          <c:v>35.40872459970533</c:v>
                        </c:pt>
                        <c:pt idx="5">
                          <c:v>41.909956388004566</c:v>
                        </c:pt>
                        <c:pt idx="6">
                          <c:v>0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J$536:$AP$536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7</c:v>
                      </c:pt>
                      <c:pt idx="2">
                        <c:v>14</c:v>
                      </c:pt>
                      <c:pt idx="3">
                        <c:v>21</c:v>
                      </c:pt>
                      <c:pt idx="4">
                        <c:v>26</c:v>
                      </c:pt>
                      <c:pt idx="5">
                        <c:v>28</c:v>
                      </c:pt>
                      <c:pt idx="6">
                        <c:v>49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J$538:$AP$538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13.066666666666668</c:v>
                      </c:pt>
                      <c:pt idx="2">
                        <c:v>78.033333333333346</c:v>
                      </c:pt>
                      <c:pt idx="3">
                        <c:v>119.76666666666667</c:v>
                      </c:pt>
                      <c:pt idx="4">
                        <c:v>124.66666666666667</c:v>
                      </c:pt>
                      <c:pt idx="5">
                        <c:v>81.333333333333329</c:v>
                      </c:pt>
                      <c:pt idx="6">
                        <c:v>0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EB37-42E4-AEBD-5AF9D1913B3A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I$539</c15:sqref>
                        </c15:formulaRef>
                      </c:ext>
                    </c:extLst>
                    <c:strCache>
                      <c:ptCount val="1"/>
                      <c:pt idx="0">
                        <c:v>R-FAC</c:v>
                      </c:pt>
                    </c:strCache>
                  </c:strRef>
                </c:tx>
                <c:spPr>
                  <a:ln w="15875" cap="rnd">
                    <a:solidFill>
                      <a:schemeClr val="tx1"/>
                    </a:solidFill>
                    <a:prstDash val="dash"/>
                    <a:round/>
                  </a:ln>
                  <a:effectLst/>
                </c:spPr>
                <c:marker>
                  <c:symbol val="none"/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J$545:$AP$545</c15:sqref>
                          </c15:formulaRef>
                        </c:ext>
                      </c:extLst>
                      <c:numCache>
                        <c:formatCode>General</c:formatCode>
                        <c:ptCount val="7"/>
                        <c:pt idx="0">
                          <c:v>0</c:v>
                        </c:pt>
                        <c:pt idx="1">
                          <c:v>13.046625787706345</c:v>
                        </c:pt>
                        <c:pt idx="2">
                          <c:v>2.3333333333333321</c:v>
                        </c:pt>
                        <c:pt idx="3">
                          <c:v>3.4801021696368504</c:v>
                        </c:pt>
                        <c:pt idx="4">
                          <c:v>0</c:v>
                        </c:pt>
                        <c:pt idx="5">
                          <c:v>0</c:v>
                        </c:pt>
                        <c:pt idx="6">
                          <c:v>0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J$545:$AP$545</c15:sqref>
                          </c15:formulaRef>
                        </c:ext>
                      </c:extLst>
                      <c:numCache>
                        <c:formatCode>General</c:formatCode>
                        <c:ptCount val="7"/>
                        <c:pt idx="0">
                          <c:v>0</c:v>
                        </c:pt>
                        <c:pt idx="1">
                          <c:v>13.046625787706345</c:v>
                        </c:pt>
                        <c:pt idx="2">
                          <c:v>2.3333333333333321</c:v>
                        </c:pt>
                        <c:pt idx="3">
                          <c:v>3.4801021696368504</c:v>
                        </c:pt>
                        <c:pt idx="4">
                          <c:v>0</c:v>
                        </c:pt>
                        <c:pt idx="5">
                          <c:v>0</c:v>
                        </c:pt>
                        <c:pt idx="6">
                          <c:v>0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J$536:$AP$536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7</c:v>
                      </c:pt>
                      <c:pt idx="2">
                        <c:v>14</c:v>
                      </c:pt>
                      <c:pt idx="3">
                        <c:v>21</c:v>
                      </c:pt>
                      <c:pt idx="4">
                        <c:v>26</c:v>
                      </c:pt>
                      <c:pt idx="5">
                        <c:v>28</c:v>
                      </c:pt>
                      <c:pt idx="6">
                        <c:v>49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J$539:$AP$539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55.166666666666664</c:v>
                      </c:pt>
                      <c:pt idx="2">
                        <c:v>18.333333333333332</c:v>
                      </c:pt>
                      <c:pt idx="3">
                        <c:v>6.333333333333333</c:v>
                      </c:pt>
                      <c:pt idx="4">
                        <c:v>0</c:v>
                      </c:pt>
                      <c:pt idx="5">
                        <c:v>0</c:v>
                      </c:pt>
                      <c:pt idx="6">
                        <c:v>0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EB37-42E4-AEBD-5AF9D1913B3A}"/>
                  </c:ext>
                </c:extLst>
              </c15:ser>
            </c15:filteredLineSeries>
          </c:ext>
        </c:extLst>
      </c:lineChart>
      <c:catAx>
        <c:axId val="-2111536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-2111740136"/>
        <c:crosses val="autoZero"/>
        <c:auto val="1"/>
        <c:lblAlgn val="ctr"/>
        <c:lblOffset val="100"/>
        <c:noMultiLvlLbl val="0"/>
      </c:catAx>
      <c:valAx>
        <c:axId val="-2111740136"/>
        <c:scaling>
          <c:orientation val="minMax"/>
          <c:max val="3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-211153620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9781292019705602"/>
          <c:y val="0.129959536307962"/>
          <c:w val="0.68102435112277604"/>
          <c:h val="0.191579785165743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+mj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  <a:latin typeface="+mj-lt"/>
        </a:defRPr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636135170603674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T$1027:$X$1027</c:f>
                <c:numCache>
                  <c:formatCode>General</c:formatCode>
                  <c:ptCount val="2"/>
                  <c:pt idx="0">
                    <c:v>0.56044625076808297</c:v>
                  </c:pt>
                  <c:pt idx="1">
                    <c:v>3.6055528162975401</c:v>
                  </c:pt>
                </c:numCache>
              </c:numRef>
            </c:plus>
            <c:minus>
              <c:numRef>
                <c:f>Dormancy!$T$1027:$X$1027</c:f>
                <c:numCache>
                  <c:formatCode>General</c:formatCode>
                  <c:ptCount val="2"/>
                  <c:pt idx="0">
                    <c:v>0.56044625076808297</c:v>
                  </c:pt>
                  <c:pt idx="1">
                    <c:v>3.6055528162975401</c:v>
                  </c:pt>
                </c:numCache>
              </c:numRef>
            </c:minus>
          </c:errBars>
          <c:cat>
            <c:strRef>
              <c:f>Dormancy!$T$1022:$X$1022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T$1026:$X$1026</c:f>
              <c:numCache>
                <c:formatCode>General</c:formatCode>
                <c:ptCount val="2"/>
                <c:pt idx="0">
                  <c:v>19.809999999999999</c:v>
                </c:pt>
                <c:pt idx="1">
                  <c:v>16.153333333333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B9-43AD-8CCD-1A7CF6EBA0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05750456"/>
        <c:axId val="-2111057768"/>
      </c:barChart>
      <c:catAx>
        <c:axId val="-2105750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11057768"/>
        <c:crosses val="autoZero"/>
        <c:auto val="1"/>
        <c:lblAlgn val="ctr"/>
        <c:lblOffset val="100"/>
        <c:noMultiLvlLbl val="0"/>
      </c:catAx>
      <c:valAx>
        <c:axId val="-2111057768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05750456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636135170603674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K$1027:$O$1027</c:f>
                <c:numCache>
                  <c:formatCode>General</c:formatCode>
                  <c:ptCount val="2"/>
                  <c:pt idx="0">
                    <c:v>1.3373647387472301</c:v>
                  </c:pt>
                  <c:pt idx="1">
                    <c:v>1.571298118683333</c:v>
                  </c:pt>
                </c:numCache>
              </c:numRef>
            </c:plus>
            <c:minus>
              <c:numRef>
                <c:f>Dormancy!$K$1027:$O$1027</c:f>
                <c:numCache>
                  <c:formatCode>General</c:formatCode>
                  <c:ptCount val="2"/>
                  <c:pt idx="0">
                    <c:v>1.3373647387472301</c:v>
                  </c:pt>
                  <c:pt idx="1">
                    <c:v>1.571298118683333</c:v>
                  </c:pt>
                </c:numCache>
              </c:numRef>
            </c:minus>
          </c:errBars>
          <c:cat>
            <c:strRef>
              <c:f>Dormancy!$K$1022:$O$1022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K$1026:$O$1026</c:f>
              <c:numCache>
                <c:formatCode>General</c:formatCode>
                <c:ptCount val="2"/>
                <c:pt idx="0">
                  <c:v>51.256666666666533</c:v>
                </c:pt>
                <c:pt idx="1">
                  <c:v>53.68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C5-47C8-A712-88D92A0AA0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77606136"/>
        <c:axId val="-2009596552"/>
      </c:barChart>
      <c:catAx>
        <c:axId val="-20776061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596552"/>
        <c:crosses val="autoZero"/>
        <c:auto val="1"/>
        <c:lblAlgn val="ctr"/>
        <c:lblOffset val="100"/>
        <c:noMultiLvlLbl val="0"/>
      </c:catAx>
      <c:valAx>
        <c:axId val="-2009596552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77606136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653788344304111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T$1091:$X$1091</c:f>
                <c:numCache>
                  <c:formatCode>General</c:formatCode>
                  <c:ptCount val="2"/>
                  <c:pt idx="0">
                    <c:v>2.1244790211040239</c:v>
                  </c:pt>
                  <c:pt idx="1">
                    <c:v>4.1499892904814786</c:v>
                  </c:pt>
                </c:numCache>
              </c:numRef>
            </c:plus>
            <c:minus>
              <c:numRef>
                <c:f>Dormancy!$T$1091:$X$1091</c:f>
                <c:numCache>
                  <c:formatCode>General</c:formatCode>
                  <c:ptCount val="2"/>
                  <c:pt idx="0">
                    <c:v>2.1244790211040239</c:v>
                  </c:pt>
                  <c:pt idx="1">
                    <c:v>4.1499892904814786</c:v>
                  </c:pt>
                </c:numCache>
              </c:numRef>
            </c:minus>
          </c:errBars>
          <c:cat>
            <c:strRef>
              <c:f>Dormancy!$T$1086:$X$1086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T$1090:$X$1090</c:f>
              <c:numCache>
                <c:formatCode>General</c:formatCode>
                <c:ptCount val="2"/>
                <c:pt idx="0">
                  <c:v>36.523333333333333</c:v>
                </c:pt>
                <c:pt idx="1">
                  <c:v>25.00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FF-40EE-B399-64F4CCC268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9840536"/>
        <c:axId val="-2009565128"/>
      </c:barChart>
      <c:catAx>
        <c:axId val="-2009840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565128"/>
        <c:crosses val="autoZero"/>
        <c:auto val="1"/>
        <c:lblAlgn val="ctr"/>
        <c:lblOffset val="100"/>
        <c:noMultiLvlLbl val="0"/>
      </c:catAx>
      <c:valAx>
        <c:axId val="-2009565128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840536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653789066860295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Dormancy!$K$1091:$O$1091</c:f>
                <c:numCache>
                  <c:formatCode>General</c:formatCode>
                  <c:ptCount val="2"/>
                  <c:pt idx="0">
                    <c:v>0.49095145720665201</c:v>
                  </c:pt>
                  <c:pt idx="1">
                    <c:v>1.347470881977705</c:v>
                  </c:pt>
                </c:numCache>
              </c:numRef>
            </c:plus>
            <c:minus>
              <c:numRef>
                <c:f>Dormancy!$K$1091:$O$1091</c:f>
                <c:numCache>
                  <c:formatCode>General</c:formatCode>
                  <c:ptCount val="2"/>
                  <c:pt idx="0">
                    <c:v>0.49095145720665201</c:v>
                  </c:pt>
                  <c:pt idx="1">
                    <c:v>1.347470881977705</c:v>
                  </c:pt>
                </c:numCache>
              </c:numRef>
            </c:minus>
          </c:errBars>
          <c:cat>
            <c:strRef>
              <c:f>Dormancy!$K$1086:$O$1086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Dormancy!$K$1090:$O$1090</c:f>
              <c:numCache>
                <c:formatCode>General</c:formatCode>
                <c:ptCount val="2"/>
                <c:pt idx="0">
                  <c:v>61.70000000000001</c:v>
                </c:pt>
                <c:pt idx="1">
                  <c:v>63.1266666666665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DA2-4654-B399-CE60A4B0FE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73603064"/>
        <c:axId val="-2073747256"/>
      </c:barChart>
      <c:catAx>
        <c:axId val="-2073603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73747256"/>
        <c:crosses val="autoZero"/>
        <c:auto val="1"/>
        <c:lblAlgn val="ctr"/>
        <c:lblOffset val="100"/>
        <c:noMultiLvlLbl val="0"/>
      </c:catAx>
      <c:valAx>
        <c:axId val="-2073747256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73603064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6.6004423058228803E-2"/>
          <c:w val="0.85756826449325396"/>
          <c:h val="0.78155013609409896"/>
        </c:manualLayout>
      </c:layout>
      <c:barChart>
        <c:barDir val="col"/>
        <c:grouping val="clustered"/>
        <c:varyColors val="0"/>
        <c:ser>
          <c:idx val="3"/>
          <c:order val="3"/>
          <c:tx>
            <c:strRef>
              <c:f>Dormancy!$AR$1067</c:f>
              <c:strCache>
                <c:ptCount val="1"/>
                <c:pt idx="0">
                  <c:v>R-FAC/AIT</c:v>
                </c:pt>
              </c:strCache>
              <c:extLst xmlns:c15="http://schemas.microsoft.com/office/drawing/2012/chart"/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7711-4FFE-B5BE-B0D16805D30C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7711-4FFE-B5BE-B0D16805D30C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7711-4FFE-B5BE-B0D16805D30C}"/>
              </c:ext>
            </c:extLst>
          </c:dPt>
          <c:errBars>
            <c:errBarType val="both"/>
            <c:errValType val="cust"/>
            <c:noEndCap val="0"/>
            <c:plus>
              <c:numRef>
                <c:f>Dormancy!$AS$1053:$AV$1053</c:f>
                <c:numCache>
                  <c:formatCode>General</c:formatCode>
                  <c:ptCount val="4"/>
                  <c:pt idx="0">
                    <c:v>2.4200160697354431</c:v>
                  </c:pt>
                  <c:pt idx="1">
                    <c:v>1.1124197848734001</c:v>
                  </c:pt>
                  <c:pt idx="2">
                    <c:v>1.1448046897955031</c:v>
                  </c:pt>
                  <c:pt idx="3">
                    <c:v>2.6841655024317128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S$1053:$AV$1053</c:f>
                <c:numCache>
                  <c:formatCode>General</c:formatCode>
                  <c:ptCount val="4"/>
                  <c:pt idx="0">
                    <c:v>2.4200160697354431</c:v>
                  </c:pt>
                  <c:pt idx="1">
                    <c:v>1.1124197848734001</c:v>
                  </c:pt>
                  <c:pt idx="2">
                    <c:v>1.1448046897955031</c:v>
                  </c:pt>
                  <c:pt idx="3">
                    <c:v>2.6841655024317128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S$1063:$AV$1063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S$1067:$AV$1067</c:f>
              <c:numCache>
                <c:formatCode>General</c:formatCode>
                <c:ptCount val="4"/>
                <c:pt idx="0">
                  <c:v>13.61333333333333</c:v>
                </c:pt>
                <c:pt idx="1">
                  <c:v>9.7233333333333309</c:v>
                </c:pt>
                <c:pt idx="2">
                  <c:v>33.783333333333331</c:v>
                </c:pt>
                <c:pt idx="3">
                  <c:v>32.713333333333331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3-7711-4FFE-B5BE-B0D16805D30C}"/>
            </c:ext>
          </c:extLst>
        </c:ser>
        <c:ser>
          <c:idx val="4"/>
          <c:order val="4"/>
          <c:tx>
            <c:strRef>
              <c:f>Dormancy!$AR$1068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rgbClr val="FF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AS$1061:$AV$1061</c:f>
                <c:numCache>
                  <c:formatCode>General</c:formatCode>
                  <c:ptCount val="4"/>
                  <c:pt idx="0">
                    <c:v>2.2646044540566739</c:v>
                  </c:pt>
                  <c:pt idx="1">
                    <c:v>1.210569195782619</c:v>
                  </c:pt>
                  <c:pt idx="2">
                    <c:v>0.47209933041445701</c:v>
                  </c:pt>
                  <c:pt idx="3">
                    <c:v>1.7042821884235539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S$1061:$AV$1061</c:f>
                <c:numCache>
                  <c:formatCode>General</c:formatCode>
                  <c:ptCount val="4"/>
                  <c:pt idx="0">
                    <c:v>2.2646044540566739</c:v>
                  </c:pt>
                  <c:pt idx="1">
                    <c:v>1.210569195782619</c:v>
                  </c:pt>
                  <c:pt idx="2">
                    <c:v>0.47209933041445701</c:v>
                  </c:pt>
                  <c:pt idx="3">
                    <c:v>1.7042821884235539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S$1063:$AV$1063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S$1068:$AV$1068</c:f>
              <c:numCache>
                <c:formatCode>General</c:formatCode>
                <c:ptCount val="4"/>
                <c:pt idx="0">
                  <c:v>17.190000000000001</c:v>
                </c:pt>
                <c:pt idx="1">
                  <c:v>9.2833333333333332</c:v>
                </c:pt>
                <c:pt idx="2">
                  <c:v>34.736666666666629</c:v>
                </c:pt>
                <c:pt idx="3">
                  <c:v>24.653333333333311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4-7711-4FFE-B5BE-B0D16805D3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77292280"/>
        <c:axId val="-2009592376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AR$1064</c15:sqref>
                        </c15:formulaRef>
                      </c:ext>
                    </c:extLst>
                    <c:strCache>
                      <c:ptCount val="1"/>
                      <c:pt idx="0">
                        <c:v>Naïve</c:v>
                      </c:pt>
                    </c:strCache>
                  </c:strRef>
                </c:tx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6-7711-4FFE-B5BE-B0D16805D30C}"/>
                    </c:ext>
                  </c:extLst>
                </c:dPt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8-7711-4FFE-B5BE-B0D16805D30C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A-7711-4FFE-B5BE-B0D16805D30C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C-7711-4FFE-B5BE-B0D16805D30C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AS$1027:$AV$1027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89448309095253431</c:v>
                        </c:pt>
                        <c:pt idx="1">
                          <c:v>1.6667433315700804</c:v>
                        </c:pt>
                        <c:pt idx="2">
                          <c:v>2.2170275395472903</c:v>
                        </c:pt>
                        <c:pt idx="3">
                          <c:v>0.58660037504249818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AS$1027:$AV$1027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89448309095253431</c:v>
                        </c:pt>
                        <c:pt idx="1">
                          <c:v>1.6667433315700804</c:v>
                        </c:pt>
                        <c:pt idx="2">
                          <c:v>2.2170275395472903</c:v>
                        </c:pt>
                        <c:pt idx="3">
                          <c:v>0.58660037504249818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Dormancy!$AS$1063:$AV$1063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Dormancy!$AS$1064:$AV$1064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3.58</c:v>
                      </c:pt>
                      <c:pt idx="1">
                        <c:v>6.28</c:v>
                      </c:pt>
                      <c:pt idx="2">
                        <c:v>36.553333333333335</c:v>
                      </c:pt>
                      <c:pt idx="3">
                        <c:v>41.53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D-7711-4FFE-B5BE-B0D16805D30C}"/>
                  </c:ext>
                </c:extLst>
              </c15:ser>
            </c15:filteredBarSeries>
            <c15:filteredBa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R$1065</c15:sqref>
                        </c15:formulaRef>
                      </c:ext>
                    </c:extLst>
                    <c:strCache>
                      <c:ptCount val="1"/>
                      <c:pt idx="0">
                        <c:v>MMC</c:v>
                      </c:pt>
                    </c:strCache>
                  </c:strRef>
                </c:tx>
                <c:spPr>
                  <a:solidFill>
                    <a:srgbClr val="0070C0"/>
                  </a:solidFill>
                </c:spPr>
                <c:invertIfNegative val="0"/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F-7711-4FFE-B5BE-B0D16805D30C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1-7711-4FFE-B5BE-B0D16805D30C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3-7711-4FFE-B5BE-B0D16805D30C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S$1037:$AV$1037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3028345166512034</c:v>
                        </c:pt>
                        <c:pt idx="1">
                          <c:v>0.5571455026392218</c:v>
                        </c:pt>
                        <c:pt idx="2">
                          <c:v>0.77889522901207819</c:v>
                        </c:pt>
                        <c:pt idx="3">
                          <c:v>1.6280151514446459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S$1037:$AV$1037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3028345166512034</c:v>
                        </c:pt>
                        <c:pt idx="1">
                          <c:v>0.5571455026392218</c:v>
                        </c:pt>
                        <c:pt idx="2">
                          <c:v>0.77889522901207819</c:v>
                        </c:pt>
                        <c:pt idx="3">
                          <c:v>1.6280151514446459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S$1063:$AV$1063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S$1065:$AV$1065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6.653333333333332</c:v>
                      </c:pt>
                      <c:pt idx="1">
                        <c:v>10.943333333333333</c:v>
                      </c:pt>
                      <c:pt idx="2">
                        <c:v>28.633333333333336</c:v>
                      </c:pt>
                      <c:pt idx="3">
                        <c:v>29.790000000000003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4-7711-4FFE-B5BE-B0D16805D30C}"/>
                  </c:ext>
                </c:extLst>
              </c15:ser>
            </c15:filteredBarSeries>
            <c15:filteredBa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R$1066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spPr>
                  <a:solidFill>
                    <a:srgbClr val="0070C0"/>
                  </a:solidFill>
                </c:spPr>
                <c:invertIfNegative val="0"/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6-7711-4FFE-B5BE-B0D16805D30C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8-7711-4FFE-B5BE-B0D16805D30C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A-7711-4FFE-B5BE-B0D16805D30C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S$1045:$AV$104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4141782065920852</c:v>
                        </c:pt>
                        <c:pt idx="1">
                          <c:v>1.0560986906745207</c:v>
                        </c:pt>
                        <c:pt idx="2">
                          <c:v>0.5990084399331197</c:v>
                        </c:pt>
                        <c:pt idx="3">
                          <c:v>1.2770582515209619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S$1045:$AV$104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4141782065920852</c:v>
                        </c:pt>
                        <c:pt idx="1">
                          <c:v>1.0560986906745207</c:v>
                        </c:pt>
                        <c:pt idx="2">
                          <c:v>0.5990084399331197</c:v>
                        </c:pt>
                        <c:pt idx="3">
                          <c:v>1.2770582515209619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S$1063:$AV$1063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S$1066:$AV$106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4.65</c:v>
                      </c:pt>
                      <c:pt idx="1">
                        <c:v>9.3933333333333326</c:v>
                      </c:pt>
                      <c:pt idx="2">
                        <c:v>32.233333333333334</c:v>
                      </c:pt>
                      <c:pt idx="3">
                        <c:v>29.293333333333333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7711-4FFE-B5BE-B0D16805D30C}"/>
                  </c:ext>
                </c:extLst>
              </c15:ser>
            </c15:filteredBarSeries>
          </c:ext>
        </c:extLst>
      </c:barChart>
      <c:catAx>
        <c:axId val="-20772922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592376"/>
        <c:crosses val="autoZero"/>
        <c:auto val="1"/>
        <c:lblAlgn val="ctr"/>
        <c:lblOffset val="100"/>
        <c:noMultiLvlLbl val="0"/>
      </c:catAx>
      <c:valAx>
        <c:axId val="-2009592376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77292280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2050294232029802"/>
          <c:y val="4.6611206263763097E-2"/>
          <c:w val="0.62565524368400804"/>
          <c:h val="0.23177147051627101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8.4488080537239496E-2"/>
          <c:w val="0.85756826449325396"/>
          <c:h val="0.78621439681150895"/>
        </c:manualLayout>
      </c:layout>
      <c:barChart>
        <c:barDir val="col"/>
        <c:grouping val="clustered"/>
        <c:varyColors val="0"/>
        <c:ser>
          <c:idx val="3"/>
          <c:order val="3"/>
          <c:tx>
            <c:strRef>
              <c:f>Dormancy!$AJ$1067</c:f>
              <c:strCache>
                <c:ptCount val="1"/>
                <c:pt idx="0">
                  <c:v>R-FAC/AIT</c:v>
                </c:pt>
              </c:strCache>
              <c:extLst xmlns:c15="http://schemas.microsoft.com/office/drawing/2012/chart"/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17A-405E-83B7-50D7BE29E03D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217A-405E-83B7-50D7BE29E03D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217A-405E-83B7-50D7BE29E03D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217A-405E-83B7-50D7BE29E03D}"/>
              </c:ext>
            </c:extLst>
          </c:dPt>
          <c:errBars>
            <c:errBarType val="both"/>
            <c:errValType val="cust"/>
            <c:noEndCap val="0"/>
            <c:plus>
              <c:numRef>
                <c:f>Dormancy!$AK$1053:$AN$1053</c:f>
                <c:numCache>
                  <c:formatCode>General</c:formatCode>
                  <c:ptCount val="4"/>
                  <c:pt idx="0">
                    <c:v>1.2510306861855101</c:v>
                  </c:pt>
                  <c:pt idx="1">
                    <c:v>2.1848747739350598</c:v>
                  </c:pt>
                  <c:pt idx="2">
                    <c:v>3.4872402332567281</c:v>
                  </c:pt>
                  <c:pt idx="3">
                    <c:v>0.81002057587034904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K$1053:$AN$1053</c:f>
                <c:numCache>
                  <c:formatCode>General</c:formatCode>
                  <c:ptCount val="4"/>
                  <c:pt idx="0">
                    <c:v>1.2510306861855101</c:v>
                  </c:pt>
                  <c:pt idx="1">
                    <c:v>2.1848747739350598</c:v>
                  </c:pt>
                  <c:pt idx="2">
                    <c:v>3.4872402332567281</c:v>
                  </c:pt>
                  <c:pt idx="3">
                    <c:v>0.81002057587034904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K$1063:$AN$1063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K$1067:$AN$1067</c:f>
              <c:numCache>
                <c:formatCode>General</c:formatCode>
                <c:ptCount val="4"/>
                <c:pt idx="0">
                  <c:v>15.286666666666671</c:v>
                </c:pt>
                <c:pt idx="1">
                  <c:v>17.2433333333333</c:v>
                </c:pt>
                <c:pt idx="2">
                  <c:v>51.173333333333339</c:v>
                </c:pt>
                <c:pt idx="3">
                  <c:v>5.8199999999999976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4-217A-405E-83B7-50D7BE29E03D}"/>
            </c:ext>
          </c:extLst>
        </c:ser>
        <c:ser>
          <c:idx val="4"/>
          <c:order val="4"/>
          <c:tx>
            <c:strRef>
              <c:f>Dormancy!$AJ$1068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rgbClr val="FF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AK$1061:$AN$1061</c:f>
                <c:numCache>
                  <c:formatCode>General</c:formatCode>
                  <c:ptCount val="4"/>
                  <c:pt idx="0">
                    <c:v>0.34167886157098498</c:v>
                  </c:pt>
                  <c:pt idx="1">
                    <c:v>2.1536093734318031</c:v>
                  </c:pt>
                  <c:pt idx="2">
                    <c:v>3.4033774074847281</c:v>
                  </c:pt>
                  <c:pt idx="3">
                    <c:v>4.8074017006186603E-2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K$1061:$AN$1061</c:f>
                <c:numCache>
                  <c:formatCode>General</c:formatCode>
                  <c:ptCount val="4"/>
                  <c:pt idx="0">
                    <c:v>0.34167886157098498</c:v>
                  </c:pt>
                  <c:pt idx="1">
                    <c:v>2.1536093734318031</c:v>
                  </c:pt>
                  <c:pt idx="2">
                    <c:v>3.4033774074847281</c:v>
                  </c:pt>
                  <c:pt idx="3">
                    <c:v>4.8074017006186603E-2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K$1063:$AN$1063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K$1068:$AN$1068</c:f>
              <c:numCache>
                <c:formatCode>General</c:formatCode>
                <c:ptCount val="4"/>
                <c:pt idx="0">
                  <c:v>17.743333333333311</c:v>
                </c:pt>
                <c:pt idx="1">
                  <c:v>20.45</c:v>
                </c:pt>
                <c:pt idx="2">
                  <c:v>46.566666666666627</c:v>
                </c:pt>
                <c:pt idx="3">
                  <c:v>3.8833333333333342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5-217A-405E-83B7-50D7BE29E0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11215160"/>
        <c:axId val="-2130781464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AJ$1064</c15:sqref>
                        </c15:formulaRef>
                      </c:ext>
                    </c:extLst>
                    <c:strCache>
                      <c:ptCount val="1"/>
                      <c:pt idx="0">
                        <c:v>Naïve</c:v>
                      </c:pt>
                    </c:strCache>
                  </c:strRef>
                </c:tx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7-217A-405E-83B7-50D7BE29E03D}"/>
                    </c:ext>
                  </c:extLst>
                </c:dPt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9-217A-405E-83B7-50D7BE29E03D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B-217A-405E-83B7-50D7BE29E03D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D-217A-405E-83B7-50D7BE29E03D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AK$1028:$AN$1028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4.9858343779596668</c:v>
                        </c:pt>
                        <c:pt idx="1">
                          <c:v>3.4179721083316803</c:v>
                        </c:pt>
                        <c:pt idx="2">
                          <c:v>7.2225349504942553</c:v>
                        </c:pt>
                        <c:pt idx="3">
                          <c:v>0.62656027465661968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AK$1028:$AN$1028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4.9858343779596668</c:v>
                        </c:pt>
                        <c:pt idx="1">
                          <c:v>3.4179721083316803</c:v>
                        </c:pt>
                        <c:pt idx="2">
                          <c:v>7.2225349504942553</c:v>
                        </c:pt>
                        <c:pt idx="3">
                          <c:v>0.62656027465661968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Dormancy!$AK$1063:$AN$1063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Dormancy!$AK$1064:$AN$1064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33.813333333333333</c:v>
                      </c:pt>
                      <c:pt idx="1">
                        <c:v>15.71</c:v>
                      </c:pt>
                      <c:pt idx="2">
                        <c:v>41.756666666666668</c:v>
                      </c:pt>
                      <c:pt idx="3">
                        <c:v>8.0533333333333328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E-217A-405E-83B7-50D7BE29E03D}"/>
                  </c:ext>
                </c:extLst>
              </c15:ser>
            </c15:filteredBarSeries>
            <c15:filteredBa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J$1065</c15:sqref>
                        </c15:formulaRef>
                      </c:ext>
                    </c:extLst>
                    <c:strCache>
                      <c:ptCount val="1"/>
                      <c:pt idx="0">
                        <c:v>MMC</c:v>
                      </c:pt>
                    </c:strCache>
                  </c:strRef>
                </c:tx>
                <c:spPr>
                  <a:solidFill>
                    <a:srgbClr val="FF0000"/>
                  </a:solidFill>
                </c:spPr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0-217A-405E-83B7-50D7BE29E03D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2-217A-405E-83B7-50D7BE29E03D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4-217A-405E-83B7-50D7BE29E03D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K$1037:$AN$1037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8067189414331608</c:v>
                        </c:pt>
                        <c:pt idx="1">
                          <c:v>2.6557547577540452</c:v>
                        </c:pt>
                        <c:pt idx="2">
                          <c:v>1.93989976831565</c:v>
                        </c:pt>
                        <c:pt idx="3">
                          <c:v>0.45346811721810576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K$1037:$AN$1037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8067189414331608</c:v>
                        </c:pt>
                        <c:pt idx="1">
                          <c:v>2.6557547577540452</c:v>
                        </c:pt>
                        <c:pt idx="2">
                          <c:v>1.93989976831565</c:v>
                        </c:pt>
                        <c:pt idx="3">
                          <c:v>0.45346811721810576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K$1063:$AN$1063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K$1065:$AN$1065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9.029999999999998</c:v>
                      </c:pt>
                      <c:pt idx="1">
                        <c:v>23.51</c:v>
                      </c:pt>
                      <c:pt idx="2">
                        <c:v>42.266666666666666</c:v>
                      </c:pt>
                      <c:pt idx="3">
                        <c:v>3.08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5-217A-405E-83B7-50D7BE29E03D}"/>
                  </c:ext>
                </c:extLst>
              </c15:ser>
            </c15:filteredBarSeries>
            <c15:filteredBa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J$1066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7-217A-405E-83B7-50D7BE29E03D}"/>
                    </c:ext>
                  </c:extLst>
                </c:dPt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9-217A-405E-83B7-50D7BE29E03D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B-217A-405E-83B7-50D7BE29E03D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D-217A-405E-83B7-50D7BE29E03D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K$1045:$AN$104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0156169444124987</c:v>
                        </c:pt>
                        <c:pt idx="1">
                          <c:v>2.5788649527349103</c:v>
                        </c:pt>
                        <c:pt idx="2">
                          <c:v>3.9217187275195795</c:v>
                        </c:pt>
                        <c:pt idx="3">
                          <c:v>0.24126978905596758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K$1045:$AN$104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0156169444124987</c:v>
                        </c:pt>
                        <c:pt idx="1">
                          <c:v>2.5788649527349103</c:v>
                        </c:pt>
                        <c:pt idx="2">
                          <c:v>3.9217187275195795</c:v>
                        </c:pt>
                        <c:pt idx="3">
                          <c:v>0.24126978905596758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K$1063:$AN$1063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K$1066:$AN$106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1.933333333333332</c:v>
                      </c:pt>
                      <c:pt idx="1">
                        <c:v>14.453333333333333</c:v>
                      </c:pt>
                      <c:pt idx="2">
                        <c:v>60.436666666666667</c:v>
                      </c:pt>
                      <c:pt idx="3">
                        <c:v>3.5966666666666662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E-217A-405E-83B7-50D7BE29E03D}"/>
                  </c:ext>
                </c:extLst>
              </c15:ser>
            </c15:filteredBarSeries>
          </c:ext>
        </c:extLst>
      </c:barChart>
      <c:catAx>
        <c:axId val="-2111215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30781464"/>
        <c:crosses val="autoZero"/>
        <c:auto val="1"/>
        <c:lblAlgn val="ctr"/>
        <c:lblOffset val="100"/>
        <c:noMultiLvlLbl val="0"/>
      </c:catAx>
      <c:valAx>
        <c:axId val="-2130781464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11215160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1185930940013601"/>
          <c:y val="4.6650842929305603E-2"/>
          <c:w val="0.62741187288159195"/>
          <c:h val="0.231968561494933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734020487022456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AQ$1610:$AS$1610</c:f>
                <c:numCache>
                  <c:formatCode>General</c:formatCode>
                  <c:ptCount val="3"/>
                  <c:pt idx="0">
                    <c:v>3.7999999999999972</c:v>
                  </c:pt>
                  <c:pt idx="1">
                    <c:v>4.816047249675889</c:v>
                  </c:pt>
                  <c:pt idx="2">
                    <c:v>1.698060985686652</c:v>
                  </c:pt>
                </c:numCache>
              </c:numRef>
            </c:plus>
            <c:minus>
              <c:numRef>
                <c:f>Dormancy!$AQ$1610:$AS$1610</c:f>
                <c:numCache>
                  <c:formatCode>General</c:formatCode>
                  <c:ptCount val="3"/>
                  <c:pt idx="0">
                    <c:v>3.7999999999999972</c:v>
                  </c:pt>
                  <c:pt idx="1">
                    <c:v>4.816047249675889</c:v>
                  </c:pt>
                  <c:pt idx="2">
                    <c:v>1.698060985686652</c:v>
                  </c:pt>
                </c:numCache>
              </c:numRef>
            </c:minus>
          </c:errBars>
          <c:cat>
            <c:strRef>
              <c:f>Dormancy!$AQ$1605:$AS$1605</c:f>
              <c:strCache>
                <c:ptCount val="3"/>
                <c:pt idx="0">
                  <c:v>Ctrl</c:v>
                </c:pt>
                <c:pt idx="1">
                  <c:v>FAC</c:v>
                </c:pt>
                <c:pt idx="2">
                  <c:v>FAC/AIT</c:v>
                </c:pt>
              </c:strCache>
            </c:strRef>
          </c:cat>
          <c:val>
            <c:numRef>
              <c:f>Dormancy!$AQ$1609:$AS$1609</c:f>
              <c:numCache>
                <c:formatCode>General</c:formatCode>
                <c:ptCount val="3"/>
                <c:pt idx="0">
                  <c:v>54.22</c:v>
                </c:pt>
                <c:pt idx="1">
                  <c:v>62.496666666666592</c:v>
                </c:pt>
                <c:pt idx="2">
                  <c:v>81.2466666666666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21-4C98-AE16-21343550D3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24013160"/>
        <c:axId val="-2059998120"/>
      </c:barChart>
      <c:catAx>
        <c:axId val="-2124013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59998120"/>
        <c:crosses val="autoZero"/>
        <c:auto val="1"/>
        <c:lblAlgn val="ctr"/>
        <c:lblOffset val="100"/>
        <c:noMultiLvlLbl val="0"/>
      </c:catAx>
      <c:valAx>
        <c:axId val="-2059998120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24013160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4.3786330539068698E-2"/>
          <c:w val="0.85756826449325396"/>
          <c:h val="0.75949900922060298"/>
        </c:manualLayout>
      </c:layout>
      <c:barChart>
        <c:barDir val="col"/>
        <c:grouping val="clustered"/>
        <c:varyColors val="0"/>
        <c:ser>
          <c:idx val="3"/>
          <c:order val="3"/>
          <c:tx>
            <c:strRef>
              <c:f>Dormancy!$AC$1125</c:f>
              <c:strCache>
                <c:ptCount val="1"/>
                <c:pt idx="0">
                  <c:v>R-FAC/AIT</c:v>
                </c:pt>
              </c:strCache>
              <c:extLst xmlns:c15="http://schemas.microsoft.com/office/drawing/2012/chart"/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DF70-4F2C-9C7B-AD60BBDDDC40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DF70-4F2C-9C7B-AD60BBDDDC40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DF70-4F2C-9C7B-AD60BBDDDC40}"/>
              </c:ext>
            </c:extLst>
          </c:dPt>
          <c:errBars>
            <c:errBarType val="both"/>
            <c:errValType val="cust"/>
            <c:noEndCap val="0"/>
            <c:plus>
              <c:numRef>
                <c:f>Dormancy!$AD$1118:$AG$1118</c:f>
                <c:numCache>
                  <c:formatCode>General</c:formatCode>
                  <c:ptCount val="4"/>
                  <c:pt idx="0">
                    <c:v>2.3555207020482301</c:v>
                  </c:pt>
                  <c:pt idx="1">
                    <c:v>1.51569932521079</c:v>
                  </c:pt>
                  <c:pt idx="2">
                    <c:v>6.4042668068509867</c:v>
                  </c:pt>
                  <c:pt idx="3">
                    <c:v>0.66775744099187195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D$1118:$AG$1118</c:f>
                <c:numCache>
                  <c:formatCode>General</c:formatCode>
                  <c:ptCount val="4"/>
                  <c:pt idx="0">
                    <c:v>2.3555207020482301</c:v>
                  </c:pt>
                  <c:pt idx="1">
                    <c:v>1.51569932521079</c:v>
                  </c:pt>
                  <c:pt idx="2">
                    <c:v>6.4042668068509867</c:v>
                  </c:pt>
                  <c:pt idx="3">
                    <c:v>0.66775744099187195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D$1121:$AG$1121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D$1125:$AG$1125</c:f>
              <c:numCache>
                <c:formatCode>General</c:formatCode>
                <c:ptCount val="4"/>
                <c:pt idx="0">
                  <c:v>23.1733333333333</c:v>
                </c:pt>
                <c:pt idx="1">
                  <c:v>27.286666666666662</c:v>
                </c:pt>
                <c:pt idx="2">
                  <c:v>19.989999999999981</c:v>
                </c:pt>
                <c:pt idx="3">
                  <c:v>8.4800000000000022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3-DF70-4F2C-9C7B-AD60BBDDDC40}"/>
            </c:ext>
          </c:extLst>
        </c:ser>
        <c:ser>
          <c:idx val="4"/>
          <c:order val="4"/>
          <c:tx>
            <c:strRef>
              <c:f>Dormancy!$AC$1126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rgbClr val="FF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AI$1118:$AL$1118</c:f>
                <c:numCache>
                  <c:formatCode>General</c:formatCode>
                  <c:ptCount val="4"/>
                  <c:pt idx="0">
                    <c:v>2.0913658482224249</c:v>
                  </c:pt>
                  <c:pt idx="1">
                    <c:v>4.9120475477249874</c:v>
                  </c:pt>
                  <c:pt idx="2">
                    <c:v>12.594720234200439</c:v>
                  </c:pt>
                  <c:pt idx="3">
                    <c:v>1.115840490392783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I$1118:$AL$1118</c:f>
                <c:numCache>
                  <c:formatCode>General</c:formatCode>
                  <c:ptCount val="4"/>
                  <c:pt idx="0">
                    <c:v>2.0913658482224249</c:v>
                  </c:pt>
                  <c:pt idx="1">
                    <c:v>4.9120475477249874</c:v>
                  </c:pt>
                  <c:pt idx="2">
                    <c:v>12.594720234200439</c:v>
                  </c:pt>
                  <c:pt idx="3">
                    <c:v>1.115840490392783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D$1121:$AG$1121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D$1126:$AG$1126</c:f>
              <c:numCache>
                <c:formatCode>General</c:formatCode>
                <c:ptCount val="4"/>
                <c:pt idx="0">
                  <c:v>13.17333333333333</c:v>
                </c:pt>
                <c:pt idx="1">
                  <c:v>25.183333333333309</c:v>
                </c:pt>
                <c:pt idx="2">
                  <c:v>42.943333333333328</c:v>
                </c:pt>
                <c:pt idx="3">
                  <c:v>6.49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4-DF70-4F2C-9C7B-AD60BBDDDC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83429464"/>
        <c:axId val="-2009275560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AC$1122</c15:sqref>
                        </c15:formulaRef>
                      </c:ext>
                    </c:extLst>
                    <c:strCache>
                      <c:ptCount val="1"/>
                      <c:pt idx="0">
                        <c:v>Naïve</c:v>
                      </c:pt>
                    </c:strCache>
                  </c:strRef>
                </c:tx>
                <c:spPr>
                  <a:solidFill>
                    <a:srgbClr val="0070C0"/>
                  </a:solidFill>
                </c:spPr>
                <c:invertIfNegative val="0"/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6-DF70-4F2C-9C7B-AD60BBDDDC40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8-DF70-4F2C-9C7B-AD60BBDDDC40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A-DF70-4F2C-9C7B-AD60BBDDDC40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AD$1092:$AG$1092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41525092815469222</c:v>
                        </c:pt>
                        <c:pt idx="1">
                          <c:v>0.3625986455818303</c:v>
                        </c:pt>
                        <c:pt idx="2">
                          <c:v>1.3751282768446638</c:v>
                        </c:pt>
                        <c:pt idx="3">
                          <c:v>0.73111786555475011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AD$1092:$AG$1092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41525092815469222</c:v>
                        </c:pt>
                        <c:pt idx="1">
                          <c:v>0.3625986455818303</c:v>
                        </c:pt>
                        <c:pt idx="2">
                          <c:v>1.3751282768446638</c:v>
                        </c:pt>
                        <c:pt idx="3">
                          <c:v>0.73111786555475011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Dormancy!$AD$1121:$AG$1121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Dormancy!$AD$1122:$AG$1122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3.090000000000002</c:v>
                      </c:pt>
                      <c:pt idx="1">
                        <c:v>6.8033333333333337</c:v>
                      </c:pt>
                      <c:pt idx="2">
                        <c:v>68.273333333333326</c:v>
                      </c:pt>
                      <c:pt idx="3">
                        <c:v>10.610000000000001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B-DF70-4F2C-9C7B-AD60BBDDDC40}"/>
                  </c:ext>
                </c:extLst>
              </c15:ser>
            </c15:filteredBarSeries>
            <c15:filteredBa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C$1123</c15:sqref>
                        </c15:formulaRef>
                      </c:ext>
                    </c:extLst>
                    <c:strCache>
                      <c:ptCount val="1"/>
                      <c:pt idx="0">
                        <c:v>MMC</c:v>
                      </c:pt>
                    </c:strCache>
                  </c:strRef>
                </c:tx>
                <c:spPr>
                  <a:solidFill>
                    <a:srgbClr val="0070C0"/>
                  </a:solidFill>
                </c:spPr>
                <c:invertIfNegative val="0"/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D-DF70-4F2C-9C7B-AD60BBDDDC40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F-DF70-4F2C-9C7B-AD60BBDDDC40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1-DF70-4F2C-9C7B-AD60BBDDDC40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D$1100:$AG$1100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110015014913462</c:v>
                        </c:pt>
                        <c:pt idx="1">
                          <c:v>5.6682340969456941</c:v>
                        </c:pt>
                        <c:pt idx="2">
                          <c:v>7.4832167771175486</c:v>
                        </c:pt>
                        <c:pt idx="3">
                          <c:v>0.61170072566392841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D$1100:$AG$1100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110015014913462</c:v>
                        </c:pt>
                        <c:pt idx="1">
                          <c:v>5.6682340969456941</c:v>
                        </c:pt>
                        <c:pt idx="2">
                          <c:v>7.4832167771175486</c:v>
                        </c:pt>
                        <c:pt idx="3">
                          <c:v>0.61170072566392841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D$1121:$AG$1121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D$1123:$AG$1123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5.88</c:v>
                      </c:pt>
                      <c:pt idx="1">
                        <c:v>12.883333333333333</c:v>
                      </c:pt>
                      <c:pt idx="2">
                        <c:v>48.93</c:v>
                      </c:pt>
                      <c:pt idx="3">
                        <c:v>4.873333333333334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2-DF70-4F2C-9C7B-AD60BBDDDC40}"/>
                  </c:ext>
                </c:extLst>
              </c15:ser>
            </c15:filteredBarSeries>
            <c15:filteredBa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C$1124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spPr>
                  <a:solidFill>
                    <a:srgbClr val="0070C0"/>
                  </a:solidFill>
                </c:spPr>
                <c:invertIfNegative val="0"/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4-DF70-4F2C-9C7B-AD60BBDDDC40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6-DF70-4F2C-9C7B-AD60BBDDDC40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8-DF70-4F2C-9C7B-AD60BBDDDC40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D$1109:$AG$1109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86689740518189995</c:v>
                        </c:pt>
                        <c:pt idx="1">
                          <c:v>2.0150213674080759</c:v>
                        </c:pt>
                        <c:pt idx="2">
                          <c:v>3.0470386352070578</c:v>
                        </c:pt>
                        <c:pt idx="3">
                          <c:v>0.86699352810605168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D$1109:$AG$1109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86689740518189995</c:v>
                        </c:pt>
                        <c:pt idx="1">
                          <c:v>2.0150213674080759</c:v>
                        </c:pt>
                        <c:pt idx="2">
                          <c:v>3.0470386352070578</c:v>
                        </c:pt>
                        <c:pt idx="3">
                          <c:v>0.86699352810605168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D$1121:$AG$1121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D$1124:$AG$1124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6.723333333333333</c:v>
                      </c:pt>
                      <c:pt idx="1">
                        <c:v>36.99666666666667</c:v>
                      </c:pt>
                      <c:pt idx="2">
                        <c:v>32.953333333333333</c:v>
                      </c:pt>
                      <c:pt idx="3">
                        <c:v>5.0966666666666667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9-DF70-4F2C-9C7B-AD60BBDDDC40}"/>
                  </c:ext>
                </c:extLst>
              </c15:ser>
            </c15:filteredBarSeries>
          </c:ext>
        </c:extLst>
      </c:barChart>
      <c:catAx>
        <c:axId val="-20834294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275560"/>
        <c:crosses val="autoZero"/>
        <c:auto val="1"/>
        <c:lblAlgn val="ctr"/>
        <c:lblOffset val="100"/>
        <c:noMultiLvlLbl val="0"/>
      </c:catAx>
      <c:valAx>
        <c:axId val="-2009275560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83429464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201284559771118"/>
          <c:y val="5.5952477108681502E-2"/>
          <c:w val="0.77820211998348798"/>
          <c:h val="0.20361708533119899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5.8334965019166102E-2"/>
          <c:w val="0.85756826449325396"/>
          <c:h val="0.78150346042910801"/>
        </c:manualLayout>
      </c:layout>
      <c:barChart>
        <c:barDir val="col"/>
        <c:grouping val="clustered"/>
        <c:varyColors val="0"/>
        <c:ser>
          <c:idx val="3"/>
          <c:order val="3"/>
          <c:tx>
            <c:strRef>
              <c:f>Dormancy!$AL$1124</c:f>
              <c:strCache>
                <c:ptCount val="1"/>
                <c:pt idx="0">
                  <c:v>R-FAC/AIT</c:v>
                </c:pt>
              </c:strCache>
              <c:extLst xmlns:c15="http://schemas.microsoft.com/office/drawing/2012/chart"/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C633-46D3-A0B0-2E60EDBC170E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C633-46D3-A0B0-2E60EDBC170E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C633-46D3-A0B0-2E60EDBC170E}"/>
              </c:ext>
            </c:extLst>
          </c:dPt>
          <c:errBars>
            <c:errBarType val="both"/>
            <c:errValType val="cust"/>
            <c:noEndCap val="0"/>
            <c:plus>
              <c:numRef>
                <c:f>Dormancy!$AM$1118:$AP$1118</c:f>
                <c:numCache>
                  <c:formatCode>General</c:formatCode>
                  <c:ptCount val="4"/>
                  <c:pt idx="0">
                    <c:v>2.511150687987044</c:v>
                  </c:pt>
                  <c:pt idx="1">
                    <c:v>1.7704079881328041</c:v>
                  </c:pt>
                  <c:pt idx="2">
                    <c:v>2.4571008209767151</c:v>
                  </c:pt>
                  <c:pt idx="3">
                    <c:v>1.397096194890594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M$1118:$AP$1118</c:f>
                <c:numCache>
                  <c:formatCode>General</c:formatCode>
                  <c:ptCount val="4"/>
                  <c:pt idx="0">
                    <c:v>2.511150687987044</c:v>
                  </c:pt>
                  <c:pt idx="1">
                    <c:v>1.7704079881328041</c:v>
                  </c:pt>
                  <c:pt idx="2">
                    <c:v>2.4571008209767151</c:v>
                  </c:pt>
                  <c:pt idx="3">
                    <c:v>1.397096194890594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M$1120:$AP$1120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M$1124:$AP$1124</c:f>
              <c:numCache>
                <c:formatCode>General</c:formatCode>
                <c:ptCount val="4"/>
                <c:pt idx="0">
                  <c:v>16.063333333333301</c:v>
                </c:pt>
                <c:pt idx="1">
                  <c:v>26.326666666666661</c:v>
                </c:pt>
                <c:pt idx="2">
                  <c:v>7.4133333333333331</c:v>
                </c:pt>
                <c:pt idx="3">
                  <c:v>21.456666666666671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3-C633-46D3-A0B0-2E60EDBC170E}"/>
            </c:ext>
          </c:extLst>
        </c:ser>
        <c:ser>
          <c:idx val="4"/>
          <c:order val="4"/>
          <c:tx>
            <c:strRef>
              <c:f>Dormancy!$AL$1125</c:f>
              <c:strCache>
                <c:ptCount val="1"/>
                <c:pt idx="0">
                  <c:v>R-FAC/AIT L</c:v>
                </c:pt>
              </c:strCache>
              <c:extLst xmlns:c15="http://schemas.microsoft.com/office/drawing/2012/chart"/>
            </c:strRef>
          </c:tx>
          <c:spPr>
            <a:pattFill prst="wdUpDiag">
              <a:fgClr>
                <a:srgbClr val="FF0000"/>
              </a:fgClr>
              <a:bgClr>
                <a:schemeClr val="bg1"/>
              </a:bgClr>
            </a:pattFill>
            <a:ln>
              <a:solidFill>
                <a:srgbClr val="FF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AR$1118:$AU$1118</c:f>
                <c:numCache>
                  <c:formatCode>General</c:formatCode>
                  <c:ptCount val="4"/>
                  <c:pt idx="0">
                    <c:v>1.374546389823851</c:v>
                  </c:pt>
                  <c:pt idx="1">
                    <c:v>7.4699895879743003</c:v>
                  </c:pt>
                  <c:pt idx="2">
                    <c:v>8.4355524089679204</c:v>
                  </c:pt>
                  <c:pt idx="3">
                    <c:v>3.774374120301268</c:v>
                  </c:pt>
                </c:numCache>
                <c:extLst xmlns:c15="http://schemas.microsoft.com/office/drawing/2012/chart"/>
              </c:numRef>
            </c:plus>
            <c:minus>
              <c:numRef>
                <c:f>Dormancy!$AR$1118:$AU$1118</c:f>
                <c:numCache>
                  <c:formatCode>General</c:formatCode>
                  <c:ptCount val="4"/>
                  <c:pt idx="0">
                    <c:v>1.374546389823851</c:v>
                  </c:pt>
                  <c:pt idx="1">
                    <c:v>7.4699895879743003</c:v>
                  </c:pt>
                  <c:pt idx="2">
                    <c:v>8.4355524089679204</c:v>
                  </c:pt>
                  <c:pt idx="3">
                    <c:v>3.774374120301268</c:v>
                  </c:pt>
                </c:numCache>
                <c:extLst xmlns:c15="http://schemas.microsoft.com/office/drawing/2012/chart"/>
              </c:numRef>
            </c:minus>
          </c:errBars>
          <c:cat>
            <c:strRef>
              <c:f>Dormancy!$AM$1120:$AP$1120</c:f>
              <c:strCache>
                <c:ptCount val="4"/>
                <c:pt idx="0">
                  <c:v>Te</c:v>
                </c:pt>
                <c:pt idx="1">
                  <c:v>Tem</c:v>
                </c:pt>
                <c:pt idx="2">
                  <c:v>Tcm</c:v>
                </c:pt>
                <c:pt idx="3">
                  <c:v>Tn</c:v>
                </c:pt>
              </c:strCache>
              <c:extLst xmlns:c15="http://schemas.microsoft.com/office/drawing/2012/chart"/>
            </c:strRef>
          </c:cat>
          <c:val>
            <c:numRef>
              <c:f>Dormancy!$AM$1125:$AP$1125</c:f>
              <c:numCache>
                <c:formatCode>General</c:formatCode>
                <c:ptCount val="4"/>
                <c:pt idx="0">
                  <c:v>10.293333333333329</c:v>
                </c:pt>
                <c:pt idx="1">
                  <c:v>20.343333333333302</c:v>
                </c:pt>
                <c:pt idx="2">
                  <c:v>22.626666666666669</c:v>
                </c:pt>
                <c:pt idx="3">
                  <c:v>24.06</c:v>
                </c:pt>
              </c:numCache>
              <c:extLst xmlns:c15="http://schemas.microsoft.com/office/drawing/2012/chart"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4-C633-46D3-A0B0-2E60EDBC17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73622120"/>
        <c:axId val="-2111991208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Dormancy!$AL$1121</c15:sqref>
                        </c15:formulaRef>
                      </c:ext>
                    </c:extLst>
                    <c:strCache>
                      <c:ptCount val="1"/>
                      <c:pt idx="0">
                        <c:v>Naïve</c:v>
                      </c:pt>
                    </c:strCache>
                  </c:strRef>
                </c:tx>
                <c:spPr>
                  <a:solidFill>
                    <a:srgbClr val="FF0000"/>
                  </a:solidFill>
                </c:spPr>
                <c:invertIfNegative val="0"/>
                <c:dPt>
                  <c:idx val="0"/>
                  <c:invertIfNegative val="0"/>
                  <c:bubble3D val="0"/>
                  <c:spPr>
                    <a:solidFill>
                      <a:srgbClr val="0070C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6-C633-46D3-A0B0-2E60EDBC170E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8-C633-46D3-A0B0-2E60EDBC170E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>
                    <c:ext xmlns:c16="http://schemas.microsoft.com/office/drawing/2014/chart" uri="{C3380CC4-5D6E-409C-BE32-E72D297353CC}">
                      <c16:uniqueId val="{0000000A-C633-46D3-A0B0-2E60EDBC170E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Dormancy!$AM$1092:$AP$1092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15376750126227742</c:v>
                        </c:pt>
                        <c:pt idx="1">
                          <c:v>0.16045075395411645</c:v>
                        </c:pt>
                        <c:pt idx="2">
                          <c:v>0.73656862092634201</c:v>
                        </c:pt>
                        <c:pt idx="3">
                          <c:v>9.1476305371633977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Dormancy!$AM$1092:$AP$1092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15376750126227742</c:v>
                        </c:pt>
                        <c:pt idx="1">
                          <c:v>0.16045075395411645</c:v>
                        </c:pt>
                        <c:pt idx="2">
                          <c:v>0.73656862092634201</c:v>
                        </c:pt>
                        <c:pt idx="3">
                          <c:v>9.1476305371633977</c:v>
                        </c:pt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Dormancy!$AM$1120:$AP$1120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Dormancy!$AM$1121:$AP$1121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6.2533333333333339</c:v>
                      </c:pt>
                      <c:pt idx="1">
                        <c:v>3.5533333333333332</c:v>
                      </c:pt>
                      <c:pt idx="2">
                        <c:v>41.56</c:v>
                      </c:pt>
                      <c:pt idx="3">
                        <c:v>52.046666666666674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B-C633-46D3-A0B0-2E60EDBC170E}"/>
                  </c:ext>
                </c:extLst>
              </c15:ser>
            </c15:filteredBarSeries>
            <c15:filteredBa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L$1122</c15:sqref>
                        </c15:formulaRef>
                      </c:ext>
                    </c:extLst>
                    <c:strCache>
                      <c:ptCount val="1"/>
                      <c:pt idx="0">
                        <c:v>MMC</c:v>
                      </c:pt>
                    </c:strCache>
                  </c:strRef>
                </c:tx>
                <c:spPr>
                  <a:solidFill>
                    <a:srgbClr val="0070C0"/>
                  </a:solidFill>
                </c:spPr>
                <c:invertIfNegative val="0"/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D-C633-46D3-A0B0-2E60EDBC170E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0F-C633-46D3-A0B0-2E60EDBC170E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1-C633-46D3-A0B0-2E60EDBC170E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M$1100:$AP$1100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90864979196852569</c:v>
                        </c:pt>
                        <c:pt idx="1">
                          <c:v>3.3220626122937533</c:v>
                        </c:pt>
                        <c:pt idx="2">
                          <c:v>8.6989890855840883</c:v>
                        </c:pt>
                        <c:pt idx="3">
                          <c:v>4.4845413490246989E-2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M$1100:$AP$1100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.90864979196852569</c:v>
                        </c:pt>
                        <c:pt idx="1">
                          <c:v>3.3220626122937533</c:v>
                        </c:pt>
                        <c:pt idx="2">
                          <c:v>8.6989890855840883</c:v>
                        </c:pt>
                        <c:pt idx="3">
                          <c:v>4.4845413490246989E-2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M$1120:$AP$1120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M$1122:$AP$1122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0.083333333333334</c:v>
                      </c:pt>
                      <c:pt idx="1">
                        <c:v>13.38</c:v>
                      </c:pt>
                      <c:pt idx="2">
                        <c:v>13.483333333333334</c:v>
                      </c:pt>
                      <c:pt idx="3">
                        <c:v>32.636666666666663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2-C633-46D3-A0B0-2E60EDBC170E}"/>
                  </c:ext>
                </c:extLst>
              </c15:ser>
            </c15:filteredBarSeries>
            <c15:filteredBa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L$1123</c15:sqref>
                        </c15:formulaRef>
                      </c:ext>
                    </c:extLst>
                    <c:strCache>
                      <c:ptCount val="1"/>
                      <c:pt idx="0">
                        <c:v>R-Ctrl</c:v>
                      </c:pt>
                    </c:strCache>
                  </c:strRef>
                </c:tx>
                <c:spPr>
                  <a:solidFill>
                    <a:srgbClr val="0070C0"/>
                  </a:solidFill>
                </c:spPr>
                <c:invertIfNegative val="0"/>
                <c:dPt>
                  <c:idx val="1"/>
                  <c:invertIfNegative val="0"/>
                  <c:bubble3D val="0"/>
                  <c:spPr>
                    <a:solidFill>
                      <a:srgbClr val="FF000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4-C633-46D3-A0B0-2E60EDBC170E}"/>
                    </c:ext>
                  </c:extLst>
                </c:dPt>
                <c:dPt>
                  <c:idx val="2"/>
                  <c:invertIfNegative val="0"/>
                  <c:bubble3D val="0"/>
                  <c:spPr>
                    <a:solidFill>
                      <a:srgbClr val="00B050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6-C633-46D3-A0B0-2E60EDBC170E}"/>
                    </c:ext>
                  </c:extLst>
                </c:dPt>
                <c:dPt>
                  <c:idx val="3"/>
                  <c:invertIfNegative val="0"/>
                  <c:bubble3D val="0"/>
                  <c:spPr>
                    <a:solidFill>
                      <a:schemeClr val="tx1"/>
                    </a:solidFill>
                  </c:spPr>
                  <c:extLst xmlns:c15="http://schemas.microsoft.com/office/drawing/2012/chart">
                    <c:ext xmlns:c16="http://schemas.microsoft.com/office/drawing/2014/chart" uri="{C3380CC4-5D6E-409C-BE32-E72D297353CC}">
                      <c16:uniqueId val="{00000018-C633-46D3-A0B0-2E60EDBC170E}"/>
                    </c:ext>
                  </c:extLst>
                </c:dPt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M$1109:$AP$1109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2832813842299418</c:v>
                        </c:pt>
                        <c:pt idx="1">
                          <c:v>0.98800022492125184</c:v>
                        </c:pt>
                        <c:pt idx="2">
                          <c:v>5.9263995065394575</c:v>
                        </c:pt>
                        <c:pt idx="3">
                          <c:v>1.93084897850085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Dormancy!$AM$1109:$AP$1109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2832813842299418</c:v>
                        </c:pt>
                        <c:pt idx="1">
                          <c:v>0.98800022492125184</c:v>
                        </c:pt>
                        <c:pt idx="2">
                          <c:v>5.9263995065394575</c:v>
                        </c:pt>
                        <c:pt idx="3">
                          <c:v>1.93084897850085</c:v>
                        </c:pt>
                      </c:numCache>
                    </c:numRef>
                  </c:minus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M$1120:$AP$1120</c15:sqref>
                        </c15:formulaRef>
                      </c:ext>
                    </c:extLst>
                    <c:strCache>
                      <c:ptCount val="4"/>
                      <c:pt idx="0">
                        <c:v>Te</c:v>
                      </c:pt>
                      <c:pt idx="1">
                        <c:v>Tem</c:v>
                      </c:pt>
                      <c:pt idx="2">
                        <c:v>Tcm</c:v>
                      </c:pt>
                      <c:pt idx="3">
                        <c:v>Tn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Dormancy!$AM$1123:$AP$1123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0.953333333333333</c:v>
                      </c:pt>
                      <c:pt idx="1">
                        <c:v>15.803333333333335</c:v>
                      </c:pt>
                      <c:pt idx="2">
                        <c:v>15.423333333333332</c:v>
                      </c:pt>
                      <c:pt idx="3">
                        <c:v>32.24666666666667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9-C633-46D3-A0B0-2E60EDBC170E}"/>
                  </c:ext>
                </c:extLst>
              </c15:ser>
            </c15:filteredBarSeries>
          </c:ext>
        </c:extLst>
      </c:barChart>
      <c:catAx>
        <c:axId val="-20736221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11991208"/>
        <c:crosses val="autoZero"/>
        <c:auto val="1"/>
        <c:lblAlgn val="ctr"/>
        <c:lblOffset val="100"/>
        <c:noMultiLvlLbl val="0"/>
      </c:catAx>
      <c:valAx>
        <c:axId val="-2111991208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73622120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33238553514144098"/>
          <c:y val="4.6296296296296301E-2"/>
          <c:w val="0.61300579615048101"/>
          <c:h val="0.23020559930008699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740301472732574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AQ$1561:$AS$1561</c:f>
                <c:numCache>
                  <c:formatCode>General</c:formatCode>
                  <c:ptCount val="3"/>
                  <c:pt idx="0">
                    <c:v>2.5400000000000031</c:v>
                  </c:pt>
                  <c:pt idx="1">
                    <c:v>7.5709980260934326</c:v>
                  </c:pt>
                  <c:pt idx="2">
                    <c:v>2.151637619220403</c:v>
                  </c:pt>
                </c:numCache>
              </c:numRef>
            </c:plus>
            <c:minus>
              <c:numRef>
                <c:f>Dormancy!$AQ$1561:$AS$1561</c:f>
                <c:numCache>
                  <c:formatCode>General</c:formatCode>
                  <c:ptCount val="3"/>
                  <c:pt idx="0">
                    <c:v>2.5400000000000031</c:v>
                  </c:pt>
                  <c:pt idx="1">
                    <c:v>7.5709980260934326</c:v>
                  </c:pt>
                  <c:pt idx="2">
                    <c:v>2.151637619220403</c:v>
                  </c:pt>
                </c:numCache>
              </c:numRef>
            </c:minus>
          </c:errBars>
          <c:cat>
            <c:strRef>
              <c:f>Dormancy!$AQ$1556:$AS$1556</c:f>
              <c:strCache>
                <c:ptCount val="3"/>
                <c:pt idx="0">
                  <c:v>Ctrl</c:v>
                </c:pt>
                <c:pt idx="1">
                  <c:v>FAC</c:v>
                </c:pt>
                <c:pt idx="2">
                  <c:v>FAC/AIT</c:v>
                </c:pt>
              </c:strCache>
            </c:strRef>
          </c:cat>
          <c:val>
            <c:numRef>
              <c:f>Dormancy!$AQ$1560:$AS$1560</c:f>
              <c:numCache>
                <c:formatCode>General</c:formatCode>
                <c:ptCount val="3"/>
                <c:pt idx="0">
                  <c:v>47.84</c:v>
                </c:pt>
                <c:pt idx="1">
                  <c:v>73.803333333333271</c:v>
                </c:pt>
                <c:pt idx="2">
                  <c:v>72.7333333333332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C5-442A-A574-CCA5A10F0D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59024328"/>
        <c:axId val="2128764408"/>
      </c:barChart>
      <c:catAx>
        <c:axId val="-2059024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2128764408"/>
        <c:crosses val="autoZero"/>
        <c:auto val="1"/>
        <c:lblAlgn val="ctr"/>
        <c:lblOffset val="100"/>
        <c:noMultiLvlLbl val="0"/>
      </c:catAx>
      <c:valAx>
        <c:axId val="2128764408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59024328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715357571182775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Y$1582:$AA$1582</c:f>
                <c:numCache>
                  <c:formatCode>General</c:formatCode>
                  <c:ptCount val="3"/>
                  <c:pt idx="0">
                    <c:v>1.6499999999999979</c:v>
                  </c:pt>
                  <c:pt idx="1">
                    <c:v>6.1597898593305196</c:v>
                  </c:pt>
                  <c:pt idx="2">
                    <c:v>4.5776886453027013</c:v>
                  </c:pt>
                </c:numCache>
              </c:numRef>
            </c:plus>
            <c:minus>
              <c:numRef>
                <c:f>Dormancy!$Y$1582:$AA$1582</c:f>
                <c:numCache>
                  <c:formatCode>General</c:formatCode>
                  <c:ptCount val="3"/>
                  <c:pt idx="0">
                    <c:v>1.6499999999999979</c:v>
                  </c:pt>
                  <c:pt idx="1">
                    <c:v>6.1597898593305196</c:v>
                  </c:pt>
                  <c:pt idx="2">
                    <c:v>4.5776886453027013</c:v>
                  </c:pt>
                </c:numCache>
              </c:numRef>
            </c:minus>
          </c:errBars>
          <c:cat>
            <c:strRef>
              <c:f>Dormancy!$Y$1577:$AA$1577</c:f>
              <c:strCache>
                <c:ptCount val="3"/>
                <c:pt idx="0">
                  <c:v>Ctrl</c:v>
                </c:pt>
                <c:pt idx="1">
                  <c:v>FAC</c:v>
                </c:pt>
                <c:pt idx="2">
                  <c:v>FAC/AIT</c:v>
                </c:pt>
              </c:strCache>
            </c:strRef>
          </c:cat>
          <c:val>
            <c:numRef>
              <c:f>Dormancy!$Y$1581:$AA$1581</c:f>
              <c:numCache>
                <c:formatCode>General</c:formatCode>
                <c:ptCount val="3"/>
                <c:pt idx="0">
                  <c:v>25.68</c:v>
                </c:pt>
                <c:pt idx="1">
                  <c:v>32.90666666666656</c:v>
                </c:pt>
                <c:pt idx="2">
                  <c:v>28.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CE-4226-AED6-6A94BED629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9417416"/>
        <c:axId val="-2112952520"/>
      </c:barChart>
      <c:catAx>
        <c:axId val="2129417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12952520"/>
        <c:crosses val="autoZero"/>
        <c:auto val="1"/>
        <c:lblAlgn val="ctr"/>
        <c:lblOffset val="100"/>
        <c:noMultiLvlLbl val="0"/>
      </c:catAx>
      <c:valAx>
        <c:axId val="-2112952520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2129417416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latin typeface="+mj-lt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21863056591599"/>
          <c:y val="0.11111111111111099"/>
          <c:w val="0.85756826449325396"/>
          <c:h val="0.70480600672436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ormancy!$Y$1631:$AA$1631</c:f>
                <c:numCache>
                  <c:formatCode>General</c:formatCode>
                  <c:ptCount val="3"/>
                  <c:pt idx="0">
                    <c:v>2.139999999999997</c:v>
                  </c:pt>
                  <c:pt idx="1">
                    <c:v>15.437821881484579</c:v>
                  </c:pt>
                  <c:pt idx="2">
                    <c:v>1.017660716218002</c:v>
                  </c:pt>
                </c:numCache>
              </c:numRef>
            </c:plus>
            <c:minus>
              <c:numRef>
                <c:f>Dormancy!$Y$1631:$AA$1631</c:f>
                <c:numCache>
                  <c:formatCode>General</c:formatCode>
                  <c:ptCount val="3"/>
                  <c:pt idx="0">
                    <c:v>2.139999999999997</c:v>
                  </c:pt>
                  <c:pt idx="1">
                    <c:v>15.437821881484579</c:v>
                  </c:pt>
                  <c:pt idx="2">
                    <c:v>1.017660716218002</c:v>
                  </c:pt>
                </c:numCache>
              </c:numRef>
            </c:minus>
          </c:errBars>
          <c:cat>
            <c:strRef>
              <c:f>Dormancy!$Y$1626:$AA$1626</c:f>
              <c:strCache>
                <c:ptCount val="3"/>
                <c:pt idx="0">
                  <c:v>Ctrl</c:v>
                </c:pt>
                <c:pt idx="1">
                  <c:v>FAC</c:v>
                </c:pt>
                <c:pt idx="2">
                  <c:v>FAC/AIT</c:v>
                </c:pt>
              </c:strCache>
            </c:strRef>
          </c:cat>
          <c:val>
            <c:numRef>
              <c:f>Dormancy!$Y$1630:$AA$1630</c:f>
              <c:numCache>
                <c:formatCode>General</c:formatCode>
                <c:ptCount val="3"/>
                <c:pt idx="0">
                  <c:v>50.28</c:v>
                </c:pt>
                <c:pt idx="1">
                  <c:v>44.173333333333339</c:v>
                </c:pt>
                <c:pt idx="2">
                  <c:v>7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47E-429D-90D8-CB84EDFD7F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31898296"/>
        <c:axId val="-2108457464"/>
      </c:barChart>
      <c:catAx>
        <c:axId val="-2131898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08457464"/>
        <c:crosses val="autoZero"/>
        <c:auto val="1"/>
        <c:lblAlgn val="ctr"/>
        <c:lblOffset val="100"/>
        <c:noMultiLvlLbl val="0"/>
      </c:catAx>
      <c:valAx>
        <c:axId val="-2108457464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31898296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247594050743705E-2"/>
          <c:y val="0.11266294838145199"/>
          <c:w val="0.890196850393701"/>
          <c:h val="0.656318350831145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ormancy cells'!$K$23</c:f>
              <c:strCache>
                <c:ptCount val="1"/>
                <c:pt idx="0">
                  <c:v>EpCA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rmancy cells'!$L$15:$P$15</c:f>
                <c:numCache>
                  <c:formatCode>General</c:formatCode>
                  <c:ptCount val="2"/>
                  <c:pt idx="0">
                    <c:v>0.95343239578552696</c:v>
                  </c:pt>
                  <c:pt idx="1">
                    <c:v>0.78935275876998101</c:v>
                  </c:pt>
                </c:numCache>
              </c:numRef>
            </c:plus>
            <c:minus>
              <c:numRef>
                <c:f>'dormancy cells'!$L$15:$P$15</c:f>
                <c:numCache>
                  <c:formatCode>General</c:formatCode>
                  <c:ptCount val="2"/>
                  <c:pt idx="0">
                    <c:v>0.95343239578552696</c:v>
                  </c:pt>
                  <c:pt idx="1">
                    <c:v>0.789352758769981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ormancy cells'!$L$22:$P$22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'dormancy cells'!$L$23:$P$23</c:f>
              <c:numCache>
                <c:formatCode>General</c:formatCode>
                <c:ptCount val="2"/>
                <c:pt idx="0">
                  <c:v>87.179999999999978</c:v>
                </c:pt>
                <c:pt idx="1">
                  <c:v>83.066666666666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F4-4648-BE6D-E3ED0F320D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17800312"/>
        <c:axId val="-2135675896"/>
        <c:extLst>
          <c:ext xmlns:c15="http://schemas.microsoft.com/office/drawing/2012/chart" uri="{02D57815-91ED-43cb-92C2-25804820EDAC}">
            <c15:filteredBarSeries>
              <c15:ser>
                <c:idx val="1"/>
                <c:order val="1"/>
                <c:tx>
                  <c:strRef>
                    <c:extLst>
                      <c:ext uri="{02D57815-91ED-43cb-92C2-25804820EDAC}">
                        <c15:formulaRef>
                          <c15:sqref>'dormancy cells'!$K$24</c15:sqref>
                        </c15:formulaRef>
                      </c:ext>
                    </c:extLst>
                    <c:strCache>
                      <c:ptCount val="1"/>
                      <c:pt idx="0">
                        <c:v>CD326- </c:v>
                      </c:pt>
                    </c:strCache>
                  </c:strRef>
                </c:tx>
                <c:spPr>
                  <a:noFill/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dormancy cells'!$L$21:$P$21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0.66799035255841188</c:v>
                        </c:pt>
                        <c:pt idx="1">
                          <c:v>0.53926905261762537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dormancy cells'!$L$21:$P$21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0.66799035255841188</c:v>
                        </c:pt>
                        <c:pt idx="1">
                          <c:v>0.53926905261762537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strRef>
                    <c:extLst>
                      <c:ext uri="{02D57815-91ED-43cb-92C2-25804820EDAC}">
                        <c15:formulaRef>
                          <c15:sqref>'dormancy cells'!$L$22:$P$22</c15:sqref>
                        </c15:formulaRef>
                      </c:ext>
                    </c:extLst>
                    <c:strCache>
                      <c:ptCount val="2"/>
                      <c:pt idx="0">
                        <c:v>R-FAC/AIT</c:v>
                      </c:pt>
                      <c:pt idx="1">
                        <c:v>R-FAC/AIT L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dormancy cells'!$L$24:$P$24</c15:sqref>
                        </c15:formulaRef>
                      </c:ext>
                    </c:extLst>
                    <c:numCache>
                      <c:formatCode>General</c:formatCode>
                      <c:ptCount val="2"/>
                      <c:pt idx="0">
                        <c:v>9.8466666666666658</c:v>
                      </c:pt>
                      <c:pt idx="1">
                        <c:v>9.413333333333334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1-C4F4-4648-BE6D-E3ED0F320D40}"/>
                  </c:ext>
                </c:extLst>
              </c15:ser>
            </c15:filteredBarSeries>
          </c:ext>
        </c:extLst>
      </c:barChart>
      <c:catAx>
        <c:axId val="-2017800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35675896"/>
        <c:crosses val="autoZero"/>
        <c:auto val="1"/>
        <c:lblAlgn val="ctr"/>
        <c:lblOffset val="100"/>
        <c:noMultiLvlLbl val="0"/>
      </c:catAx>
      <c:valAx>
        <c:axId val="-2135675896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1780031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247594050743705E-2"/>
          <c:y val="0.20024118606795799"/>
          <c:w val="0.890196850393701"/>
          <c:h val="0.565834609215514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ormancy cells'!$Z$23</c:f>
              <c:strCache>
                <c:ptCount val="1"/>
                <c:pt idx="0">
                  <c:v>CD24+CD44+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rmancy cells'!$AA$15:$AE$15</c:f>
                <c:numCache>
                  <c:formatCode>General</c:formatCode>
                  <c:ptCount val="2"/>
                  <c:pt idx="0">
                    <c:v>0.77833868663398198</c:v>
                  </c:pt>
                  <c:pt idx="1">
                    <c:v>0.65526924067727799</c:v>
                  </c:pt>
                </c:numCache>
              </c:numRef>
            </c:plus>
            <c:minus>
              <c:numRef>
                <c:f>'dormancy cells'!$AA$15:$AE$15</c:f>
                <c:numCache>
                  <c:formatCode>General</c:formatCode>
                  <c:ptCount val="2"/>
                  <c:pt idx="0">
                    <c:v>0.77833868663398198</c:v>
                  </c:pt>
                  <c:pt idx="1">
                    <c:v>0.655269240677277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ormancy cells'!$AA$22:$AE$22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'dormancy cells'!$AA$23:$AE$23</c:f>
              <c:numCache>
                <c:formatCode>General</c:formatCode>
                <c:ptCount val="2"/>
                <c:pt idx="0">
                  <c:v>96.756666666666675</c:v>
                </c:pt>
                <c:pt idx="1">
                  <c:v>85.6033333333332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15-427D-A662-61543E5F3D26}"/>
            </c:ext>
          </c:extLst>
        </c:ser>
        <c:ser>
          <c:idx val="1"/>
          <c:order val="1"/>
          <c:tx>
            <c:strRef>
              <c:f>'dormancy cells'!$Z$24</c:f>
              <c:strCache>
                <c:ptCount val="1"/>
                <c:pt idx="0">
                  <c:v>CD24-CD44+</c:v>
                </c:pt>
              </c:strCache>
              <c:extLst xmlns:c15="http://schemas.microsoft.com/office/drawing/2012/chart"/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rmancy cells'!$AA$21:$AE$21</c:f>
                <c:numCache>
                  <c:formatCode>General</c:formatCode>
                  <c:ptCount val="2"/>
                  <c:pt idx="0">
                    <c:v>0.47987266829626601</c:v>
                  </c:pt>
                  <c:pt idx="1">
                    <c:v>0.59197409853246796</c:v>
                  </c:pt>
                </c:numCache>
              </c:numRef>
            </c:plus>
            <c:minus>
              <c:numRef>
                <c:f>'dormancy cells'!$AA$21:$AE$21</c:f>
                <c:numCache>
                  <c:formatCode>General</c:formatCode>
                  <c:ptCount val="2"/>
                  <c:pt idx="0">
                    <c:v>0.47987266829626601</c:v>
                  </c:pt>
                  <c:pt idx="1">
                    <c:v>0.591974098532467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ormancy cells'!$AA$22:$AE$22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'dormancy cells'!$AA$24:$AE$24</c:f>
              <c:numCache>
                <c:formatCode>General</c:formatCode>
                <c:ptCount val="2"/>
                <c:pt idx="0">
                  <c:v>1.3466666666666669</c:v>
                </c:pt>
                <c:pt idx="1">
                  <c:v>6.88</c:v>
                </c:pt>
              </c:numCache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1-C215-427D-A662-61543E5F3D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35420104"/>
        <c:axId val="-2135700024"/>
        <c:extLst/>
      </c:barChart>
      <c:catAx>
        <c:axId val="-2135420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35700024"/>
        <c:crosses val="autoZero"/>
        <c:auto val="1"/>
        <c:lblAlgn val="ctr"/>
        <c:lblOffset val="100"/>
        <c:noMultiLvlLbl val="0"/>
      </c:catAx>
      <c:valAx>
        <c:axId val="-213570002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3542010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9.1152263374485606E-2"/>
          <c:y val="1.2012012012012E-2"/>
          <c:w val="0.9"/>
          <c:h val="0.15917996736894399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247594050743705E-2"/>
          <c:y val="0.116157407407407"/>
          <c:w val="0.890196850393701"/>
          <c:h val="0.776443205016039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rmancy cells'!$C$15:$I$15</c:f>
                <c:numCache>
                  <c:formatCode>General</c:formatCode>
                  <c:ptCount val="2"/>
                  <c:pt idx="0">
                    <c:v>0.59677838805074701</c:v>
                  </c:pt>
                  <c:pt idx="1">
                    <c:v>3.2038535824500149</c:v>
                  </c:pt>
                </c:numCache>
              </c:numRef>
            </c:plus>
            <c:minus>
              <c:numRef>
                <c:f>'dormancy cells'!$C$15:$I$15</c:f>
                <c:numCache>
                  <c:formatCode>General</c:formatCode>
                  <c:ptCount val="2"/>
                  <c:pt idx="0">
                    <c:v>0.59677838805074701</c:v>
                  </c:pt>
                  <c:pt idx="1">
                    <c:v>3.20385358245001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ormancy cells'!$C$10:$I$10</c:f>
              <c:strCache>
                <c:ptCount val="2"/>
                <c:pt idx="0">
                  <c:v>R-FAC/AIT</c:v>
                </c:pt>
                <c:pt idx="1">
                  <c:v>R-FAC/AIT L</c:v>
                </c:pt>
              </c:strCache>
            </c:strRef>
          </c:cat>
          <c:val>
            <c:numRef>
              <c:f>'dormancy cells'!$C$14:$I$14</c:f>
              <c:numCache>
                <c:formatCode>General</c:formatCode>
                <c:ptCount val="2"/>
                <c:pt idx="0">
                  <c:v>91.733333333333277</c:v>
                </c:pt>
                <c:pt idx="1">
                  <c:v>81.146666666666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9C-45FE-B0DE-FD5B78AD4D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83367112"/>
        <c:axId val="-2009415096"/>
      </c:barChart>
      <c:catAx>
        <c:axId val="-2083367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09415096"/>
        <c:crosses val="autoZero"/>
        <c:auto val="1"/>
        <c:lblAlgn val="ctr"/>
        <c:lblOffset val="100"/>
        <c:noMultiLvlLbl val="0"/>
      </c:catAx>
      <c:valAx>
        <c:axId val="-2009415096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8336711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+mj-lt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A0CBE9-42BC-434A-957F-178AEA29AC08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126D59-D325-4471-AAE7-2305EA4C1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902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CD734B-11D0-4231-9BE6-122BF6B99A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2EAF6F-5E83-496E-AB3C-27EAF8FF16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A1E7E1-D095-4063-97FC-6C7B03BE1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0C6E12-4349-449A-A78D-51D2F337E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81106C-9F34-45AB-B339-58EAB936D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04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CB8BB9-D8B9-49CD-A58B-D86AC96C48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D8EAB5-2D20-4FFF-B8E3-38205B70DE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40E220-A73C-4FE3-ACFB-BA7D73EB4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EE4308-855B-4D10-92C8-14BEE2401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609EED-5E5C-414C-A588-7BF41C475D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894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4E28E4-9632-4694-9462-A1EF704F39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EC8BDB-5558-4F92-853C-73586834BE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8A79CB-212B-4131-8C14-A3C06A5FD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CA4000-F323-41D0-9ED3-B19AB8115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31BEC9-D79B-48D9-ABD7-8358859FF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9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B36FD0-87EB-4BEB-BD2A-7F7448EF8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850EB7-0EE8-4836-A6BF-30DD6B3E45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977BD8-9A21-4C7F-9B86-26C3DFBB09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9068AA-6A0D-49BD-8D9F-E93919E5DB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5E38B8-9D71-449D-A79A-9B8DADC2B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424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72D94B-F8A2-4F23-9A7A-5B2C3ABB48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98EFB7-F320-413F-9D4F-12CC0D9248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983162-C47F-4975-9D19-59A9689F5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F4CCB3-1B09-4DAD-AD8A-D0ACAF1AE8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2C736-A417-4009-ADB8-A66C9B75B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644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0D09F5-2B84-44BD-A865-45EA25A78F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284D07-1547-4F3A-B53C-4B92BA62D0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1C6FFC-DDC2-417E-B81E-3E92FA3D7E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771486-B578-4BC8-BA5F-887E5F2458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A84290-3597-4CB1-B3CB-E857988B1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56228E-E6E1-48C7-AF65-D843061CA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221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2D2EAC-DC5F-47B7-BD43-1047B368FE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136F3B-A92E-49D3-B8E7-D96FD45A36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8822A6-1EC3-4B39-9B7E-FF66A7FCDC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D9C6898-5AEC-4F25-BA03-4EBFCA3F32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64E1607-F834-4590-B351-DAC95D2729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FB7F5A-15F3-4F4C-B821-F4F2CB717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1F2688-B520-4731-AF14-F28007144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B70794F-E6AC-4B1F-9B24-C8014CBCC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075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2327E-0DBC-4E6D-9718-31A7E66E76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04DEE7-AFB2-44D8-BB21-1BA38B4D6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E2302D3-D46F-4D9A-9F0D-62AD1473D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61569D-6482-4F6A-9E6B-E100B3B03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377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D52AEF-A9AF-4092-AED5-7D3B2609F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F380A1-7EE4-49E0-BFE6-DE7547C26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EB6145-88EB-423F-896A-110FD226B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609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3D5743-34B7-4DFF-A18C-06078C28E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A74A36-D628-407E-A8C2-D3172969EE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271380-08A7-4004-9AEB-8F8B09D16B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73ABFC-C387-4914-8593-48CA07E14B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D38943-B0A5-48D5-BBAC-44C53F24B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B3C232-FE2A-46C8-B9F6-3006C6C20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081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902201-097E-4DEF-BFA0-2629217F71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B9F2DD-35D7-450A-9FDB-88353D5CDA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2583A6-8C43-47C2-9698-30F582A880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B77E73-8CF4-4379-B9FF-EB392EA50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37E19B-67C1-4AC6-AA86-061E70E12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117521-2BDC-446C-9C20-917E69B28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202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7B079B-9C80-407D-9532-2A8CEE8A67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3EA8C5-631A-4F90-8008-13633EAA9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32823C-8844-4AC8-9F9E-C6E43A6DCD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FB53B-1B4C-448A-A833-8C40D342E447}" type="datetimeFigureOut">
              <a:rPr lang="en-US" smtClean="0"/>
              <a:t>9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B1B311-EF85-41D9-AF2D-02A670210B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8EA862-B809-4513-92D6-29B4FE8328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B9878D-6646-4B7F-8A45-FC4644C8D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19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chart" Target="../charts/chart2.xml"/><Relationship Id="rId4" Type="http://schemas.openxmlformats.org/officeDocument/2006/relationships/image" Target="../media/image3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chart" Target="../charts/chart5.xml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12" Type="http://schemas.openxmlformats.org/officeDocument/2006/relationships/chart" Target="../charts/chart4.xml"/><Relationship Id="rId17" Type="http://schemas.openxmlformats.org/officeDocument/2006/relationships/image" Target="../media/image19.emf"/><Relationship Id="rId2" Type="http://schemas.openxmlformats.org/officeDocument/2006/relationships/image" Target="../media/image8.emf"/><Relationship Id="rId16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11" Type="http://schemas.openxmlformats.org/officeDocument/2006/relationships/chart" Target="../charts/chart3.xml"/><Relationship Id="rId5" Type="http://schemas.openxmlformats.org/officeDocument/2006/relationships/image" Target="../media/image11.emf"/><Relationship Id="rId15" Type="http://schemas.openxmlformats.org/officeDocument/2006/relationships/image" Target="../media/image17.emf"/><Relationship Id="rId10" Type="http://schemas.openxmlformats.org/officeDocument/2006/relationships/image" Target="../media/image16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Relationship Id="rId1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emf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.xml"/><Relationship Id="rId3" Type="http://schemas.openxmlformats.org/officeDocument/2006/relationships/image" Target="../media/image27.emf"/><Relationship Id="rId7" Type="http://schemas.openxmlformats.org/officeDocument/2006/relationships/chart" Target="../charts/chart7.xml"/><Relationship Id="rId12" Type="http://schemas.openxmlformats.org/officeDocument/2006/relationships/image" Target="../media/image33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11" Type="http://schemas.openxmlformats.org/officeDocument/2006/relationships/image" Target="../media/image32.emf"/><Relationship Id="rId5" Type="http://schemas.openxmlformats.org/officeDocument/2006/relationships/image" Target="../media/image29.jpeg"/><Relationship Id="rId10" Type="http://schemas.openxmlformats.org/officeDocument/2006/relationships/chart" Target="../charts/chart9.xml"/><Relationship Id="rId4" Type="http://schemas.openxmlformats.org/officeDocument/2006/relationships/image" Target="../media/image28.emf"/><Relationship Id="rId9" Type="http://schemas.openxmlformats.org/officeDocument/2006/relationships/image" Target="../media/image3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2.xml"/><Relationship Id="rId13" Type="http://schemas.openxmlformats.org/officeDocument/2006/relationships/chart" Target="../charts/chart17.xml"/><Relationship Id="rId18" Type="http://schemas.openxmlformats.org/officeDocument/2006/relationships/chart" Target="../charts/chart22.xml"/><Relationship Id="rId26" Type="http://schemas.openxmlformats.org/officeDocument/2006/relationships/image" Target="../media/image45.emf"/><Relationship Id="rId3" Type="http://schemas.openxmlformats.org/officeDocument/2006/relationships/image" Target="../media/image35.emf"/><Relationship Id="rId21" Type="http://schemas.openxmlformats.org/officeDocument/2006/relationships/image" Target="../media/image40.emf"/><Relationship Id="rId7" Type="http://schemas.openxmlformats.org/officeDocument/2006/relationships/chart" Target="../charts/chart11.xml"/><Relationship Id="rId12" Type="http://schemas.openxmlformats.org/officeDocument/2006/relationships/chart" Target="../charts/chart16.xml"/><Relationship Id="rId17" Type="http://schemas.openxmlformats.org/officeDocument/2006/relationships/chart" Target="../charts/chart21.xml"/><Relationship Id="rId25" Type="http://schemas.openxmlformats.org/officeDocument/2006/relationships/image" Target="../media/image44.emf"/><Relationship Id="rId2" Type="http://schemas.openxmlformats.org/officeDocument/2006/relationships/image" Target="../media/image34.emf"/><Relationship Id="rId16" Type="http://schemas.openxmlformats.org/officeDocument/2006/relationships/chart" Target="../charts/chart20.xml"/><Relationship Id="rId20" Type="http://schemas.openxmlformats.org/officeDocument/2006/relationships/image" Target="../media/image39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0.xml"/><Relationship Id="rId11" Type="http://schemas.openxmlformats.org/officeDocument/2006/relationships/chart" Target="../charts/chart15.xml"/><Relationship Id="rId24" Type="http://schemas.openxmlformats.org/officeDocument/2006/relationships/image" Target="../media/image43.emf"/><Relationship Id="rId5" Type="http://schemas.openxmlformats.org/officeDocument/2006/relationships/image" Target="../media/image37.emf"/><Relationship Id="rId15" Type="http://schemas.openxmlformats.org/officeDocument/2006/relationships/chart" Target="../charts/chart19.xml"/><Relationship Id="rId23" Type="http://schemas.openxmlformats.org/officeDocument/2006/relationships/image" Target="../media/image42.emf"/><Relationship Id="rId10" Type="http://schemas.openxmlformats.org/officeDocument/2006/relationships/chart" Target="../charts/chart14.xml"/><Relationship Id="rId19" Type="http://schemas.openxmlformats.org/officeDocument/2006/relationships/image" Target="../media/image38.emf"/><Relationship Id="rId4" Type="http://schemas.openxmlformats.org/officeDocument/2006/relationships/image" Target="../media/image36.emf"/><Relationship Id="rId9" Type="http://schemas.openxmlformats.org/officeDocument/2006/relationships/chart" Target="../charts/chart13.xml"/><Relationship Id="rId14" Type="http://schemas.openxmlformats.org/officeDocument/2006/relationships/chart" Target="../charts/chart18.xml"/><Relationship Id="rId22" Type="http://schemas.openxmlformats.org/officeDocument/2006/relationships/image" Target="../media/image41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5.xml"/><Relationship Id="rId13" Type="http://schemas.openxmlformats.org/officeDocument/2006/relationships/chart" Target="../charts/chart30.xml"/><Relationship Id="rId18" Type="http://schemas.openxmlformats.org/officeDocument/2006/relationships/image" Target="../media/image53.emf"/><Relationship Id="rId3" Type="http://schemas.openxmlformats.org/officeDocument/2006/relationships/image" Target="../media/image47.emf"/><Relationship Id="rId7" Type="http://schemas.openxmlformats.org/officeDocument/2006/relationships/chart" Target="../charts/chart24.xml"/><Relationship Id="rId12" Type="http://schemas.openxmlformats.org/officeDocument/2006/relationships/chart" Target="../charts/chart29.xml"/><Relationship Id="rId17" Type="http://schemas.openxmlformats.org/officeDocument/2006/relationships/image" Target="../media/image52.emf"/><Relationship Id="rId2" Type="http://schemas.openxmlformats.org/officeDocument/2006/relationships/image" Target="../media/image46.emf"/><Relationship Id="rId16" Type="http://schemas.openxmlformats.org/officeDocument/2006/relationships/image" Target="../media/image51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3.xml"/><Relationship Id="rId11" Type="http://schemas.openxmlformats.org/officeDocument/2006/relationships/chart" Target="../charts/chart28.xml"/><Relationship Id="rId5" Type="http://schemas.openxmlformats.org/officeDocument/2006/relationships/image" Target="../media/image49.emf"/><Relationship Id="rId15" Type="http://schemas.openxmlformats.org/officeDocument/2006/relationships/image" Target="../media/image50.emf"/><Relationship Id="rId10" Type="http://schemas.openxmlformats.org/officeDocument/2006/relationships/chart" Target="../charts/chart27.xml"/><Relationship Id="rId4" Type="http://schemas.openxmlformats.org/officeDocument/2006/relationships/image" Target="../media/image48.emf"/><Relationship Id="rId9" Type="http://schemas.openxmlformats.org/officeDocument/2006/relationships/chart" Target="../charts/chart26.xml"/><Relationship Id="rId14" Type="http://schemas.openxmlformats.org/officeDocument/2006/relationships/chart" Target="../charts/chart3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4406729" y="3049427"/>
            <a:ext cx="478166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Expression of PD-1/PD-L1 at the site of primary tumor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) Expression of PD-1 on gated CD3+ FVS- viable T cells in the mammary tumor site of the Ctrl, FAC or FAC/AIT groups. B) MMC tumor cell line or mammary tumor cells of FVBN202 mice from three groups (Ctrl, FAC or FAC/AIT) were analyzed for the expression of PD-L1 on gated FVS-neu+ cells.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405DA12-F3CD-4A11-B077-A22057C275AA}"/>
              </a:ext>
            </a:extLst>
          </p:cNvPr>
          <p:cNvSpPr txBox="1"/>
          <p:nvPr/>
        </p:nvSpPr>
        <p:spPr>
          <a:xfrm>
            <a:off x="7497095" y="1029174"/>
            <a:ext cx="332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Ctr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EE015E5-DD9F-4740-8A91-D31CD6650412}"/>
              </a:ext>
            </a:extLst>
          </p:cNvPr>
          <p:cNvSpPr txBox="1"/>
          <p:nvPr/>
        </p:nvSpPr>
        <p:spPr>
          <a:xfrm>
            <a:off x="6838961" y="1756829"/>
            <a:ext cx="34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433DA12-DC8D-48A3-A870-575C77C44650}"/>
              </a:ext>
            </a:extLst>
          </p:cNvPr>
          <p:cNvSpPr txBox="1"/>
          <p:nvPr/>
        </p:nvSpPr>
        <p:spPr>
          <a:xfrm>
            <a:off x="7455384" y="1754371"/>
            <a:ext cx="5196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/AI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16BE81B-4333-42A3-8E97-6944723698ED}"/>
              </a:ext>
            </a:extLst>
          </p:cNvPr>
          <p:cNvSpPr txBox="1"/>
          <p:nvPr/>
        </p:nvSpPr>
        <p:spPr>
          <a:xfrm>
            <a:off x="7160112" y="2457173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PD-L1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226693" y="20189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7BCFD13-E777-497D-8AA4-F28C4DDBD07A}"/>
              </a:ext>
            </a:extLst>
          </p:cNvPr>
          <p:cNvSpPr txBox="1"/>
          <p:nvPr/>
        </p:nvSpPr>
        <p:spPr>
          <a:xfrm>
            <a:off x="6811283" y="1026812"/>
            <a:ext cx="419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MMC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BD6C112-F86D-4E8E-9D38-F6D4DA6C3180}"/>
              </a:ext>
            </a:extLst>
          </p:cNvPr>
          <p:cNvSpPr txBox="1"/>
          <p:nvPr/>
        </p:nvSpPr>
        <p:spPr>
          <a:xfrm>
            <a:off x="6598623" y="797352"/>
            <a:ext cx="18165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B) Gated neu+ FVS- viable cell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239DC94-FB7D-4D7E-889A-C00272DE19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35888" y="1951663"/>
            <a:ext cx="685696" cy="54864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421BE03-F5DC-48D5-BE4D-6D43B4D92C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06942" y="1951663"/>
            <a:ext cx="711928" cy="5486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49FA5C2-4BA3-4300-AAB9-3F8998D54D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08353" y="1267849"/>
            <a:ext cx="738051" cy="54864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ED0CCC42-7D1E-4FC9-B6F4-F17E477D6A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08935" y="1272611"/>
            <a:ext cx="728254" cy="5486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D8B5650-E7A6-49B9-823F-82713728F8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24471" y="1273978"/>
            <a:ext cx="695597" cy="5486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909DF7A-EB5F-40FF-B688-6F0BFA505D6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45591" y="1225587"/>
            <a:ext cx="663229" cy="548640"/>
          </a:xfrm>
          <a:prstGeom prst="rect">
            <a:avLst/>
          </a:prstGeom>
        </p:spPr>
      </p:pic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00000000-0008-0000-0700-0000AA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6273642"/>
              </p:ext>
            </p:extLst>
          </p:nvPr>
        </p:nvGraphicFramePr>
        <p:xfrm>
          <a:off x="4982525" y="1877524"/>
          <a:ext cx="914400" cy="1097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31FDC396-F731-4990-A611-5A0D4F434256}"/>
              </a:ext>
            </a:extLst>
          </p:cNvPr>
          <p:cNvSpPr txBox="1"/>
          <p:nvPr/>
        </p:nvSpPr>
        <p:spPr>
          <a:xfrm rot="16200000">
            <a:off x="4551344" y="2156561"/>
            <a:ext cx="7857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PD-1+ T cell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A93F873-ED45-4DF7-AB46-38945B1A322A}"/>
              </a:ext>
            </a:extLst>
          </p:cNvPr>
          <p:cNvSpPr txBox="1"/>
          <p:nvPr/>
        </p:nvSpPr>
        <p:spPr>
          <a:xfrm>
            <a:off x="4475713" y="797352"/>
            <a:ext cx="19255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A) Gated CD3+ FVS- viable T cell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4C8AA63-142B-4EE1-985A-0B3E9240AF8A}"/>
              </a:ext>
            </a:extLst>
          </p:cNvPr>
          <p:cNvSpPr txBox="1"/>
          <p:nvPr/>
        </p:nvSpPr>
        <p:spPr>
          <a:xfrm>
            <a:off x="5338480" y="1078977"/>
            <a:ext cx="34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6CCDA59-5607-414B-8C82-D81DEA1697D1}"/>
              </a:ext>
            </a:extLst>
          </p:cNvPr>
          <p:cNvSpPr txBox="1"/>
          <p:nvPr/>
        </p:nvSpPr>
        <p:spPr>
          <a:xfrm>
            <a:off x="5960240" y="1074215"/>
            <a:ext cx="5196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/AI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DEF0290-7B75-43F2-B3CA-5A4EBB452AC2}"/>
              </a:ext>
            </a:extLst>
          </p:cNvPr>
          <p:cNvSpPr txBox="1"/>
          <p:nvPr/>
        </p:nvSpPr>
        <p:spPr>
          <a:xfrm>
            <a:off x="4422506" y="1826068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PD-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6FD7EE2-9D12-4E73-85B5-05DF20768FFD}"/>
              </a:ext>
            </a:extLst>
          </p:cNvPr>
          <p:cNvSpPr txBox="1"/>
          <p:nvPr/>
        </p:nvSpPr>
        <p:spPr>
          <a:xfrm>
            <a:off x="4596962" y="1076219"/>
            <a:ext cx="34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Ctrl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D457D0D-9580-44CB-9258-F8333B34B77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16389" y="1225587"/>
            <a:ext cx="711926" cy="548640"/>
          </a:xfrm>
          <a:prstGeom prst="rect">
            <a:avLst/>
          </a:prstGeom>
        </p:spPr>
      </p:pic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00000000-0008-0000-0700-0000A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4880791"/>
              </p:ext>
            </p:extLst>
          </p:nvPr>
        </p:nvGraphicFramePr>
        <p:xfrm>
          <a:off x="8210608" y="1242256"/>
          <a:ext cx="993561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7DFF51F-3FD3-43BA-9D75-E1D82BFF2B34}"/>
              </a:ext>
            </a:extLst>
          </p:cNvPr>
          <p:cNvSpPr txBox="1"/>
          <p:nvPr/>
        </p:nvSpPr>
        <p:spPr>
          <a:xfrm>
            <a:off x="8519671" y="1436456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8D24063-C7DA-41CF-9B48-D346B0E61238}"/>
              </a:ext>
            </a:extLst>
          </p:cNvPr>
          <p:cNvSpPr txBox="1"/>
          <p:nvPr/>
        </p:nvSpPr>
        <p:spPr>
          <a:xfrm>
            <a:off x="8802000" y="129532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*</a:t>
            </a:r>
          </a:p>
        </p:txBody>
      </p:sp>
      <p:sp>
        <p:nvSpPr>
          <p:cNvPr id="5" name="Right Bracket 4">
            <a:extLst>
              <a:ext uri="{FF2B5EF4-FFF2-40B4-BE49-F238E27FC236}">
                <a16:creationId xmlns:a16="http://schemas.microsoft.com/office/drawing/2014/main" id="{EAA30247-6049-462E-8C42-934247575A61}"/>
              </a:ext>
            </a:extLst>
          </p:cNvPr>
          <p:cNvSpPr/>
          <p:nvPr/>
        </p:nvSpPr>
        <p:spPr>
          <a:xfrm rot="16200000">
            <a:off x="8774094" y="1514204"/>
            <a:ext cx="45719" cy="157087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ight Bracket 33">
            <a:extLst>
              <a:ext uri="{FF2B5EF4-FFF2-40B4-BE49-F238E27FC236}">
                <a16:creationId xmlns:a16="http://schemas.microsoft.com/office/drawing/2014/main" id="{DBBEACE7-1E77-40E5-991A-EFAE6D6FAE55}"/>
              </a:ext>
            </a:extLst>
          </p:cNvPr>
          <p:cNvSpPr/>
          <p:nvPr/>
        </p:nvSpPr>
        <p:spPr>
          <a:xfrm rot="16200000">
            <a:off x="8921927" y="1361479"/>
            <a:ext cx="45719" cy="157087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ight Bracket 34">
            <a:extLst>
              <a:ext uri="{FF2B5EF4-FFF2-40B4-BE49-F238E27FC236}">
                <a16:creationId xmlns:a16="http://schemas.microsoft.com/office/drawing/2014/main" id="{596A5E06-7D9D-45DA-80C3-409033DEA927}"/>
              </a:ext>
            </a:extLst>
          </p:cNvPr>
          <p:cNvSpPr/>
          <p:nvPr/>
        </p:nvSpPr>
        <p:spPr>
          <a:xfrm rot="16200000">
            <a:off x="8617007" y="1511093"/>
            <a:ext cx="45719" cy="157087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3D22C40B-EC8E-46A8-80CA-D4CAD2CC6695}"/>
              </a:ext>
            </a:extLst>
          </p:cNvPr>
          <p:cNvCxnSpPr/>
          <p:nvPr/>
        </p:nvCxnSpPr>
        <p:spPr>
          <a:xfrm>
            <a:off x="4480033" y="1816489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95A8C4C0-B259-45A7-87C8-9FBE96C62C19}"/>
              </a:ext>
            </a:extLst>
          </p:cNvPr>
          <p:cNvSpPr txBox="1"/>
          <p:nvPr/>
        </p:nvSpPr>
        <p:spPr>
          <a:xfrm rot="16200000">
            <a:off x="7655126" y="1718345"/>
            <a:ext cx="10390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PD-L1+ tumor cells</a:t>
            </a:r>
          </a:p>
        </p:txBody>
      </p:sp>
    </p:spTree>
    <p:extLst>
      <p:ext uri="{BB962C8B-B14F-4D97-AF65-F5344CB8AC3E}">
        <p14:creationId xmlns:p14="http://schemas.microsoft.com/office/powerpoint/2010/main" val="33518886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1C17CA9-FFC5-4AC0-9D4B-5A03FE3D0F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15379" y="3530906"/>
            <a:ext cx="751114" cy="5486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A37C1DF-662F-47D5-A69E-999FC99D2B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83476" y="2357994"/>
            <a:ext cx="722376" cy="53087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0DEFA87-B369-46A8-A1F5-F95F332424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44021" y="2357993"/>
            <a:ext cx="722376" cy="52183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415C7B3-CC88-476A-AD1D-087C6DEE230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20906" y="2357992"/>
            <a:ext cx="722376" cy="501484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2781381" y="4333785"/>
            <a:ext cx="698372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Dormant tumor cells in the lungs or in the liver express PD-L1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ted neu+ FVS- viable dormant cells or CD3+ FVS- viable T cells in the lungs (A) or in the liver (B) of FVBN202 mice bearing primary mammary tumor without any treatment (Ctrl) as well as following chemotherapy (FAC) or chemoimmunotherapy (FAC/AIT) were analyzed for the expression of PD-L1 or PD-1, respectively.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519149" y="121812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9AB62B4-30B9-4568-95A8-8240561F7050}"/>
              </a:ext>
            </a:extLst>
          </p:cNvPr>
          <p:cNvSpPr txBox="1"/>
          <p:nvPr/>
        </p:nvSpPr>
        <p:spPr>
          <a:xfrm rot="16200000">
            <a:off x="4549849" y="2512637"/>
            <a:ext cx="756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PD-L1+ cell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BD6C112-F86D-4E8E-9D38-F6D4DA6C3180}"/>
              </a:ext>
            </a:extLst>
          </p:cNvPr>
          <p:cNvSpPr txBox="1"/>
          <p:nvPr/>
        </p:nvSpPr>
        <p:spPr>
          <a:xfrm>
            <a:off x="2678124" y="1625978"/>
            <a:ext cx="6351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A) Lung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8F55A2A-255E-4AA1-A12C-339B18161B8A}"/>
              </a:ext>
            </a:extLst>
          </p:cNvPr>
          <p:cNvSpPr txBox="1"/>
          <p:nvPr/>
        </p:nvSpPr>
        <p:spPr>
          <a:xfrm>
            <a:off x="3190517" y="1946107"/>
            <a:ext cx="1375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neu+ FVS- viable cell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E8AFE4D-D31B-4969-B5B0-0FFDAB40EFCB}"/>
              </a:ext>
            </a:extLst>
          </p:cNvPr>
          <p:cNvSpPr txBox="1"/>
          <p:nvPr/>
        </p:nvSpPr>
        <p:spPr>
          <a:xfrm>
            <a:off x="6237282" y="1625978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B) Liver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3BECF2F-3825-4A9C-87D4-7FAD892D23E9}"/>
              </a:ext>
            </a:extLst>
          </p:cNvPr>
          <p:cNvSpPr txBox="1"/>
          <p:nvPr/>
        </p:nvSpPr>
        <p:spPr>
          <a:xfrm>
            <a:off x="2853865" y="2920963"/>
            <a:ext cx="577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PD-L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4661220-B1AA-4F63-9993-9C8EBD05205C}"/>
              </a:ext>
            </a:extLst>
          </p:cNvPr>
          <p:cNvSpPr txBox="1"/>
          <p:nvPr/>
        </p:nvSpPr>
        <p:spPr>
          <a:xfrm rot="16200000">
            <a:off x="8022920" y="2488356"/>
            <a:ext cx="756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PD-L1+ cell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DCA63BA-98A6-47A6-905A-78B2135847FF}"/>
              </a:ext>
            </a:extLst>
          </p:cNvPr>
          <p:cNvSpPr txBox="1"/>
          <p:nvPr/>
        </p:nvSpPr>
        <p:spPr>
          <a:xfrm>
            <a:off x="6697607" y="1946107"/>
            <a:ext cx="1375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neu+ FVS- viable cell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2A1F9A0-492B-47FB-AAB9-F997D520F81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75952" y="2356708"/>
            <a:ext cx="722376" cy="50356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4EF3F5C-A424-4F2C-943F-4B840B29261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57061" y="3530906"/>
            <a:ext cx="744583" cy="54864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9CAABEA-8962-4C96-8C31-6D9F973998B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08292" y="2357992"/>
            <a:ext cx="722376" cy="52335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CC0E6BF7-3AD9-4D0D-9611-89931E329CF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31533" y="3530133"/>
            <a:ext cx="722376" cy="56429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AAF5F55-746F-4689-9BFD-7458C5A361A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986469" y="3529966"/>
            <a:ext cx="722376" cy="564461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83481CC2-671A-4A41-8BE2-5CB372209809}"/>
              </a:ext>
            </a:extLst>
          </p:cNvPr>
          <p:cNvSpPr txBox="1"/>
          <p:nvPr/>
        </p:nvSpPr>
        <p:spPr>
          <a:xfrm>
            <a:off x="3024219" y="2159909"/>
            <a:ext cx="393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Ctrl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3F68B5C-C248-4D83-8213-E7FFD894E8A5}"/>
              </a:ext>
            </a:extLst>
          </p:cNvPr>
          <p:cNvSpPr txBox="1"/>
          <p:nvPr/>
        </p:nvSpPr>
        <p:spPr>
          <a:xfrm>
            <a:off x="3705883" y="2159909"/>
            <a:ext cx="34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437AED8-97B2-430D-A52C-79F42568CE27}"/>
              </a:ext>
            </a:extLst>
          </p:cNvPr>
          <p:cNvSpPr txBox="1"/>
          <p:nvPr/>
        </p:nvSpPr>
        <p:spPr>
          <a:xfrm>
            <a:off x="4264836" y="2159909"/>
            <a:ext cx="5196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/AIT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CC2A8BF-6F06-485C-AF14-5CD1894AF051}"/>
              </a:ext>
            </a:extLst>
          </p:cNvPr>
          <p:cNvSpPr txBox="1"/>
          <p:nvPr/>
        </p:nvSpPr>
        <p:spPr>
          <a:xfrm>
            <a:off x="6527141" y="2153635"/>
            <a:ext cx="393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Ctrl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44C6924-62EB-401B-A6BB-0EDB06E80C27}"/>
              </a:ext>
            </a:extLst>
          </p:cNvPr>
          <p:cNvSpPr txBox="1"/>
          <p:nvPr/>
        </p:nvSpPr>
        <p:spPr>
          <a:xfrm>
            <a:off x="7184190" y="2153635"/>
            <a:ext cx="34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AFEF3EE-5B98-4D3E-976A-9598A678B11B}"/>
              </a:ext>
            </a:extLst>
          </p:cNvPr>
          <p:cNvSpPr txBox="1"/>
          <p:nvPr/>
        </p:nvSpPr>
        <p:spPr>
          <a:xfrm>
            <a:off x="7733337" y="2153734"/>
            <a:ext cx="5196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/AIT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DAACBE0-66E9-4941-83E5-3DFECF2012FE}"/>
              </a:ext>
            </a:extLst>
          </p:cNvPr>
          <p:cNvSpPr txBox="1"/>
          <p:nvPr/>
        </p:nvSpPr>
        <p:spPr>
          <a:xfrm>
            <a:off x="2985727" y="3327127"/>
            <a:ext cx="393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Ctrl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9449957-5C8C-480E-A2EF-3F434D7EE04C}"/>
              </a:ext>
            </a:extLst>
          </p:cNvPr>
          <p:cNvSpPr txBox="1"/>
          <p:nvPr/>
        </p:nvSpPr>
        <p:spPr>
          <a:xfrm>
            <a:off x="3684643" y="3327127"/>
            <a:ext cx="34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C6D4781-C9A9-4C98-B51C-8200FE9DE3F7}"/>
              </a:ext>
            </a:extLst>
          </p:cNvPr>
          <p:cNvSpPr txBox="1"/>
          <p:nvPr/>
        </p:nvSpPr>
        <p:spPr>
          <a:xfrm>
            <a:off x="4259755" y="3327226"/>
            <a:ext cx="5196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/AI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D1DC413-2F5D-4AE7-B1AD-EB6827869D57}"/>
              </a:ext>
            </a:extLst>
          </p:cNvPr>
          <p:cNvSpPr txBox="1"/>
          <p:nvPr/>
        </p:nvSpPr>
        <p:spPr>
          <a:xfrm>
            <a:off x="2837861" y="4061916"/>
            <a:ext cx="4329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PD-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7035596-9587-47AB-BA22-D6113F10E955}"/>
              </a:ext>
            </a:extLst>
          </p:cNvPr>
          <p:cNvSpPr txBox="1"/>
          <p:nvPr/>
        </p:nvSpPr>
        <p:spPr>
          <a:xfrm>
            <a:off x="3092849" y="3150737"/>
            <a:ext cx="14590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 FVS- viable T cell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ADF2817-E46F-4092-A0A3-6E10545AA991}"/>
              </a:ext>
            </a:extLst>
          </p:cNvPr>
          <p:cNvSpPr txBox="1"/>
          <p:nvPr/>
        </p:nvSpPr>
        <p:spPr>
          <a:xfrm>
            <a:off x="6528388" y="3325888"/>
            <a:ext cx="393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Ctrl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FED4864-F595-48F9-8DE7-B621D9AD895E}"/>
              </a:ext>
            </a:extLst>
          </p:cNvPr>
          <p:cNvSpPr txBox="1"/>
          <p:nvPr/>
        </p:nvSpPr>
        <p:spPr>
          <a:xfrm>
            <a:off x="7198385" y="3333698"/>
            <a:ext cx="34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95AD3A3-E199-4715-89FC-576906BE111D}"/>
              </a:ext>
            </a:extLst>
          </p:cNvPr>
          <p:cNvSpPr txBox="1"/>
          <p:nvPr/>
        </p:nvSpPr>
        <p:spPr>
          <a:xfrm>
            <a:off x="7765777" y="3333743"/>
            <a:ext cx="5196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FAC/AIT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FD1CA7F-CD88-490D-BD64-0E8C2CF8D77F}"/>
              </a:ext>
            </a:extLst>
          </p:cNvPr>
          <p:cNvSpPr txBox="1"/>
          <p:nvPr/>
        </p:nvSpPr>
        <p:spPr>
          <a:xfrm>
            <a:off x="6405373" y="4097227"/>
            <a:ext cx="468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PD-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EC3BD00-5539-4316-93B1-F5138874574D}"/>
              </a:ext>
            </a:extLst>
          </p:cNvPr>
          <p:cNvSpPr txBox="1"/>
          <p:nvPr/>
        </p:nvSpPr>
        <p:spPr>
          <a:xfrm>
            <a:off x="6691352" y="3150737"/>
            <a:ext cx="14590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 FVS- viable T cells</a:t>
            </a:r>
          </a:p>
        </p:txBody>
      </p:sp>
      <p:graphicFrame>
        <p:nvGraphicFramePr>
          <p:cNvPr id="43" name="Chart 42">
            <a:extLst>
              <a:ext uri="{FF2B5EF4-FFF2-40B4-BE49-F238E27FC236}">
                <a16:creationId xmlns:a16="http://schemas.microsoft.com/office/drawing/2014/main" id="{00000000-0008-0000-0700-0000B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5685913"/>
              </p:ext>
            </p:extLst>
          </p:nvPr>
        </p:nvGraphicFramePr>
        <p:xfrm>
          <a:off x="4994596" y="2179718"/>
          <a:ext cx="914400" cy="1097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4" name="Chart 43">
            <a:extLst>
              <a:ext uri="{FF2B5EF4-FFF2-40B4-BE49-F238E27FC236}">
                <a16:creationId xmlns:a16="http://schemas.microsoft.com/office/drawing/2014/main" id="{00000000-0008-0000-0700-000089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71923"/>
              </p:ext>
            </p:extLst>
          </p:nvPr>
        </p:nvGraphicFramePr>
        <p:xfrm>
          <a:off x="8475791" y="2148192"/>
          <a:ext cx="914400" cy="1097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9" name="Chart 48">
            <a:extLst>
              <a:ext uri="{FF2B5EF4-FFF2-40B4-BE49-F238E27FC236}">
                <a16:creationId xmlns:a16="http://schemas.microsoft.com/office/drawing/2014/main" id="{00000000-0008-0000-0700-00008E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5214210"/>
              </p:ext>
            </p:extLst>
          </p:nvPr>
        </p:nvGraphicFramePr>
        <p:xfrm>
          <a:off x="8518593" y="3258181"/>
          <a:ext cx="914400" cy="1097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52" name="Chart 51">
            <a:extLst>
              <a:ext uri="{FF2B5EF4-FFF2-40B4-BE49-F238E27FC236}">
                <a16:creationId xmlns:a16="http://schemas.microsoft.com/office/drawing/2014/main" id="{00000000-0008-0000-0700-0000B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0247903"/>
              </p:ext>
            </p:extLst>
          </p:nvPr>
        </p:nvGraphicFramePr>
        <p:xfrm>
          <a:off x="4988241" y="3255377"/>
          <a:ext cx="914400" cy="1097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53" name="TextBox 52">
            <a:extLst>
              <a:ext uri="{FF2B5EF4-FFF2-40B4-BE49-F238E27FC236}">
                <a16:creationId xmlns:a16="http://schemas.microsoft.com/office/drawing/2014/main" id="{A9AEAF35-2EE7-4EAB-ACD3-D43E903D501C}"/>
              </a:ext>
            </a:extLst>
          </p:cNvPr>
          <p:cNvSpPr txBox="1"/>
          <p:nvPr/>
        </p:nvSpPr>
        <p:spPr>
          <a:xfrm>
            <a:off x="5554405" y="3400063"/>
            <a:ext cx="323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1364AC7-E06F-4534-A1E2-E2DAF2C0202C}"/>
              </a:ext>
            </a:extLst>
          </p:cNvPr>
          <p:cNvSpPr txBox="1"/>
          <p:nvPr/>
        </p:nvSpPr>
        <p:spPr>
          <a:xfrm>
            <a:off x="5521182" y="2195600"/>
            <a:ext cx="359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57E11AD-3721-478F-AE06-77383250A55F}"/>
              </a:ext>
            </a:extLst>
          </p:cNvPr>
          <p:cNvSpPr txBox="1"/>
          <p:nvPr/>
        </p:nvSpPr>
        <p:spPr>
          <a:xfrm>
            <a:off x="8767425" y="2152000"/>
            <a:ext cx="2341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DBDF758-0A3F-4AA6-A401-F66F0738229F}"/>
              </a:ext>
            </a:extLst>
          </p:cNvPr>
          <p:cNvSpPr txBox="1"/>
          <p:nvPr/>
        </p:nvSpPr>
        <p:spPr>
          <a:xfrm rot="16200000">
            <a:off x="4562821" y="3574279"/>
            <a:ext cx="7857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PD-1+ T cells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E60E58D-9421-4489-A62E-FB0E90C9E87C}"/>
              </a:ext>
            </a:extLst>
          </p:cNvPr>
          <p:cNvSpPr txBox="1"/>
          <p:nvPr/>
        </p:nvSpPr>
        <p:spPr>
          <a:xfrm>
            <a:off x="6331367" y="2928986"/>
            <a:ext cx="577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PDL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DBDF758-0A3F-4AA6-A401-F66F0738229F}"/>
              </a:ext>
            </a:extLst>
          </p:cNvPr>
          <p:cNvSpPr txBox="1"/>
          <p:nvPr/>
        </p:nvSpPr>
        <p:spPr>
          <a:xfrm rot="16200000">
            <a:off x="8047233" y="3609408"/>
            <a:ext cx="7857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PD-1+ T cells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4684C60-6DB5-437A-8F99-446161A978EF}"/>
              </a:ext>
            </a:extLst>
          </p:cNvPr>
          <p:cNvCxnSpPr>
            <a:cxnSpLocks/>
          </p:cNvCxnSpPr>
          <p:nvPr/>
        </p:nvCxnSpPr>
        <p:spPr>
          <a:xfrm>
            <a:off x="5498760" y="2355132"/>
            <a:ext cx="29042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151B0A0C-ABC3-4261-85E0-6EC1F89A9CF0}"/>
              </a:ext>
            </a:extLst>
          </p:cNvPr>
          <p:cNvCxnSpPr>
            <a:cxnSpLocks/>
          </p:cNvCxnSpPr>
          <p:nvPr/>
        </p:nvCxnSpPr>
        <p:spPr>
          <a:xfrm>
            <a:off x="8735428" y="2319854"/>
            <a:ext cx="29042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A1AF243-7733-4059-B67A-967D267961A4}"/>
              </a:ext>
            </a:extLst>
          </p:cNvPr>
          <p:cNvCxnSpPr/>
          <p:nvPr/>
        </p:nvCxnSpPr>
        <p:spPr>
          <a:xfrm>
            <a:off x="5529808" y="3562229"/>
            <a:ext cx="290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59AF425F-D522-4DA1-A9ED-084F90DC456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814391" y="2355114"/>
            <a:ext cx="722376" cy="514233"/>
          </a:xfrm>
          <a:prstGeom prst="rect">
            <a:avLst/>
          </a:prstGeom>
        </p:spPr>
      </p:pic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6963FF31-A6A1-4066-9B1A-03F0586AE587}"/>
              </a:ext>
            </a:extLst>
          </p:cNvPr>
          <p:cNvCxnSpPr/>
          <p:nvPr/>
        </p:nvCxnSpPr>
        <p:spPr>
          <a:xfrm>
            <a:off x="2903175" y="2921005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9FBCD7D7-4744-4968-8153-E6B3E314B467}"/>
              </a:ext>
            </a:extLst>
          </p:cNvPr>
          <p:cNvCxnSpPr/>
          <p:nvPr/>
        </p:nvCxnSpPr>
        <p:spPr>
          <a:xfrm>
            <a:off x="6404613" y="2920963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14">
            <a:extLst>
              <a:ext uri="{FF2B5EF4-FFF2-40B4-BE49-F238E27FC236}">
                <a16:creationId xmlns:a16="http://schemas.microsoft.com/office/drawing/2014/main" id="{B59B0CEB-5337-4AB5-B2A7-B5A79817972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352754" y="3530906"/>
            <a:ext cx="722376" cy="56446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821D0ED-E06F-4174-8B52-6A8D758DB30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806661" y="3530906"/>
            <a:ext cx="718457" cy="548640"/>
          </a:xfrm>
          <a:prstGeom prst="rect">
            <a:avLst/>
          </a:prstGeom>
        </p:spPr>
      </p:pic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2FD47813-24FD-488E-AC50-64AB0A55AC29}"/>
              </a:ext>
            </a:extLst>
          </p:cNvPr>
          <p:cNvCxnSpPr/>
          <p:nvPr/>
        </p:nvCxnSpPr>
        <p:spPr>
          <a:xfrm>
            <a:off x="2888369" y="4098258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804B081A-ED7D-41E1-A6DA-1BEEF8416B42}"/>
              </a:ext>
            </a:extLst>
          </p:cNvPr>
          <p:cNvCxnSpPr/>
          <p:nvPr/>
        </p:nvCxnSpPr>
        <p:spPr>
          <a:xfrm>
            <a:off x="6440829" y="4100659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301286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4716948" y="3448044"/>
            <a:ext cx="303052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. Intravenous injection of MMC establishes mammary tumors in the lung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Female FVBN202 mice (8-10 weeks old, 3 mice) were challenged with Neu overexpressing MMC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.v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1 million cells/mouse). Animals were sacrificed upon &gt;10% weight loss and their lungs or liver were examined for palpable mammary tumors.  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98922" y="1733916"/>
            <a:ext cx="811251" cy="6858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36586" y="1733916"/>
            <a:ext cx="829985" cy="6858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92985" y="1733916"/>
            <a:ext cx="827177" cy="685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632EE7A-3B7C-49AE-AE05-05479693C1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98922" y="2560711"/>
            <a:ext cx="798272" cy="685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0D99559-424C-45C9-B942-B926C5086F1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26308" y="2578954"/>
            <a:ext cx="811802" cy="6858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FFD1210-A35D-492F-9472-683BAF9AC4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64027" y="2590980"/>
            <a:ext cx="816429" cy="6858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D6DF7C1-4DB1-4A33-8193-EAC84662C49B}"/>
              </a:ext>
            </a:extLst>
          </p:cNvPr>
          <p:cNvSpPr txBox="1"/>
          <p:nvPr/>
        </p:nvSpPr>
        <p:spPr>
          <a:xfrm rot="16200000">
            <a:off x="4481224" y="1953706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Lung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F35D3B3-0424-4648-A02B-25C166420610}"/>
              </a:ext>
            </a:extLst>
          </p:cNvPr>
          <p:cNvSpPr txBox="1"/>
          <p:nvPr/>
        </p:nvSpPr>
        <p:spPr>
          <a:xfrm rot="16200000">
            <a:off x="4506872" y="2705190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Liver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95291" y="1224951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igure 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71605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750FBAEA-5D4D-4FF1-B084-122CE1E880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11979" y="2113054"/>
            <a:ext cx="690342" cy="5486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84F530F-16E9-412D-B0F3-4E94C443FA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01644" y="2113752"/>
            <a:ext cx="690342" cy="5486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E795943-6D23-4265-871B-C982DCEBFF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24147" y="2101867"/>
            <a:ext cx="767423" cy="731520"/>
          </a:xfrm>
          <a:prstGeom prst="rect">
            <a:avLst/>
          </a:prstGeom>
        </p:spPr>
      </p:pic>
      <p:sp>
        <p:nvSpPr>
          <p:cNvPr id="26" name="TextBox 46"/>
          <p:cNvSpPr txBox="1"/>
          <p:nvPr/>
        </p:nvSpPr>
        <p:spPr>
          <a:xfrm>
            <a:off x="3556608" y="4313007"/>
            <a:ext cx="553659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4. Dormant tumor cells isolated from the lungs or liver of the FAC/AIT group show similar characteristic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) Dormant tumor cells (20X magnification) recovered from the lungs (R-FAC/AIT) or from the liver (R-FAC/AIT L) of FVBN202 mice bearing primary mammary tumor cells following FAC chemotherapy and AIT combined with anti-PD1 therapy. B) Gated FVS- viable cells were analyzed for the detection of neu+ cells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) Gated FVS- neu+ viable cells were analyzed for the expression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pCA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D) Gated FVS- viable cells were analyzed for the expression of CD44 and CD24. Data represents triplicates.</a:t>
            </a:r>
          </a:p>
          <a:p>
            <a:pPr algn="just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2DB7202-A128-4A56-9F30-7B5BCAEF9B14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2871" y="3080720"/>
            <a:ext cx="690880" cy="548640"/>
          </a:xfrm>
          <a:prstGeom prst="rect">
            <a:avLst/>
          </a:prstGeom>
        </p:spPr>
      </p:pic>
      <p:pic>
        <p:nvPicPr>
          <p:cNvPr id="37" name="Picture 10">
            <a:extLst>
              <a:ext uri="{FF2B5EF4-FFF2-40B4-BE49-F238E27FC236}">
                <a16:creationId xmlns:a16="http://schemas.microsoft.com/office/drawing/2014/main" id="{E07469C7-F988-4A8B-8093-9B7B05AEACC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2870" y="2182900"/>
            <a:ext cx="690880" cy="548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0A97FFB-A347-4309-87F2-98FE879CDB82}"/>
              </a:ext>
            </a:extLst>
          </p:cNvPr>
          <p:cNvSpPr txBox="1"/>
          <p:nvPr/>
        </p:nvSpPr>
        <p:spPr>
          <a:xfrm>
            <a:off x="3679268" y="1673089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0A97FFB-A347-4309-87F2-98FE879CDB82}"/>
              </a:ext>
            </a:extLst>
          </p:cNvPr>
          <p:cNvSpPr txBox="1"/>
          <p:nvPr/>
        </p:nvSpPr>
        <p:spPr>
          <a:xfrm>
            <a:off x="4578100" y="1673089"/>
            <a:ext cx="215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+mj-lt"/>
              </a:rPr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985845" y="102354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4</a:t>
            </a:r>
          </a:p>
        </p:txBody>
      </p:sp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CDFF1FBA-C7DC-481A-BB76-A4BA71545D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8680833"/>
              </p:ext>
            </p:extLst>
          </p:nvPr>
        </p:nvGraphicFramePr>
        <p:xfrm>
          <a:off x="6324907" y="2933198"/>
          <a:ext cx="9144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841713C2-A831-4EAD-A79D-DF50925BE7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9398141"/>
              </p:ext>
            </p:extLst>
          </p:nvPr>
        </p:nvGraphicFramePr>
        <p:xfrm>
          <a:off x="7994421" y="2987819"/>
          <a:ext cx="9144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ECD5582A-1499-4639-ABC7-E30617E992B7}"/>
              </a:ext>
            </a:extLst>
          </p:cNvPr>
          <p:cNvSpPr txBox="1"/>
          <p:nvPr/>
        </p:nvSpPr>
        <p:spPr>
          <a:xfrm>
            <a:off x="4636585" y="2648100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Neu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DFB8650-4F71-4138-BA4A-26245B34A04F}"/>
              </a:ext>
            </a:extLst>
          </p:cNvPr>
          <p:cNvSpPr txBox="1"/>
          <p:nvPr/>
        </p:nvSpPr>
        <p:spPr>
          <a:xfrm rot="16200000">
            <a:off x="4470191" y="3184786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neu+ cell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D635646-3094-44D4-8576-703F5BC69721}"/>
              </a:ext>
            </a:extLst>
          </p:cNvPr>
          <p:cNvSpPr txBox="1"/>
          <p:nvPr/>
        </p:nvSpPr>
        <p:spPr>
          <a:xfrm>
            <a:off x="6066688" y="2673010"/>
            <a:ext cx="4908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+mj-lt"/>
              </a:rPr>
              <a:t>EpCAM</a:t>
            </a:r>
            <a:endParaRPr lang="en-US" sz="800" dirty="0"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6BBE9EC-7B40-48AC-A5F4-7608EECD33F6}"/>
              </a:ext>
            </a:extLst>
          </p:cNvPr>
          <p:cNvSpPr txBox="1"/>
          <p:nvPr/>
        </p:nvSpPr>
        <p:spPr>
          <a:xfrm rot="16200000">
            <a:off x="7437346" y="2341368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2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6D0F47D-69CD-4614-9A67-41904C44D2F7}"/>
              </a:ext>
            </a:extLst>
          </p:cNvPr>
          <p:cNvSpPr txBox="1"/>
          <p:nvPr/>
        </p:nvSpPr>
        <p:spPr>
          <a:xfrm>
            <a:off x="7731718" y="2816744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44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74EF66F-8DCE-49CA-8EFC-25A37660A5F0}"/>
              </a:ext>
            </a:extLst>
          </p:cNvPr>
          <p:cNvSpPr txBox="1"/>
          <p:nvPr/>
        </p:nvSpPr>
        <p:spPr>
          <a:xfrm rot="16200000">
            <a:off x="5856385" y="3282387"/>
            <a:ext cx="8210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</a:t>
            </a:r>
            <a:r>
              <a:rPr lang="en-US" sz="800" dirty="0" err="1">
                <a:latin typeface="+mj-lt"/>
              </a:rPr>
              <a:t>EpCAM</a:t>
            </a:r>
            <a:r>
              <a:rPr lang="en-US" sz="800" dirty="0">
                <a:latin typeface="+mj-lt"/>
              </a:rPr>
              <a:t>+ cell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CB21ED7-05B2-431D-B519-BBE95EA62FCE}"/>
              </a:ext>
            </a:extLst>
          </p:cNvPr>
          <p:cNvSpPr txBox="1"/>
          <p:nvPr/>
        </p:nvSpPr>
        <p:spPr>
          <a:xfrm rot="16200000">
            <a:off x="7708018" y="3305195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 cell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6052860-AF7E-4940-9548-2DFF9F3B55A9}"/>
              </a:ext>
            </a:extLst>
          </p:cNvPr>
          <p:cNvSpPr txBox="1"/>
          <p:nvPr/>
        </p:nvSpPr>
        <p:spPr>
          <a:xfrm>
            <a:off x="6080705" y="1673089"/>
            <a:ext cx="215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+mj-lt"/>
              </a:rPr>
              <a:t>C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894ACF9-6B3D-45B8-B4F6-B84C9426E76B}"/>
              </a:ext>
            </a:extLst>
          </p:cNvPr>
          <p:cNvSpPr txBox="1"/>
          <p:nvPr/>
        </p:nvSpPr>
        <p:spPr>
          <a:xfrm>
            <a:off x="7691776" y="1673089"/>
            <a:ext cx="215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+mj-lt"/>
              </a:rPr>
              <a:t>D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4E03CDA-3782-4C34-BAD4-8FF5920BF3D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78100" y="2115274"/>
            <a:ext cx="690342" cy="548640"/>
          </a:xfrm>
          <a:prstGeom prst="rect">
            <a:avLst/>
          </a:prstGeom>
        </p:spPr>
      </p:pic>
      <p:graphicFrame>
        <p:nvGraphicFramePr>
          <p:cNvPr id="47" name="Chart 46">
            <a:extLst>
              <a:ext uri="{FF2B5EF4-FFF2-40B4-BE49-F238E27FC236}">
                <a16:creationId xmlns:a16="http://schemas.microsoft.com/office/drawing/2014/main" id="{A7FB42F5-5165-46E1-836B-79AF254D7B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6757823"/>
              </p:ext>
            </p:extLst>
          </p:nvPr>
        </p:nvGraphicFramePr>
        <p:xfrm>
          <a:off x="4872856" y="2847562"/>
          <a:ext cx="9144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pic>
        <p:nvPicPr>
          <p:cNvPr id="7" name="Picture 6">
            <a:extLst>
              <a:ext uri="{FF2B5EF4-FFF2-40B4-BE49-F238E27FC236}">
                <a16:creationId xmlns:a16="http://schemas.microsoft.com/office/drawing/2014/main" id="{DD95FB49-80D6-4082-9F51-02C4CCD33DE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093169" y="2111821"/>
            <a:ext cx="690342" cy="548640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ABD4EFC1-D88A-4764-946B-381D869D2EA5}"/>
              </a:ext>
            </a:extLst>
          </p:cNvPr>
          <p:cNvSpPr txBox="1"/>
          <p:nvPr/>
        </p:nvSpPr>
        <p:spPr>
          <a:xfrm>
            <a:off x="3719584" y="1960431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5B21E7F-C06C-43F1-AC73-F2B75E2B2C0E}"/>
              </a:ext>
            </a:extLst>
          </p:cNvPr>
          <p:cNvSpPr txBox="1"/>
          <p:nvPr/>
        </p:nvSpPr>
        <p:spPr>
          <a:xfrm>
            <a:off x="3683413" y="2857067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A2C1E85-6C21-45D9-AB86-3714B795FB47}"/>
              </a:ext>
            </a:extLst>
          </p:cNvPr>
          <p:cNvSpPr txBox="1"/>
          <p:nvPr/>
        </p:nvSpPr>
        <p:spPr>
          <a:xfrm>
            <a:off x="4650386" y="1917984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9A56B45-F19E-4419-A833-EF9B5EA2EE69}"/>
              </a:ext>
            </a:extLst>
          </p:cNvPr>
          <p:cNvSpPr txBox="1"/>
          <p:nvPr/>
        </p:nvSpPr>
        <p:spPr>
          <a:xfrm>
            <a:off x="5249486" y="1911078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61F113E-A549-4A3E-9623-9478BE558020}"/>
              </a:ext>
            </a:extLst>
          </p:cNvPr>
          <p:cNvSpPr txBox="1"/>
          <p:nvPr/>
        </p:nvSpPr>
        <p:spPr>
          <a:xfrm>
            <a:off x="6135324" y="1917678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94E9843-E4AE-4B83-91EE-68AF8599241F}"/>
              </a:ext>
            </a:extLst>
          </p:cNvPr>
          <p:cNvSpPr txBox="1"/>
          <p:nvPr/>
        </p:nvSpPr>
        <p:spPr>
          <a:xfrm>
            <a:off x="6751676" y="1919398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2BD8C03-131E-44C9-9454-724B8CB9279E}"/>
              </a:ext>
            </a:extLst>
          </p:cNvPr>
          <p:cNvSpPr txBox="1"/>
          <p:nvPr/>
        </p:nvSpPr>
        <p:spPr>
          <a:xfrm>
            <a:off x="7774862" y="1912714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77E8106-70B2-4308-8613-D2E5C48EDB76}"/>
              </a:ext>
            </a:extLst>
          </p:cNvPr>
          <p:cNvSpPr txBox="1"/>
          <p:nvPr/>
        </p:nvSpPr>
        <p:spPr>
          <a:xfrm>
            <a:off x="8532489" y="1911127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F8E9718-8405-4014-924E-28D1F72DC63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680200" y="2101867"/>
            <a:ext cx="771421" cy="731520"/>
          </a:xfrm>
          <a:prstGeom prst="rect">
            <a:avLst/>
          </a:prstGeom>
        </p:spPr>
      </p:pic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0A05DF76-F7D8-4764-87AA-2262CCF91670}"/>
              </a:ext>
            </a:extLst>
          </p:cNvPr>
          <p:cNvCxnSpPr/>
          <p:nvPr/>
        </p:nvCxnSpPr>
        <p:spPr>
          <a:xfrm>
            <a:off x="4650386" y="2669087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F796B927-6947-446E-B4F6-F085F95DC0F0}"/>
              </a:ext>
            </a:extLst>
          </p:cNvPr>
          <p:cNvCxnSpPr/>
          <p:nvPr/>
        </p:nvCxnSpPr>
        <p:spPr>
          <a:xfrm>
            <a:off x="6135324" y="2669087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61CBFDFA-DCF1-49D7-A88B-3099647BE46A}"/>
              </a:ext>
            </a:extLst>
          </p:cNvPr>
          <p:cNvCxnSpPr/>
          <p:nvPr/>
        </p:nvCxnSpPr>
        <p:spPr>
          <a:xfrm>
            <a:off x="7763028" y="2821411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322692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1E29596E-F1E6-42D9-A376-53D868B031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57337" y="5601645"/>
            <a:ext cx="752421" cy="73152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E92DB38-031F-40BF-A6C3-6A668FB9CC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57337" y="3950525"/>
            <a:ext cx="768897" cy="73152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30A142F-2617-49E1-A883-DBBC04B43A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90747" y="5493071"/>
            <a:ext cx="658796" cy="64008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D82EE38-D812-4AEA-A424-C39CD36FE4F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27129" y="3358074"/>
            <a:ext cx="640080" cy="640080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DCF43CBB-BF7F-477A-83F5-F1EB304FADBA}"/>
              </a:ext>
            </a:extLst>
          </p:cNvPr>
          <p:cNvSpPr txBox="1"/>
          <p:nvPr/>
        </p:nvSpPr>
        <p:spPr>
          <a:xfrm rot="16200000">
            <a:off x="2812833" y="1194706"/>
            <a:ext cx="10775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Tumor volume (mm</a:t>
            </a:r>
            <a:r>
              <a:rPr lang="en-US" sz="800" baseline="30000" dirty="0">
                <a:latin typeface="+mj-lt"/>
              </a:rPr>
              <a:t>3</a:t>
            </a:r>
            <a:r>
              <a:rPr lang="en-US" sz="800" dirty="0">
                <a:latin typeface="+mj-lt"/>
              </a:rPr>
              <a:t>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0A97FFB-A347-4309-87F2-98FE879CDB82}"/>
              </a:ext>
            </a:extLst>
          </p:cNvPr>
          <p:cNvSpPr txBox="1"/>
          <p:nvPr/>
        </p:nvSpPr>
        <p:spPr>
          <a:xfrm>
            <a:off x="3218134" y="270155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088A8BB-3C22-4323-9717-D2438215469B}"/>
              </a:ext>
            </a:extLst>
          </p:cNvPr>
          <p:cNvSpPr txBox="1"/>
          <p:nvPr/>
        </p:nvSpPr>
        <p:spPr>
          <a:xfrm>
            <a:off x="2695785" y="2683755"/>
            <a:ext cx="14189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B) Lungs: dormant cell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1528848-8D61-4990-862E-4D3F970F0FD2}"/>
              </a:ext>
            </a:extLst>
          </p:cNvPr>
          <p:cNvSpPr txBox="1"/>
          <p:nvPr/>
        </p:nvSpPr>
        <p:spPr>
          <a:xfrm>
            <a:off x="6264972" y="236825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C) Lungs: T cells</a:t>
            </a:r>
          </a:p>
        </p:txBody>
      </p:sp>
      <p:graphicFrame>
        <p:nvGraphicFramePr>
          <p:cNvPr id="83" name="Chart 82">
            <a:extLst>
              <a:ext uri="{FF2B5EF4-FFF2-40B4-BE49-F238E27FC236}">
                <a16:creationId xmlns:a16="http://schemas.microsoft.com/office/drawing/2014/main" id="{00000000-0008-0000-0700-0000FB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6974204"/>
              </p:ext>
            </p:extLst>
          </p:nvPr>
        </p:nvGraphicFramePr>
        <p:xfrm>
          <a:off x="3470289" y="730942"/>
          <a:ext cx="13716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107923" y="23933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5</a:t>
            </a:r>
          </a:p>
        </p:txBody>
      </p:sp>
      <p:graphicFrame>
        <p:nvGraphicFramePr>
          <p:cNvPr id="95" name="Chart 94">
            <a:extLst>
              <a:ext uri="{FF2B5EF4-FFF2-40B4-BE49-F238E27FC236}">
                <a16:creationId xmlns:a16="http://schemas.microsoft.com/office/drawing/2014/main" id="{00000000-0008-0000-0700-00001201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9654226"/>
              </p:ext>
            </p:extLst>
          </p:nvPr>
        </p:nvGraphicFramePr>
        <p:xfrm>
          <a:off x="2798311" y="3061907"/>
          <a:ext cx="68580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6" name="Chart 95">
            <a:extLst>
              <a:ext uri="{FF2B5EF4-FFF2-40B4-BE49-F238E27FC236}">
                <a16:creationId xmlns:a16="http://schemas.microsoft.com/office/drawing/2014/main" id="{00000000-0008-0000-0700-00001401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4403198"/>
              </p:ext>
            </p:extLst>
          </p:nvPr>
        </p:nvGraphicFramePr>
        <p:xfrm>
          <a:off x="5122021" y="3065869"/>
          <a:ext cx="73152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00" name="TextBox 99">
            <a:extLst>
              <a:ext uri="{FF2B5EF4-FFF2-40B4-BE49-F238E27FC236}">
                <a16:creationId xmlns:a16="http://schemas.microsoft.com/office/drawing/2014/main" id="{52BC9C06-FFCD-40C6-9F7A-DD3448A79B05}"/>
              </a:ext>
            </a:extLst>
          </p:cNvPr>
          <p:cNvSpPr txBox="1"/>
          <p:nvPr/>
        </p:nvSpPr>
        <p:spPr>
          <a:xfrm rot="16200000">
            <a:off x="2390536" y="3337547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Total neu+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E7E4A7A4-2446-4B2B-8808-443AFFDCA0A9}"/>
              </a:ext>
            </a:extLst>
          </p:cNvPr>
          <p:cNvSpPr txBox="1"/>
          <p:nvPr/>
        </p:nvSpPr>
        <p:spPr>
          <a:xfrm>
            <a:off x="3752385" y="2951786"/>
            <a:ext cx="1165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neu+ viable cells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47BDECF-0BF3-476F-96C1-528B90E55BA2}"/>
              </a:ext>
            </a:extLst>
          </p:cNvPr>
          <p:cNvSpPr txBox="1"/>
          <p:nvPr/>
        </p:nvSpPr>
        <p:spPr>
          <a:xfrm>
            <a:off x="3739661" y="3161998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F6149B6-E9EC-407F-9BCD-AFA06F6632BD}"/>
              </a:ext>
            </a:extLst>
          </p:cNvPr>
          <p:cNvSpPr txBox="1"/>
          <p:nvPr/>
        </p:nvSpPr>
        <p:spPr>
          <a:xfrm>
            <a:off x="4314119" y="3163527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2A549B0F-B495-45FE-B3ED-24A3BE9C951F}"/>
              </a:ext>
            </a:extLst>
          </p:cNvPr>
          <p:cNvSpPr txBox="1"/>
          <p:nvPr/>
        </p:nvSpPr>
        <p:spPr>
          <a:xfrm rot="16200000">
            <a:off x="4955917" y="3354361"/>
            <a:ext cx="2792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 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77948ED-B9FA-49B8-84E0-6464B694249C}"/>
              </a:ext>
            </a:extLst>
          </p:cNvPr>
          <p:cNvSpPr txBox="1"/>
          <p:nvPr/>
        </p:nvSpPr>
        <p:spPr>
          <a:xfrm>
            <a:off x="2695785" y="4757699"/>
            <a:ext cx="1378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D) Liver: dormant cells</a:t>
            </a:r>
          </a:p>
        </p:txBody>
      </p:sp>
      <p:graphicFrame>
        <p:nvGraphicFramePr>
          <p:cNvPr id="113" name="Chart 112">
            <a:extLst>
              <a:ext uri="{FF2B5EF4-FFF2-40B4-BE49-F238E27FC236}">
                <a16:creationId xmlns:a16="http://schemas.microsoft.com/office/drawing/2014/main" id="{00000000-0008-0000-0700-00000301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831169"/>
              </p:ext>
            </p:extLst>
          </p:nvPr>
        </p:nvGraphicFramePr>
        <p:xfrm>
          <a:off x="2788725" y="5118180"/>
          <a:ext cx="681564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14" name="TextBox 113">
            <a:extLst>
              <a:ext uri="{FF2B5EF4-FFF2-40B4-BE49-F238E27FC236}">
                <a16:creationId xmlns:a16="http://schemas.microsoft.com/office/drawing/2014/main" id="{75382D2F-E174-4799-AE26-801A8819F133}"/>
              </a:ext>
            </a:extLst>
          </p:cNvPr>
          <p:cNvSpPr txBox="1"/>
          <p:nvPr/>
        </p:nvSpPr>
        <p:spPr>
          <a:xfrm rot="16200000">
            <a:off x="2414856" y="5474031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Total neu+</a:t>
            </a:r>
          </a:p>
        </p:txBody>
      </p:sp>
      <p:graphicFrame>
        <p:nvGraphicFramePr>
          <p:cNvPr id="118" name="Chart 117">
            <a:extLst>
              <a:ext uri="{FF2B5EF4-FFF2-40B4-BE49-F238E27FC236}">
                <a16:creationId xmlns:a16="http://schemas.microsoft.com/office/drawing/2014/main" id="{7763F6D5-054F-4201-A214-F585EC23A5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1808348"/>
              </p:ext>
            </p:extLst>
          </p:nvPr>
        </p:nvGraphicFramePr>
        <p:xfrm>
          <a:off x="5126355" y="5179476"/>
          <a:ext cx="73152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19" name="TextBox 118">
            <a:extLst>
              <a:ext uri="{FF2B5EF4-FFF2-40B4-BE49-F238E27FC236}">
                <a16:creationId xmlns:a16="http://schemas.microsoft.com/office/drawing/2014/main" id="{41725EE5-9FBA-45F1-8F9A-65215958AB23}"/>
              </a:ext>
            </a:extLst>
          </p:cNvPr>
          <p:cNvSpPr txBox="1"/>
          <p:nvPr/>
        </p:nvSpPr>
        <p:spPr>
          <a:xfrm rot="16200000">
            <a:off x="4940615" y="5538633"/>
            <a:ext cx="2792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 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805D1D13-37E9-4125-A944-103878940582}"/>
              </a:ext>
            </a:extLst>
          </p:cNvPr>
          <p:cNvSpPr txBox="1"/>
          <p:nvPr/>
        </p:nvSpPr>
        <p:spPr>
          <a:xfrm rot="16200000">
            <a:off x="6039480" y="853185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4+ T cells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D8D3C822-FB88-4841-A0D7-E01CD6AE7072}"/>
              </a:ext>
            </a:extLst>
          </p:cNvPr>
          <p:cNvSpPr txBox="1"/>
          <p:nvPr/>
        </p:nvSpPr>
        <p:spPr>
          <a:xfrm rot="16200000">
            <a:off x="6039480" y="2144066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8+ T cells</a:t>
            </a:r>
          </a:p>
        </p:txBody>
      </p:sp>
      <p:graphicFrame>
        <p:nvGraphicFramePr>
          <p:cNvPr id="126" name="Chart 125">
            <a:extLst>
              <a:ext uri="{FF2B5EF4-FFF2-40B4-BE49-F238E27FC236}">
                <a16:creationId xmlns:a16="http://schemas.microsoft.com/office/drawing/2014/main" id="{00000000-0008-0000-0700-00001F01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532018"/>
              </p:ext>
            </p:extLst>
          </p:nvPr>
        </p:nvGraphicFramePr>
        <p:xfrm>
          <a:off x="6508810" y="474077"/>
          <a:ext cx="82296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27" name="Chart 126">
            <a:extLst>
              <a:ext uri="{FF2B5EF4-FFF2-40B4-BE49-F238E27FC236}">
                <a16:creationId xmlns:a16="http://schemas.microsoft.com/office/drawing/2014/main" id="{00000000-0008-0000-0700-00002001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6024594"/>
              </p:ext>
            </p:extLst>
          </p:nvPr>
        </p:nvGraphicFramePr>
        <p:xfrm>
          <a:off x="6508810" y="1879528"/>
          <a:ext cx="82296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31" name="TextBox 130">
            <a:extLst>
              <a:ext uri="{FF2B5EF4-FFF2-40B4-BE49-F238E27FC236}">
                <a16:creationId xmlns:a16="http://schemas.microsoft.com/office/drawing/2014/main" id="{6ADB22F6-2CB2-4CD6-9976-855DCAD789F2}"/>
              </a:ext>
            </a:extLst>
          </p:cNvPr>
          <p:cNvSpPr txBox="1"/>
          <p:nvPr/>
        </p:nvSpPr>
        <p:spPr>
          <a:xfrm>
            <a:off x="7663066" y="319337"/>
            <a:ext cx="1191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CD4+ T cells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E507D13B-515D-4DCC-BBC2-844A00C43827}"/>
              </a:ext>
            </a:extLst>
          </p:cNvPr>
          <p:cNvSpPr txBox="1"/>
          <p:nvPr/>
        </p:nvSpPr>
        <p:spPr>
          <a:xfrm rot="16200000">
            <a:off x="8588139" y="881442"/>
            <a:ext cx="10518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4+ T cell subsets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058F1F5-B904-4E62-A8C1-0AC521D5B96F}"/>
              </a:ext>
            </a:extLst>
          </p:cNvPr>
          <p:cNvSpPr txBox="1"/>
          <p:nvPr/>
        </p:nvSpPr>
        <p:spPr>
          <a:xfrm>
            <a:off x="7654548" y="1830129"/>
            <a:ext cx="11769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CD8+ T cells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768444AC-8C38-49E1-968C-EEC24F99B7CB}"/>
              </a:ext>
            </a:extLst>
          </p:cNvPr>
          <p:cNvSpPr txBox="1"/>
          <p:nvPr/>
        </p:nvSpPr>
        <p:spPr>
          <a:xfrm rot="16200000">
            <a:off x="7226827" y="1087455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44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22F71FA0-766A-46DA-9464-AC7697EB1CE5}"/>
              </a:ext>
            </a:extLst>
          </p:cNvPr>
          <p:cNvSpPr txBox="1"/>
          <p:nvPr/>
        </p:nvSpPr>
        <p:spPr>
          <a:xfrm>
            <a:off x="6264972" y="3387183"/>
            <a:ext cx="9621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E) Liver: T cells</a:t>
            </a:r>
          </a:p>
        </p:txBody>
      </p:sp>
      <p:graphicFrame>
        <p:nvGraphicFramePr>
          <p:cNvPr id="141" name="Chart 140">
            <a:extLst>
              <a:ext uri="{FF2B5EF4-FFF2-40B4-BE49-F238E27FC236}">
                <a16:creationId xmlns:a16="http://schemas.microsoft.com/office/drawing/2014/main" id="{00000000-0008-0000-0700-00001F01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3839950"/>
              </p:ext>
            </p:extLst>
          </p:nvPr>
        </p:nvGraphicFramePr>
        <p:xfrm>
          <a:off x="6508810" y="3627330"/>
          <a:ext cx="82296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142" name="TextBox 141">
            <a:extLst>
              <a:ext uri="{FF2B5EF4-FFF2-40B4-BE49-F238E27FC236}">
                <a16:creationId xmlns:a16="http://schemas.microsoft.com/office/drawing/2014/main" id="{AC7D4F49-A275-4636-ACF0-8C1E7ACA2522}"/>
              </a:ext>
            </a:extLst>
          </p:cNvPr>
          <p:cNvSpPr txBox="1"/>
          <p:nvPr/>
        </p:nvSpPr>
        <p:spPr>
          <a:xfrm rot="16200000">
            <a:off x="6039480" y="4054518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4+ T cells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66E107D7-BE87-4BA1-A1A5-8A6FF7997271}"/>
              </a:ext>
            </a:extLst>
          </p:cNvPr>
          <p:cNvSpPr txBox="1"/>
          <p:nvPr/>
        </p:nvSpPr>
        <p:spPr>
          <a:xfrm rot="16200000">
            <a:off x="6039480" y="5608398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8+ T cells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3B6F3D09-BAA2-4597-AAD8-9634A8615FCE}"/>
              </a:ext>
            </a:extLst>
          </p:cNvPr>
          <p:cNvSpPr txBox="1"/>
          <p:nvPr/>
        </p:nvSpPr>
        <p:spPr>
          <a:xfrm>
            <a:off x="7618067" y="3528435"/>
            <a:ext cx="1191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CD4+ T cells</a:t>
            </a:r>
          </a:p>
        </p:txBody>
      </p:sp>
      <p:graphicFrame>
        <p:nvGraphicFramePr>
          <p:cNvPr id="147" name="Chart 146">
            <a:extLst>
              <a:ext uri="{FF2B5EF4-FFF2-40B4-BE49-F238E27FC236}">
                <a16:creationId xmlns:a16="http://schemas.microsoft.com/office/drawing/2014/main" id="{00000000-0008-0000-0700-00002001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6695675"/>
              </p:ext>
            </p:extLst>
          </p:nvPr>
        </p:nvGraphicFramePr>
        <p:xfrm>
          <a:off x="6508810" y="5200720"/>
          <a:ext cx="82296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48" name="TextBox 147">
            <a:extLst>
              <a:ext uri="{FF2B5EF4-FFF2-40B4-BE49-F238E27FC236}">
                <a16:creationId xmlns:a16="http://schemas.microsoft.com/office/drawing/2014/main" id="{DEE0A8C4-D24E-4A6D-AC93-C047D3A9E264}"/>
              </a:ext>
            </a:extLst>
          </p:cNvPr>
          <p:cNvSpPr txBox="1"/>
          <p:nvPr/>
        </p:nvSpPr>
        <p:spPr>
          <a:xfrm>
            <a:off x="7628506" y="5200720"/>
            <a:ext cx="11769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CD8+ T cells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563E269-2D2B-4419-A5C0-E247522E50E9}"/>
              </a:ext>
            </a:extLst>
          </p:cNvPr>
          <p:cNvSpPr txBox="1"/>
          <p:nvPr/>
        </p:nvSpPr>
        <p:spPr>
          <a:xfrm>
            <a:off x="3222501" y="308279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*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5B6C925-488E-4CDC-9438-2E96B3BAEC60}"/>
              </a:ext>
            </a:extLst>
          </p:cNvPr>
          <p:cNvSpPr txBox="1"/>
          <p:nvPr/>
        </p:nvSpPr>
        <p:spPr>
          <a:xfrm>
            <a:off x="5660501" y="3335353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3D52F2E-060A-41FD-8964-CD353C041133}"/>
              </a:ext>
            </a:extLst>
          </p:cNvPr>
          <p:cNvSpPr txBox="1"/>
          <p:nvPr/>
        </p:nvSpPr>
        <p:spPr>
          <a:xfrm>
            <a:off x="3212437" y="5318024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*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A9E0AE1-55A0-4D2D-970A-75B1EA3EA110}"/>
              </a:ext>
            </a:extLst>
          </p:cNvPr>
          <p:cNvSpPr txBox="1"/>
          <p:nvPr/>
        </p:nvSpPr>
        <p:spPr>
          <a:xfrm>
            <a:off x="3725214" y="5361339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843681B-1D23-4C08-837B-E4CA44C2E4AF}"/>
              </a:ext>
            </a:extLst>
          </p:cNvPr>
          <p:cNvSpPr txBox="1"/>
          <p:nvPr/>
        </p:nvSpPr>
        <p:spPr>
          <a:xfrm>
            <a:off x="4535229" y="135605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*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1C2370D-49F1-4F2E-AA54-3FDC8B658920}"/>
              </a:ext>
            </a:extLst>
          </p:cNvPr>
          <p:cNvSpPr txBox="1"/>
          <p:nvPr/>
        </p:nvSpPr>
        <p:spPr>
          <a:xfrm>
            <a:off x="4156089" y="2015135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Days</a:t>
            </a:r>
          </a:p>
        </p:txBody>
      </p:sp>
      <p:graphicFrame>
        <p:nvGraphicFramePr>
          <p:cNvPr id="86" name="Chart 85">
            <a:extLst>
              <a:ext uri="{FF2B5EF4-FFF2-40B4-BE49-F238E27FC236}">
                <a16:creationId xmlns:a16="http://schemas.microsoft.com/office/drawing/2014/main" id="{123292FE-6578-4EAD-9A15-8A280DC0AB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4606113"/>
              </p:ext>
            </p:extLst>
          </p:nvPr>
        </p:nvGraphicFramePr>
        <p:xfrm>
          <a:off x="9221807" y="3609131"/>
          <a:ext cx="1095858" cy="1579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106" name="TextBox 105">
            <a:extLst>
              <a:ext uri="{FF2B5EF4-FFF2-40B4-BE49-F238E27FC236}">
                <a16:creationId xmlns:a16="http://schemas.microsoft.com/office/drawing/2014/main" id="{187B96AB-666A-404E-884A-0E87BD415B65}"/>
              </a:ext>
            </a:extLst>
          </p:cNvPr>
          <p:cNvSpPr txBox="1"/>
          <p:nvPr/>
        </p:nvSpPr>
        <p:spPr>
          <a:xfrm>
            <a:off x="9448632" y="383224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**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87B96AB-666A-404E-884A-0E87BD415B65}"/>
              </a:ext>
            </a:extLst>
          </p:cNvPr>
          <p:cNvSpPr txBox="1"/>
          <p:nvPr/>
        </p:nvSpPr>
        <p:spPr>
          <a:xfrm>
            <a:off x="9718574" y="4206933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</a:t>
            </a:r>
          </a:p>
        </p:txBody>
      </p:sp>
      <p:cxnSp>
        <p:nvCxnSpPr>
          <p:cNvPr id="108" name="Straight Connector 107"/>
          <p:cNvCxnSpPr/>
          <p:nvPr/>
        </p:nvCxnSpPr>
        <p:spPr>
          <a:xfrm>
            <a:off x="9748714" y="4338992"/>
            <a:ext cx="1671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9" name="Chart 108">
            <a:extLst>
              <a:ext uri="{FF2B5EF4-FFF2-40B4-BE49-F238E27FC236}">
                <a16:creationId xmlns:a16="http://schemas.microsoft.com/office/drawing/2014/main" id="{0F9D792A-29B0-4227-A6B0-491D00C952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0635990"/>
              </p:ext>
            </p:extLst>
          </p:nvPr>
        </p:nvGraphicFramePr>
        <p:xfrm>
          <a:off x="9230599" y="5151685"/>
          <a:ext cx="1097516" cy="15795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111" name="TextBox 110">
            <a:extLst>
              <a:ext uri="{FF2B5EF4-FFF2-40B4-BE49-F238E27FC236}">
                <a16:creationId xmlns:a16="http://schemas.microsoft.com/office/drawing/2014/main" id="{187B96AB-666A-404E-884A-0E87BD415B65}"/>
              </a:ext>
            </a:extLst>
          </p:cNvPr>
          <p:cNvSpPr txBox="1"/>
          <p:nvPr/>
        </p:nvSpPr>
        <p:spPr>
          <a:xfrm>
            <a:off x="9476505" y="5768918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</a:t>
            </a:r>
          </a:p>
        </p:txBody>
      </p:sp>
      <p:cxnSp>
        <p:nvCxnSpPr>
          <p:cNvPr id="112" name="Straight Connector 111"/>
          <p:cNvCxnSpPr/>
          <p:nvPr/>
        </p:nvCxnSpPr>
        <p:spPr>
          <a:xfrm>
            <a:off x="9506645" y="5900977"/>
            <a:ext cx="1671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187B96AB-666A-404E-884A-0E87BD415B65}"/>
              </a:ext>
            </a:extLst>
          </p:cNvPr>
          <p:cNvSpPr txBox="1"/>
          <p:nvPr/>
        </p:nvSpPr>
        <p:spPr>
          <a:xfrm>
            <a:off x="10117865" y="592685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*</a:t>
            </a:r>
          </a:p>
        </p:txBody>
      </p:sp>
      <p:cxnSp>
        <p:nvCxnSpPr>
          <p:cNvPr id="117" name="Straight Connector 116"/>
          <p:cNvCxnSpPr/>
          <p:nvPr/>
        </p:nvCxnSpPr>
        <p:spPr>
          <a:xfrm>
            <a:off x="10148005" y="6058914"/>
            <a:ext cx="1671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20" name="Chart 119">
            <a:extLst>
              <a:ext uri="{FF2B5EF4-FFF2-40B4-BE49-F238E27FC236}">
                <a16:creationId xmlns:a16="http://schemas.microsoft.com/office/drawing/2014/main" id="{32200DCE-D054-417B-90EC-60B18A3BF9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4014918"/>
              </p:ext>
            </p:extLst>
          </p:nvPr>
        </p:nvGraphicFramePr>
        <p:xfrm>
          <a:off x="9162769" y="343264"/>
          <a:ext cx="1101093" cy="1589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121" name="TextBox 120">
            <a:extLst>
              <a:ext uri="{FF2B5EF4-FFF2-40B4-BE49-F238E27FC236}">
                <a16:creationId xmlns:a16="http://schemas.microsoft.com/office/drawing/2014/main" id="{187B96AB-666A-404E-884A-0E87BD415B65}"/>
              </a:ext>
            </a:extLst>
          </p:cNvPr>
          <p:cNvSpPr txBox="1"/>
          <p:nvPr/>
        </p:nvSpPr>
        <p:spPr>
          <a:xfrm>
            <a:off x="9614529" y="80449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**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187B96AB-666A-404E-884A-0E87BD415B65}"/>
              </a:ext>
            </a:extLst>
          </p:cNvPr>
          <p:cNvSpPr txBox="1"/>
          <p:nvPr/>
        </p:nvSpPr>
        <p:spPr>
          <a:xfrm>
            <a:off x="9415561" y="621620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</a:t>
            </a:r>
          </a:p>
        </p:txBody>
      </p:sp>
      <p:graphicFrame>
        <p:nvGraphicFramePr>
          <p:cNvPr id="123" name="Chart 122">
            <a:extLst>
              <a:ext uri="{FF2B5EF4-FFF2-40B4-BE49-F238E27FC236}">
                <a16:creationId xmlns:a16="http://schemas.microsoft.com/office/drawing/2014/main" id="{582EFA36-8BA1-484E-879F-CBF4D9597E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9811611"/>
              </p:ext>
            </p:extLst>
          </p:nvPr>
        </p:nvGraphicFramePr>
        <p:xfrm>
          <a:off x="9171287" y="1890924"/>
          <a:ext cx="1104628" cy="15691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139" name="TextBox 138">
            <a:extLst>
              <a:ext uri="{FF2B5EF4-FFF2-40B4-BE49-F238E27FC236}">
                <a16:creationId xmlns:a16="http://schemas.microsoft.com/office/drawing/2014/main" id="{187B96AB-666A-404E-884A-0E87BD415B65}"/>
              </a:ext>
            </a:extLst>
          </p:cNvPr>
          <p:cNvSpPr txBox="1"/>
          <p:nvPr/>
        </p:nvSpPr>
        <p:spPr>
          <a:xfrm>
            <a:off x="9416995" y="2577899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187B96AB-666A-404E-884A-0E87BD415B65}"/>
              </a:ext>
            </a:extLst>
          </p:cNvPr>
          <p:cNvSpPr txBox="1"/>
          <p:nvPr/>
        </p:nvSpPr>
        <p:spPr>
          <a:xfrm>
            <a:off x="10078628" y="2603777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</a:t>
            </a:r>
          </a:p>
        </p:txBody>
      </p:sp>
      <p:cxnSp>
        <p:nvCxnSpPr>
          <p:cNvPr id="155" name="Straight Connector 154"/>
          <p:cNvCxnSpPr/>
          <p:nvPr/>
        </p:nvCxnSpPr>
        <p:spPr>
          <a:xfrm>
            <a:off x="9450065" y="746688"/>
            <a:ext cx="1671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/>
          <p:cNvCxnSpPr/>
          <p:nvPr/>
        </p:nvCxnSpPr>
        <p:spPr>
          <a:xfrm>
            <a:off x="9681025" y="930340"/>
            <a:ext cx="1671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/>
          <p:cNvCxnSpPr/>
          <p:nvPr/>
        </p:nvCxnSpPr>
        <p:spPr>
          <a:xfrm>
            <a:off x="9448543" y="2708189"/>
            <a:ext cx="1671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/>
          <p:cNvCxnSpPr/>
          <p:nvPr/>
        </p:nvCxnSpPr>
        <p:spPr>
          <a:xfrm>
            <a:off x="10106637" y="2738740"/>
            <a:ext cx="1671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/>
          <p:cNvCxnSpPr/>
          <p:nvPr/>
        </p:nvCxnSpPr>
        <p:spPr>
          <a:xfrm>
            <a:off x="9515113" y="3963738"/>
            <a:ext cx="1671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:a16="http://schemas.microsoft.com/office/drawing/2014/main" id="{247BDECF-0BF3-476F-96C1-528B90E55BA2}"/>
              </a:ext>
            </a:extLst>
          </p:cNvPr>
          <p:cNvSpPr txBox="1"/>
          <p:nvPr/>
        </p:nvSpPr>
        <p:spPr>
          <a:xfrm>
            <a:off x="7581199" y="523548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-FAC/AIT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AF6149B6-E9EC-407F-9BCD-AFA06F6632BD}"/>
              </a:ext>
            </a:extLst>
          </p:cNvPr>
          <p:cNvSpPr txBox="1"/>
          <p:nvPr/>
        </p:nvSpPr>
        <p:spPr>
          <a:xfrm>
            <a:off x="8233291" y="525077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-FAC/AIT L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E507D13B-515D-4DCC-BBC2-844A00C43827}"/>
              </a:ext>
            </a:extLst>
          </p:cNvPr>
          <p:cNvSpPr txBox="1"/>
          <p:nvPr/>
        </p:nvSpPr>
        <p:spPr>
          <a:xfrm rot="16200000">
            <a:off x="8599399" y="2434026"/>
            <a:ext cx="10518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8+ T cell subsets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247BDECF-0BF3-476F-96C1-528B90E55BA2}"/>
              </a:ext>
            </a:extLst>
          </p:cNvPr>
          <p:cNvSpPr txBox="1"/>
          <p:nvPr/>
        </p:nvSpPr>
        <p:spPr>
          <a:xfrm>
            <a:off x="7563947" y="2063043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-FAC/AIT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AF6149B6-E9EC-407F-9BCD-AFA06F6632BD}"/>
              </a:ext>
            </a:extLst>
          </p:cNvPr>
          <p:cNvSpPr txBox="1"/>
          <p:nvPr/>
        </p:nvSpPr>
        <p:spPr>
          <a:xfrm>
            <a:off x="8216039" y="2064572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-FAC/AIT L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768444AC-8C38-49E1-968C-EEC24F99B7CB}"/>
              </a:ext>
            </a:extLst>
          </p:cNvPr>
          <p:cNvSpPr txBox="1"/>
          <p:nvPr/>
        </p:nvSpPr>
        <p:spPr>
          <a:xfrm>
            <a:off x="7452705" y="1468189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62L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768444AC-8C38-49E1-968C-EEC24F99B7CB}"/>
              </a:ext>
            </a:extLst>
          </p:cNvPr>
          <p:cNvSpPr txBox="1"/>
          <p:nvPr/>
        </p:nvSpPr>
        <p:spPr>
          <a:xfrm rot="16200000">
            <a:off x="7226827" y="2615393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44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768444AC-8C38-49E1-968C-EEC24F99B7CB}"/>
              </a:ext>
            </a:extLst>
          </p:cNvPr>
          <p:cNvSpPr txBox="1"/>
          <p:nvPr/>
        </p:nvSpPr>
        <p:spPr>
          <a:xfrm>
            <a:off x="7513572" y="2980469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62L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2A549B0F-B495-45FE-B3ED-24A3BE9C951F}"/>
              </a:ext>
            </a:extLst>
          </p:cNvPr>
          <p:cNvSpPr txBox="1"/>
          <p:nvPr/>
        </p:nvSpPr>
        <p:spPr>
          <a:xfrm rot="16200000">
            <a:off x="3453138" y="3565450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Ki67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E507D13B-515D-4DCC-BBC2-844A00C43827}"/>
              </a:ext>
            </a:extLst>
          </p:cNvPr>
          <p:cNvSpPr txBox="1"/>
          <p:nvPr/>
        </p:nvSpPr>
        <p:spPr>
          <a:xfrm rot="16200000">
            <a:off x="8625612" y="4252411"/>
            <a:ext cx="10518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4+ T cell subsets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E507D13B-515D-4DCC-BBC2-844A00C43827}"/>
              </a:ext>
            </a:extLst>
          </p:cNvPr>
          <p:cNvSpPr txBox="1"/>
          <p:nvPr/>
        </p:nvSpPr>
        <p:spPr>
          <a:xfrm rot="16200000">
            <a:off x="8636872" y="5908507"/>
            <a:ext cx="10518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8+ T cell subsets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247BDECF-0BF3-476F-96C1-528B90E55BA2}"/>
              </a:ext>
            </a:extLst>
          </p:cNvPr>
          <p:cNvSpPr txBox="1"/>
          <p:nvPr/>
        </p:nvSpPr>
        <p:spPr>
          <a:xfrm>
            <a:off x="7581199" y="3763444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AF6149B6-E9EC-407F-9BCD-AFA06F6632BD}"/>
              </a:ext>
            </a:extLst>
          </p:cNvPr>
          <p:cNvSpPr txBox="1"/>
          <p:nvPr/>
        </p:nvSpPr>
        <p:spPr>
          <a:xfrm>
            <a:off x="8233291" y="3764973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768444AC-8C38-49E1-968C-EEC24F99B7CB}"/>
              </a:ext>
            </a:extLst>
          </p:cNvPr>
          <p:cNvSpPr txBox="1"/>
          <p:nvPr/>
        </p:nvSpPr>
        <p:spPr>
          <a:xfrm rot="16200000">
            <a:off x="7226827" y="4247244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CD44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768444AC-8C38-49E1-968C-EEC24F99B7CB}"/>
              </a:ext>
            </a:extLst>
          </p:cNvPr>
          <p:cNvSpPr txBox="1"/>
          <p:nvPr/>
        </p:nvSpPr>
        <p:spPr>
          <a:xfrm>
            <a:off x="7464504" y="4681992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62L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247BDECF-0BF3-476F-96C1-528B90E55BA2}"/>
              </a:ext>
            </a:extLst>
          </p:cNvPr>
          <p:cNvSpPr txBox="1"/>
          <p:nvPr/>
        </p:nvSpPr>
        <p:spPr>
          <a:xfrm>
            <a:off x="7581199" y="5419804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AF6149B6-E9EC-407F-9BCD-AFA06F6632BD}"/>
              </a:ext>
            </a:extLst>
          </p:cNvPr>
          <p:cNvSpPr txBox="1"/>
          <p:nvPr/>
        </p:nvSpPr>
        <p:spPr>
          <a:xfrm>
            <a:off x="8233291" y="5421333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768444AC-8C38-49E1-968C-EEC24F99B7CB}"/>
              </a:ext>
            </a:extLst>
          </p:cNvPr>
          <p:cNvSpPr txBox="1"/>
          <p:nvPr/>
        </p:nvSpPr>
        <p:spPr>
          <a:xfrm rot="16200000">
            <a:off x="7226827" y="5907371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44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768444AC-8C38-49E1-968C-EEC24F99B7CB}"/>
              </a:ext>
            </a:extLst>
          </p:cNvPr>
          <p:cNvSpPr txBox="1"/>
          <p:nvPr/>
        </p:nvSpPr>
        <p:spPr>
          <a:xfrm>
            <a:off x="7498818" y="6333699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62L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2A549B0F-B495-45FE-B3ED-24A3BE9C951F}"/>
              </a:ext>
            </a:extLst>
          </p:cNvPr>
          <p:cNvSpPr txBox="1"/>
          <p:nvPr/>
        </p:nvSpPr>
        <p:spPr>
          <a:xfrm rot="16200000">
            <a:off x="3445064" y="5664592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Ki67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E7E4A7A4-2446-4B2B-8808-443AFFDCA0A9}"/>
              </a:ext>
            </a:extLst>
          </p:cNvPr>
          <p:cNvSpPr txBox="1"/>
          <p:nvPr/>
        </p:nvSpPr>
        <p:spPr>
          <a:xfrm>
            <a:off x="3772049" y="5114214"/>
            <a:ext cx="1165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neu+ viable cells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247BDECF-0BF3-476F-96C1-528B90E55BA2}"/>
              </a:ext>
            </a:extLst>
          </p:cNvPr>
          <p:cNvSpPr txBox="1"/>
          <p:nvPr/>
        </p:nvSpPr>
        <p:spPr>
          <a:xfrm>
            <a:off x="3712314" y="5303456"/>
            <a:ext cx="650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AF6149B6-E9EC-407F-9BCD-AFA06F6632BD}"/>
              </a:ext>
            </a:extLst>
          </p:cNvPr>
          <p:cNvSpPr txBox="1"/>
          <p:nvPr/>
        </p:nvSpPr>
        <p:spPr>
          <a:xfrm>
            <a:off x="4353855" y="5305456"/>
            <a:ext cx="6687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8441122-E5DB-42E4-A72C-011A3F716C8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709428" y="3349465"/>
            <a:ext cx="653555" cy="64008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0BEAAFA-75EF-495A-8AA6-0CB4467AB372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157337" y="730255"/>
            <a:ext cx="732103" cy="7315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3786620-6A75-4FD3-99A2-036D1F38682C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7464504" y="728735"/>
            <a:ext cx="735432" cy="7315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3307AF7-67A7-40CB-A56B-4C8AD13B51A2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8157337" y="2250677"/>
            <a:ext cx="740354" cy="7315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530C5E1-8912-4423-8225-1979E9B302C5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7464504" y="2242204"/>
            <a:ext cx="734689" cy="73152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C1DA1A22-9711-4AB0-A5C1-78650EE51BCC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659303" y="5492913"/>
            <a:ext cx="658796" cy="64008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575DD95-B303-41FA-A7C0-53142C19AE64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7464504" y="3943231"/>
            <a:ext cx="769172" cy="73152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03BAC9A-9C59-4884-9CF7-22A50F7E63A3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7464504" y="5602932"/>
            <a:ext cx="752272" cy="731520"/>
          </a:xfrm>
          <a:prstGeom prst="rect">
            <a:avLst/>
          </a:prstGeom>
        </p:spPr>
      </p:pic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24CC19C7-26C3-447F-A518-867F197F9CF8}"/>
              </a:ext>
            </a:extLst>
          </p:cNvPr>
          <p:cNvCxnSpPr/>
          <p:nvPr/>
        </p:nvCxnSpPr>
        <p:spPr>
          <a:xfrm>
            <a:off x="7546695" y="1448279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B36A4980-BD04-428E-9A69-CECA76049481}"/>
              </a:ext>
            </a:extLst>
          </p:cNvPr>
          <p:cNvCxnSpPr/>
          <p:nvPr/>
        </p:nvCxnSpPr>
        <p:spPr>
          <a:xfrm>
            <a:off x="7535735" y="2982197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83DE16B1-69CF-497B-B842-4C780D62B90F}"/>
              </a:ext>
            </a:extLst>
          </p:cNvPr>
          <p:cNvCxnSpPr/>
          <p:nvPr/>
        </p:nvCxnSpPr>
        <p:spPr>
          <a:xfrm>
            <a:off x="7538069" y="4673419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D5DE8E3B-CF49-4AA1-82D4-E66DBDA5ED0A}"/>
              </a:ext>
            </a:extLst>
          </p:cNvPr>
          <p:cNvCxnSpPr/>
          <p:nvPr/>
        </p:nvCxnSpPr>
        <p:spPr>
          <a:xfrm>
            <a:off x="7572573" y="6330400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677642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C13C690-9C3C-453A-A2A2-F1FA65C3BBE1}"/>
              </a:ext>
            </a:extLst>
          </p:cNvPr>
          <p:cNvSpPr txBox="1"/>
          <p:nvPr/>
        </p:nvSpPr>
        <p:spPr>
          <a:xfrm>
            <a:off x="1486212" y="2024228"/>
            <a:ext cx="883620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5. A dormant tumor cell line isolated from the liver is tumorigenic in FVBN202 transgenic mice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emale FVBN202 mice (8-10 weeks old, 3 mice/group) were challenged with the dormant tumor cell lines either isolated from the lungs (R-FAC/AIT, 3 million/mouse) or from the liver (R-FAC/AIT L, 3 million/mouse) of the FAC/AIT group. A) Tumor growth in the mammary region was measured using a digital caliper. Dormant tumor cells in the lungs (B) or in the liver (D) were detected on FVS negative (FVS-) viable cells (%total neu+ cells). Gated FVS- neu+ viable cells were analyzed for the expression of Ki67. C &amp; E) Gated FVS-CD3+ cells were analyzed for CD4+ or CD8+ T cells. Gated FVS-CD3+CD4+ or CD8+ T cells were analyzed for T effector cells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CD44+CD62L-), T effector/memory cells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e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CD44+CD62L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T central/memory cells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c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CD44+CD62L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or T naïve cells (Tn, CD44-CD62L+) in the lungs (C) or in the liver (E). Data represent triplicate experiments.</a:t>
            </a:r>
          </a:p>
        </p:txBody>
      </p:sp>
    </p:spTree>
    <p:extLst>
      <p:ext uri="{BB962C8B-B14F-4D97-AF65-F5344CB8AC3E}">
        <p14:creationId xmlns:p14="http://schemas.microsoft.com/office/powerpoint/2010/main" val="42890092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C7FB0357-23B8-49E5-A06C-55154CF199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97880" y="5214214"/>
            <a:ext cx="741872" cy="73152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0FF3C89-57A0-4822-BBC3-D376039CE7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00654" y="3078785"/>
            <a:ext cx="742122" cy="7315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FF02B54-BF09-408D-B17A-2F2FB5B7B7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19585" y="5386277"/>
            <a:ext cx="716772" cy="70730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150E9F6-DE40-415E-973B-D23511C36F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68107" y="3292159"/>
            <a:ext cx="728225" cy="73152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2472DD54-E701-40DA-BA9A-1B2C06972A01}"/>
              </a:ext>
            </a:extLst>
          </p:cNvPr>
          <p:cNvSpPr txBox="1"/>
          <p:nvPr/>
        </p:nvSpPr>
        <p:spPr>
          <a:xfrm rot="16200000">
            <a:off x="1870422" y="3401443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4+ T cells</a:t>
            </a:r>
          </a:p>
        </p:txBody>
      </p:sp>
      <p:graphicFrame>
        <p:nvGraphicFramePr>
          <p:cNvPr id="52" name="Chart 51">
            <a:extLst>
              <a:ext uri="{FF2B5EF4-FFF2-40B4-BE49-F238E27FC236}">
                <a16:creationId xmlns:a16="http://schemas.microsoft.com/office/drawing/2014/main" id="{00000000-0008-0000-0700-0000FD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9881344"/>
              </p:ext>
            </p:extLst>
          </p:nvPr>
        </p:nvGraphicFramePr>
        <p:xfrm>
          <a:off x="5017454" y="573129"/>
          <a:ext cx="1362456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4" name="TextBox 23"/>
          <p:cNvSpPr txBox="1"/>
          <p:nvPr/>
        </p:nvSpPr>
        <p:spPr>
          <a:xfrm rot="16200000">
            <a:off x="4424730" y="1173684"/>
            <a:ext cx="10775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Tumor volume (mm</a:t>
            </a:r>
            <a:r>
              <a:rPr lang="en-US" sz="800" baseline="30000" dirty="0">
                <a:latin typeface="+mj-lt"/>
              </a:rPr>
              <a:t>3</a:t>
            </a:r>
            <a:r>
              <a:rPr lang="en-US" sz="800" dirty="0">
                <a:latin typeface="+mj-lt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1A88FB8-FFAA-44CD-A5B8-08D8AB950D9E}"/>
              </a:ext>
            </a:extLst>
          </p:cNvPr>
          <p:cNvSpPr txBox="1"/>
          <p:nvPr/>
        </p:nvSpPr>
        <p:spPr>
          <a:xfrm>
            <a:off x="5603204" y="2132979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Day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819C925-4BF8-4E94-8406-7E0B3A4330AD}"/>
              </a:ext>
            </a:extLst>
          </p:cNvPr>
          <p:cNvSpPr txBox="1"/>
          <p:nvPr/>
        </p:nvSpPr>
        <p:spPr>
          <a:xfrm>
            <a:off x="4786664" y="292621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A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833711" y="265389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6</a:t>
            </a:r>
          </a:p>
        </p:txBody>
      </p:sp>
      <p:graphicFrame>
        <p:nvGraphicFramePr>
          <p:cNvPr id="42" name="Chart 41">
            <a:extLst>
              <a:ext uri="{FF2B5EF4-FFF2-40B4-BE49-F238E27FC236}">
                <a16:creationId xmlns:a16="http://schemas.microsoft.com/office/drawing/2014/main" id="{FAEA7B7D-9CD6-429C-A644-5C6D8CDBB5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4769615"/>
              </p:ext>
            </p:extLst>
          </p:nvPr>
        </p:nvGraphicFramePr>
        <p:xfrm>
          <a:off x="6568898" y="5126196"/>
          <a:ext cx="82296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3" name="Chart 42">
            <a:extLst>
              <a:ext uri="{FF2B5EF4-FFF2-40B4-BE49-F238E27FC236}">
                <a16:creationId xmlns:a16="http://schemas.microsoft.com/office/drawing/2014/main" id="{E89061FE-9068-4A4D-87B8-5750DF3ABB6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8621349"/>
              </p:ext>
            </p:extLst>
          </p:nvPr>
        </p:nvGraphicFramePr>
        <p:xfrm>
          <a:off x="6583059" y="2953258"/>
          <a:ext cx="82296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0" name="Chart 49">
            <a:extLst>
              <a:ext uri="{FF2B5EF4-FFF2-40B4-BE49-F238E27FC236}">
                <a16:creationId xmlns:a16="http://schemas.microsoft.com/office/drawing/2014/main" id="{9B2C8320-D4B6-4A4B-8C97-24EDAF40BD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3623154"/>
              </p:ext>
            </p:extLst>
          </p:nvPr>
        </p:nvGraphicFramePr>
        <p:xfrm>
          <a:off x="2277467" y="5075974"/>
          <a:ext cx="82296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54" name="Chart 53">
            <a:extLst>
              <a:ext uri="{FF2B5EF4-FFF2-40B4-BE49-F238E27FC236}">
                <a16:creationId xmlns:a16="http://schemas.microsoft.com/office/drawing/2014/main" id="{F49E89BB-5CD6-4E9F-B718-3F9906F968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6846614"/>
              </p:ext>
            </p:extLst>
          </p:nvPr>
        </p:nvGraphicFramePr>
        <p:xfrm>
          <a:off x="2285344" y="3069781"/>
          <a:ext cx="82296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55" name="TextBox 54">
            <a:extLst>
              <a:ext uri="{FF2B5EF4-FFF2-40B4-BE49-F238E27FC236}">
                <a16:creationId xmlns:a16="http://schemas.microsoft.com/office/drawing/2014/main" id="{78BCB02D-C04C-4C33-B300-7519BB10C609}"/>
              </a:ext>
            </a:extLst>
          </p:cNvPr>
          <p:cNvSpPr txBox="1"/>
          <p:nvPr/>
        </p:nvSpPr>
        <p:spPr>
          <a:xfrm>
            <a:off x="2140367" y="2401675"/>
            <a:ext cx="13260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B) Lungs: CD4+ T cell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0ECC206-491D-4730-805E-DBBE84F85DBC}"/>
              </a:ext>
            </a:extLst>
          </p:cNvPr>
          <p:cNvSpPr txBox="1"/>
          <p:nvPr/>
        </p:nvSpPr>
        <p:spPr>
          <a:xfrm>
            <a:off x="3349000" y="3099967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6221318-0295-460F-B681-02B3A714E662}"/>
              </a:ext>
            </a:extLst>
          </p:cNvPr>
          <p:cNvSpPr txBox="1"/>
          <p:nvPr/>
        </p:nvSpPr>
        <p:spPr>
          <a:xfrm>
            <a:off x="4002429" y="3104595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2C514C0-8E48-4D54-8E05-C95B92E028E0}"/>
              </a:ext>
            </a:extLst>
          </p:cNvPr>
          <p:cNvSpPr txBox="1"/>
          <p:nvPr/>
        </p:nvSpPr>
        <p:spPr>
          <a:xfrm>
            <a:off x="3285126" y="4020169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62L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B570EBE-A0C9-4FC9-AEE2-B4B20A32ABD4}"/>
              </a:ext>
            </a:extLst>
          </p:cNvPr>
          <p:cNvSpPr txBox="1"/>
          <p:nvPr/>
        </p:nvSpPr>
        <p:spPr>
          <a:xfrm rot="16200000">
            <a:off x="3044063" y="3666382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4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52B6163-8052-4A26-A902-3A8B99696E9C}"/>
              </a:ext>
            </a:extLst>
          </p:cNvPr>
          <p:cNvSpPr txBox="1"/>
          <p:nvPr/>
        </p:nvSpPr>
        <p:spPr>
          <a:xfrm>
            <a:off x="3378817" y="5188086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FBCFC50-8E94-452B-8A78-2EF245C7DC60}"/>
              </a:ext>
            </a:extLst>
          </p:cNvPr>
          <p:cNvSpPr txBox="1"/>
          <p:nvPr/>
        </p:nvSpPr>
        <p:spPr>
          <a:xfrm>
            <a:off x="4063498" y="5188086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AF62EBC-E44B-4636-A79F-69C2846CB85E}"/>
              </a:ext>
            </a:extLst>
          </p:cNvPr>
          <p:cNvSpPr txBox="1"/>
          <p:nvPr/>
        </p:nvSpPr>
        <p:spPr>
          <a:xfrm>
            <a:off x="3313167" y="6117095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62L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93F10E4-78BE-4DBC-983D-04DE8A6BB897}"/>
              </a:ext>
            </a:extLst>
          </p:cNvPr>
          <p:cNvSpPr txBox="1"/>
          <p:nvPr/>
        </p:nvSpPr>
        <p:spPr>
          <a:xfrm rot="16200000">
            <a:off x="3082105" y="5758554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4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B585495-51B2-42B5-8387-EC7B0B4AC5C9}"/>
              </a:ext>
            </a:extLst>
          </p:cNvPr>
          <p:cNvSpPr txBox="1"/>
          <p:nvPr/>
        </p:nvSpPr>
        <p:spPr>
          <a:xfrm rot="16200000">
            <a:off x="1835103" y="5395428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8+ T cells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0A76CAA-0F78-4B0E-8A15-9623D509A8DF}"/>
              </a:ext>
            </a:extLst>
          </p:cNvPr>
          <p:cNvSpPr txBox="1"/>
          <p:nvPr/>
        </p:nvSpPr>
        <p:spPr>
          <a:xfrm>
            <a:off x="2140367" y="4599571"/>
            <a:ext cx="1321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C) Lungs: CD8+ T cells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3A03499-A253-44A2-ABC3-C155B0990429}"/>
              </a:ext>
            </a:extLst>
          </p:cNvPr>
          <p:cNvSpPr txBox="1"/>
          <p:nvPr/>
        </p:nvSpPr>
        <p:spPr>
          <a:xfrm rot="16200000">
            <a:off x="6147351" y="3218917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4+ T cells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B8C8C2F-0052-4437-9CF6-128118E39021}"/>
              </a:ext>
            </a:extLst>
          </p:cNvPr>
          <p:cNvSpPr txBox="1"/>
          <p:nvPr/>
        </p:nvSpPr>
        <p:spPr>
          <a:xfrm>
            <a:off x="7615412" y="2907304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8DC3F67-0C80-47EA-8F53-1DC6DED17488}"/>
              </a:ext>
            </a:extLst>
          </p:cNvPr>
          <p:cNvSpPr txBox="1"/>
          <p:nvPr/>
        </p:nvSpPr>
        <p:spPr>
          <a:xfrm>
            <a:off x="8256013" y="2896902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1E48A9A-0153-4E0A-87CC-CBC649A99272}"/>
              </a:ext>
            </a:extLst>
          </p:cNvPr>
          <p:cNvSpPr txBox="1"/>
          <p:nvPr/>
        </p:nvSpPr>
        <p:spPr>
          <a:xfrm>
            <a:off x="7595148" y="3833856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62L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815E7EE-22CA-40F6-82F5-146D4D0237B2}"/>
              </a:ext>
            </a:extLst>
          </p:cNvPr>
          <p:cNvSpPr txBox="1"/>
          <p:nvPr/>
        </p:nvSpPr>
        <p:spPr>
          <a:xfrm rot="16200000">
            <a:off x="7314533" y="3418012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44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639F432-33B8-4599-8C77-3EF4CB52C7F3}"/>
              </a:ext>
            </a:extLst>
          </p:cNvPr>
          <p:cNvSpPr txBox="1"/>
          <p:nvPr/>
        </p:nvSpPr>
        <p:spPr>
          <a:xfrm rot="16200000">
            <a:off x="6139628" y="5427320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8+ T cells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0A04DDF-84EE-4048-AAE6-BBC61FA3B0A9}"/>
              </a:ext>
            </a:extLst>
          </p:cNvPr>
          <p:cNvSpPr txBox="1"/>
          <p:nvPr/>
        </p:nvSpPr>
        <p:spPr>
          <a:xfrm>
            <a:off x="7593864" y="5954360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62L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488F2A0-7D98-4337-B4B9-7D0D2F0E3ED4}"/>
              </a:ext>
            </a:extLst>
          </p:cNvPr>
          <p:cNvSpPr txBox="1"/>
          <p:nvPr/>
        </p:nvSpPr>
        <p:spPr>
          <a:xfrm rot="16200000">
            <a:off x="7341517" y="5572442"/>
            <a:ext cx="4042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CD44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406E64BE-C2CE-444C-BF93-D240DD5BFF84}"/>
              </a:ext>
            </a:extLst>
          </p:cNvPr>
          <p:cNvSpPr txBox="1"/>
          <p:nvPr/>
        </p:nvSpPr>
        <p:spPr>
          <a:xfrm>
            <a:off x="6367186" y="2401675"/>
            <a:ext cx="12650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D) Liver: CD4+ T cells</a:t>
            </a:r>
          </a:p>
        </p:txBody>
      </p:sp>
      <p:graphicFrame>
        <p:nvGraphicFramePr>
          <p:cNvPr id="85" name="Chart 84">
            <a:extLst>
              <a:ext uri="{FF2B5EF4-FFF2-40B4-BE49-F238E27FC236}">
                <a16:creationId xmlns:a16="http://schemas.microsoft.com/office/drawing/2014/main" id="{85558A83-EE59-412A-95B2-4029118485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2537771"/>
              </p:ext>
            </p:extLst>
          </p:nvPr>
        </p:nvGraphicFramePr>
        <p:xfrm>
          <a:off x="9171438" y="4689113"/>
          <a:ext cx="1095394" cy="163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86" name="Chart 85">
            <a:extLst>
              <a:ext uri="{FF2B5EF4-FFF2-40B4-BE49-F238E27FC236}">
                <a16:creationId xmlns:a16="http://schemas.microsoft.com/office/drawing/2014/main" id="{BF0FBCDD-6B1A-4C7C-84DD-61874D3277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3326899"/>
              </p:ext>
            </p:extLst>
          </p:nvPr>
        </p:nvGraphicFramePr>
        <p:xfrm>
          <a:off x="9180064" y="2606655"/>
          <a:ext cx="1112569" cy="16334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87" name="Chart 86">
            <a:extLst>
              <a:ext uri="{FF2B5EF4-FFF2-40B4-BE49-F238E27FC236}">
                <a16:creationId xmlns:a16="http://schemas.microsoft.com/office/drawing/2014/main" id="{3BAE606D-B032-47B0-8D49-4429410F2C2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0083440"/>
              </p:ext>
            </p:extLst>
          </p:nvPr>
        </p:nvGraphicFramePr>
        <p:xfrm>
          <a:off x="4814188" y="2767335"/>
          <a:ext cx="109728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88" name="TextBox 87">
            <a:extLst>
              <a:ext uri="{FF2B5EF4-FFF2-40B4-BE49-F238E27FC236}">
                <a16:creationId xmlns:a16="http://schemas.microsoft.com/office/drawing/2014/main" id="{187B96AB-666A-404E-884A-0E87BD415B65}"/>
              </a:ext>
            </a:extLst>
          </p:cNvPr>
          <p:cNvSpPr txBox="1"/>
          <p:nvPr/>
        </p:nvSpPr>
        <p:spPr>
          <a:xfrm>
            <a:off x="5066332" y="3572289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*</a:t>
            </a:r>
          </a:p>
        </p:txBody>
      </p:sp>
      <p:cxnSp>
        <p:nvCxnSpPr>
          <p:cNvPr id="89" name="Straight Connector 88"/>
          <p:cNvCxnSpPr/>
          <p:nvPr/>
        </p:nvCxnSpPr>
        <p:spPr>
          <a:xfrm>
            <a:off x="5107838" y="3698084"/>
            <a:ext cx="1671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0" name="Chart 89">
            <a:extLst>
              <a:ext uri="{FF2B5EF4-FFF2-40B4-BE49-F238E27FC236}">
                <a16:creationId xmlns:a16="http://schemas.microsoft.com/office/drawing/2014/main" id="{B443D5C2-FB4B-43C5-963D-07795316E8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9065663"/>
              </p:ext>
            </p:extLst>
          </p:nvPr>
        </p:nvGraphicFramePr>
        <p:xfrm>
          <a:off x="4874871" y="4817472"/>
          <a:ext cx="109728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91" name="TextBox 90">
            <a:extLst>
              <a:ext uri="{FF2B5EF4-FFF2-40B4-BE49-F238E27FC236}">
                <a16:creationId xmlns:a16="http://schemas.microsoft.com/office/drawing/2014/main" id="{E507D13B-515D-4DCC-BBC2-844A00C43827}"/>
              </a:ext>
            </a:extLst>
          </p:cNvPr>
          <p:cNvSpPr txBox="1"/>
          <p:nvPr/>
        </p:nvSpPr>
        <p:spPr>
          <a:xfrm rot="16200000">
            <a:off x="4256624" y="3391226"/>
            <a:ext cx="10518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4+ T cell subsets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E507D13B-515D-4DCC-BBC2-844A00C43827}"/>
              </a:ext>
            </a:extLst>
          </p:cNvPr>
          <p:cNvSpPr txBox="1"/>
          <p:nvPr/>
        </p:nvSpPr>
        <p:spPr>
          <a:xfrm rot="16200000">
            <a:off x="4311014" y="5461401"/>
            <a:ext cx="10518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8+ T cell subsets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ADB22F6-2CB2-4CD6-9976-855DCAD789F2}"/>
              </a:ext>
            </a:extLst>
          </p:cNvPr>
          <p:cNvSpPr txBox="1"/>
          <p:nvPr/>
        </p:nvSpPr>
        <p:spPr>
          <a:xfrm>
            <a:off x="3460605" y="2838990"/>
            <a:ext cx="1191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CD4+ T cells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A058F1F5-B904-4E62-A8C1-0AC521D5B96F}"/>
              </a:ext>
            </a:extLst>
          </p:cNvPr>
          <p:cNvSpPr txBox="1"/>
          <p:nvPr/>
        </p:nvSpPr>
        <p:spPr>
          <a:xfrm>
            <a:off x="3473322" y="5020819"/>
            <a:ext cx="11769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CD8+ T cells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ADB22F6-2CB2-4CD6-9976-855DCAD789F2}"/>
              </a:ext>
            </a:extLst>
          </p:cNvPr>
          <p:cNvSpPr txBox="1"/>
          <p:nvPr/>
        </p:nvSpPr>
        <p:spPr>
          <a:xfrm>
            <a:off x="7680336" y="2702553"/>
            <a:ext cx="1191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CD4+ T cells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507D13B-515D-4DCC-BBC2-844A00C43827}"/>
              </a:ext>
            </a:extLst>
          </p:cNvPr>
          <p:cNvSpPr txBox="1"/>
          <p:nvPr/>
        </p:nvSpPr>
        <p:spPr>
          <a:xfrm rot="16200000">
            <a:off x="8614004" y="3266113"/>
            <a:ext cx="10518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4+ T cell subsets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E507D13B-515D-4DCC-BBC2-844A00C43827}"/>
              </a:ext>
            </a:extLst>
          </p:cNvPr>
          <p:cNvSpPr txBox="1"/>
          <p:nvPr/>
        </p:nvSpPr>
        <p:spPr>
          <a:xfrm rot="16200000">
            <a:off x="8608012" y="5327662"/>
            <a:ext cx="10518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%CD8+ T cell subsets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B8C8C2F-0052-4437-9CF6-128118E39021}"/>
              </a:ext>
            </a:extLst>
          </p:cNvPr>
          <p:cNvSpPr txBox="1"/>
          <p:nvPr/>
        </p:nvSpPr>
        <p:spPr>
          <a:xfrm>
            <a:off x="7644672" y="4991531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R-FAC/AIT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38DC3F67-0C80-47EA-8F53-1DC6DED17488}"/>
              </a:ext>
            </a:extLst>
          </p:cNvPr>
          <p:cNvSpPr txBox="1"/>
          <p:nvPr/>
        </p:nvSpPr>
        <p:spPr>
          <a:xfrm>
            <a:off x="8285273" y="4981129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R-FAC/AIT L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058F1F5-B904-4E62-A8C1-0AC521D5B96F}"/>
              </a:ext>
            </a:extLst>
          </p:cNvPr>
          <p:cNvSpPr txBox="1"/>
          <p:nvPr/>
        </p:nvSpPr>
        <p:spPr>
          <a:xfrm>
            <a:off x="7675223" y="4820925"/>
            <a:ext cx="11769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</a:rPr>
              <a:t>Gated CD3+CD8+ T cell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BC5AA1C-7011-4DBD-926B-7778BB332E6B}"/>
              </a:ext>
            </a:extLst>
          </p:cNvPr>
          <p:cNvSpPr txBox="1"/>
          <p:nvPr/>
        </p:nvSpPr>
        <p:spPr>
          <a:xfrm>
            <a:off x="6367186" y="4599571"/>
            <a:ext cx="12682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+mj-lt"/>
              </a:rPr>
              <a:t>E) Liver: CD8+ T cell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65CD160-C92E-4AAB-9662-2B646A0D2E4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328691" y="5371473"/>
            <a:ext cx="716772" cy="7315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E1C4DB4-7B61-4B7E-94C5-5DA689A63CF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275911" y="3286036"/>
            <a:ext cx="728225" cy="7315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62357F4-27F5-4DFD-B6CD-C54929E0282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7582942" y="5212157"/>
            <a:ext cx="741872" cy="73152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2F72937-C794-4CAD-87AA-2429040E5A5D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595148" y="3078201"/>
            <a:ext cx="738321" cy="731520"/>
          </a:xfrm>
          <a:prstGeom prst="rect">
            <a:avLst/>
          </a:prstGeom>
        </p:spPr>
      </p:pic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1A09409D-B821-4BD9-A196-2D7A95EF672B}"/>
              </a:ext>
            </a:extLst>
          </p:cNvPr>
          <p:cNvCxnSpPr/>
          <p:nvPr/>
        </p:nvCxnSpPr>
        <p:spPr>
          <a:xfrm>
            <a:off x="3353924" y="4021544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B8753859-69C0-475C-BB81-6A0B0EF21316}"/>
              </a:ext>
            </a:extLst>
          </p:cNvPr>
          <p:cNvCxnSpPr/>
          <p:nvPr/>
        </p:nvCxnSpPr>
        <p:spPr>
          <a:xfrm>
            <a:off x="7635482" y="3827422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8FCB3E32-43BA-4ADD-A7E4-AA4A791E0A23}"/>
              </a:ext>
            </a:extLst>
          </p:cNvPr>
          <p:cNvCxnSpPr/>
          <p:nvPr/>
        </p:nvCxnSpPr>
        <p:spPr>
          <a:xfrm>
            <a:off x="3371176" y="6110839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8993A6F8-46FE-4728-8860-FDDCCC7255DA}"/>
              </a:ext>
            </a:extLst>
          </p:cNvPr>
          <p:cNvCxnSpPr/>
          <p:nvPr/>
        </p:nvCxnSpPr>
        <p:spPr>
          <a:xfrm>
            <a:off x="7642752" y="5954360"/>
            <a:ext cx="3535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880881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BB3B16-60CD-4C0D-A62E-3597E449CF53}"/>
              </a:ext>
            </a:extLst>
          </p:cNvPr>
          <p:cNvSpPr txBox="1"/>
          <p:nvPr/>
        </p:nvSpPr>
        <p:spPr>
          <a:xfrm>
            <a:off x="2302133" y="1725023"/>
            <a:ext cx="766255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6. Presence of tumor-reactive immune responses prior to tumor development protect FVB mice from challenge with R-FAC/AIT L tumor cell lin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Female FVB mice (8-10 weeks old, 3 mice/group) were challenged with the dormant tumor cell lines either isolated from the lungs (R-FAC/AIT, 3 million cells/mouse) or from the liver (R-FAC/AIT L, 3 million cells/mouse) of the FAC/AIT group. A) Tumor growth in the mammary region was measured using a digital caliper. B-E) Gated FVS-CD3+ cells were analyzed for CD4+ or CD8+ T cells in the lungs (B-C) or in the liver (D-E). Gated FVS-CD3+CD4+ or CD8+ T cells were analyzed for T effector cells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CD44+CD62L-), T effector memory cells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e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CD44+CD62L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T central memory cells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c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CD44+CD62L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or T naïve cells (Tn, CD44-CD62L+) in the lungs (B-C) or in the liver (D-E). </a:t>
            </a:r>
          </a:p>
        </p:txBody>
      </p:sp>
    </p:spTree>
    <p:extLst>
      <p:ext uri="{BB962C8B-B14F-4D97-AF65-F5344CB8AC3E}">
        <p14:creationId xmlns:p14="http://schemas.microsoft.com/office/powerpoint/2010/main" val="3557260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</TotalTime>
  <Words>1293</Words>
  <Application>Microsoft Office PowerPoint</Application>
  <PresentationFormat>Widescreen</PresentationFormat>
  <Paragraphs>175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</dc:creator>
  <cp:lastModifiedBy>Masoud Manjili</cp:lastModifiedBy>
  <cp:revision>246</cp:revision>
  <dcterms:created xsi:type="dcterms:W3CDTF">2019-11-18T15:51:43Z</dcterms:created>
  <dcterms:modified xsi:type="dcterms:W3CDTF">2020-09-19T17:54:46Z</dcterms:modified>
</cp:coreProperties>
</file>